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theme/themeOverride1.xml" ContentType="application/vnd.openxmlformats-officedocument.themeOverrid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theme/themeOverride2.xml" ContentType="application/vnd.openxmlformats-officedocument.themeOverrid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theme/themeOverride3.xml" ContentType="application/vnd.openxmlformats-officedocument.themeOverrid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theme/themeOverride4.xml" ContentType="application/vnd.openxmlformats-officedocument.themeOverrid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charts/chart3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charts/chart3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charts/chart3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ppt/charts/chart40.xml" ContentType="application/vnd.openxmlformats-officedocument.drawingml.chart+xml"/>
  <Override PartName="/ppt/charts/style40.xml" ContentType="application/vnd.ms-office.chartstyle+xml"/>
  <Override PartName="/ppt/charts/colors40.xml" ContentType="application/vnd.ms-office.chartcolorstyle+xml"/>
  <Override PartName="/ppt/charts/chart41.xml" ContentType="application/vnd.openxmlformats-officedocument.drawingml.chart+xml"/>
  <Override PartName="/ppt/charts/style41.xml" ContentType="application/vnd.ms-office.chartstyle+xml"/>
  <Override PartName="/ppt/charts/colors41.xml" ContentType="application/vnd.ms-office.chartcolorstyle+xml"/>
  <Override PartName="/ppt/charts/chart42.xml" ContentType="application/vnd.openxmlformats-officedocument.drawingml.chart+xml"/>
  <Override PartName="/ppt/charts/style42.xml" ContentType="application/vnd.ms-office.chartstyle+xml"/>
  <Override PartName="/ppt/charts/colors42.xml" ContentType="application/vnd.ms-office.chartcolorstyle+xml"/>
  <Override PartName="/ppt/charts/chart43.xml" ContentType="application/vnd.openxmlformats-officedocument.drawingml.chart+xml"/>
  <Override PartName="/ppt/charts/style43.xml" ContentType="application/vnd.ms-office.chartstyle+xml"/>
  <Override PartName="/ppt/charts/colors43.xml" ContentType="application/vnd.ms-office.chartcolorstyle+xml"/>
  <Override PartName="/ppt/charts/chart44.xml" ContentType="application/vnd.openxmlformats-officedocument.drawingml.chart+xml"/>
  <Override PartName="/ppt/charts/style44.xml" ContentType="application/vnd.ms-office.chartstyle+xml"/>
  <Override PartName="/ppt/charts/colors44.xml" ContentType="application/vnd.ms-office.chartcolorstyle+xml"/>
  <Override PartName="/ppt/charts/chart45.xml" ContentType="application/vnd.openxmlformats-officedocument.drawingml.chart+xml"/>
  <Override PartName="/ppt/charts/style45.xml" ContentType="application/vnd.ms-office.chartstyle+xml"/>
  <Override PartName="/ppt/charts/colors45.xml" ContentType="application/vnd.ms-office.chartcolorstyle+xml"/>
  <Override PartName="/ppt/charts/chart46.xml" ContentType="application/vnd.openxmlformats-officedocument.drawingml.chart+xml"/>
  <Override PartName="/ppt/charts/style46.xml" ContentType="application/vnd.ms-office.chartstyle+xml"/>
  <Override PartName="/ppt/charts/colors46.xml" ContentType="application/vnd.ms-office.chartcolorstyle+xml"/>
  <Override PartName="/ppt/charts/chart47.xml" ContentType="application/vnd.openxmlformats-officedocument.drawingml.chart+xml"/>
  <Override PartName="/ppt/charts/style47.xml" ContentType="application/vnd.ms-office.chartstyle+xml"/>
  <Override PartName="/ppt/charts/colors47.xml" ContentType="application/vnd.ms-office.chartcolorstyle+xml"/>
  <Override PartName="/ppt/charts/chart48.xml" ContentType="application/vnd.openxmlformats-officedocument.drawingml.chart+xml"/>
  <Override PartName="/ppt/charts/style48.xml" ContentType="application/vnd.ms-office.chartstyle+xml"/>
  <Override PartName="/ppt/charts/colors48.xml" ContentType="application/vnd.ms-office.chartcolorstyle+xml"/>
  <Override PartName="/ppt/charts/chart49.xml" ContentType="application/vnd.openxmlformats-officedocument.drawingml.chart+xml"/>
  <Override PartName="/ppt/charts/style49.xml" ContentType="application/vnd.ms-office.chartstyle+xml"/>
  <Override PartName="/ppt/charts/colors49.xml" ContentType="application/vnd.ms-office.chartcolorstyle+xml"/>
  <Override PartName="/ppt/charts/chart50.xml" ContentType="application/vnd.openxmlformats-officedocument.drawingml.chart+xml"/>
  <Override PartName="/ppt/charts/style50.xml" ContentType="application/vnd.ms-office.chartstyle+xml"/>
  <Override PartName="/ppt/charts/colors50.xml" ContentType="application/vnd.ms-office.chartcolorstyle+xml"/>
  <Override PartName="/ppt/charts/chart51.xml" ContentType="application/vnd.openxmlformats-officedocument.drawingml.chart+xml"/>
  <Override PartName="/ppt/charts/style51.xml" ContentType="application/vnd.ms-office.chartstyle+xml"/>
  <Override PartName="/ppt/charts/colors51.xml" ContentType="application/vnd.ms-office.chartcolorstyle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62" r:id="rId4"/>
    <p:sldId id="263" r:id="rId5"/>
    <p:sldId id="264" r:id="rId6"/>
    <p:sldId id="265" r:id="rId7"/>
    <p:sldId id="266" r:id="rId8"/>
    <p:sldId id="267" r:id="rId9"/>
    <p:sldId id="270" r:id="rId10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56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9.xml"/><Relationship Id="rId1" Type="http://schemas.microsoft.com/office/2011/relationships/chartStyle" Target="style29.xml"/><Relationship Id="rId4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0.xml"/><Relationship Id="rId1" Type="http://schemas.microsoft.com/office/2011/relationships/chartStyle" Target="style30.xml"/><Relationship Id="rId4" Type="http://schemas.openxmlformats.org/officeDocument/2006/relationships/package" Target="../embeddings/Microsoft_Excel_Worksheet1.xlsx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1.xml"/><Relationship Id="rId1" Type="http://schemas.microsoft.com/office/2011/relationships/chartStyle" Target="style31.xml"/><Relationship Id="rId4" Type="http://schemas.openxmlformats.org/officeDocument/2006/relationships/package" Target="../embeddings/Microsoft_Excel_Worksheet2.xlsx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32.xml"/><Relationship Id="rId1" Type="http://schemas.microsoft.com/office/2011/relationships/chartStyle" Target="style32.xml"/><Relationship Id="rId4" Type="http://schemas.openxmlformats.org/officeDocument/2006/relationships/package" Target="../embeddings/Microsoft_Excel_Worksheet3.xlsx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3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7.xml"/><Relationship Id="rId1" Type="http://schemas.microsoft.com/office/2011/relationships/chartStyle" Target="style37.xm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8.xml"/><Relationship Id="rId1" Type="http://schemas.microsoft.com/office/2011/relationships/chartStyle" Target="style38.xml"/></Relationships>
</file>

<file path=ppt/charts/_rels/chart3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39.xml"/><Relationship Id="rId1" Type="http://schemas.microsoft.com/office/2011/relationships/chartStyle" Target="style39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0.xml"/><Relationship Id="rId1" Type="http://schemas.microsoft.com/office/2011/relationships/chartStyle" Target="style40.xml"/></Relationships>
</file>

<file path=ppt/charts/_rels/chart4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1.xml"/><Relationship Id="rId1" Type="http://schemas.microsoft.com/office/2011/relationships/chartStyle" Target="style41.xml"/></Relationships>
</file>

<file path=ppt/charts/_rels/chart4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2.xml"/><Relationship Id="rId1" Type="http://schemas.microsoft.com/office/2011/relationships/chartStyle" Target="style42.xml"/></Relationships>
</file>

<file path=ppt/charts/_rels/chart4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3.xml"/><Relationship Id="rId1" Type="http://schemas.microsoft.com/office/2011/relationships/chartStyle" Target="style43.xml"/></Relationships>
</file>

<file path=ppt/charts/_rels/chart4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4.xml"/><Relationship Id="rId1" Type="http://schemas.microsoft.com/office/2011/relationships/chartStyle" Target="style44.xml"/></Relationships>
</file>

<file path=ppt/charts/_rels/chart4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5.xml"/><Relationship Id="rId1" Type="http://schemas.microsoft.com/office/2011/relationships/chartStyle" Target="style45.xml"/></Relationships>
</file>

<file path=ppt/charts/_rels/chart4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6.xml"/><Relationship Id="rId1" Type="http://schemas.microsoft.com/office/2011/relationships/chartStyle" Target="style46.xml"/></Relationships>
</file>

<file path=ppt/charts/_rels/chart4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7.xml"/><Relationship Id="rId1" Type="http://schemas.microsoft.com/office/2011/relationships/chartStyle" Target="style47.xml"/></Relationships>
</file>

<file path=ppt/charts/_rels/chart4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8.xml"/><Relationship Id="rId1" Type="http://schemas.microsoft.com/office/2011/relationships/chartStyle" Target="style48.xml"/></Relationships>
</file>

<file path=ppt/charts/_rels/chart4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49.xml"/><Relationship Id="rId1" Type="http://schemas.microsoft.com/office/2011/relationships/chartStyle" Target="style49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&#12499;&#12458;&#12481;&#12531;&#31478;&#21512;&#35542;&#25991;&#29992;&#12487;&#12540;&#12479;&#38598;&#12417;.xlsx" TargetMode="External"/><Relationship Id="rId2" Type="http://schemas.microsoft.com/office/2011/relationships/chartColorStyle" Target="colors50.xml"/><Relationship Id="rId1" Type="http://schemas.microsoft.com/office/2011/relationships/chartStyle" Target="style50.xml"/></Relationships>
</file>

<file path=ppt/charts/_rels/chart5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1.xml"/><Relationship Id="rId1" Type="http://schemas.microsoft.com/office/2011/relationships/chartStyle" Target="style51.xml"/><Relationship Id="rId4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mojima\Documents\SFTSV\mAb&#20316;&#12426;&#12408;\&#35542;&#25991;&#65288;mAb%20for%20Viruses&#65289;\mAb&#35413;&#20385;&#20104;&#23450;&#21152;&#24037;for&#35542;&#25991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19</c:f>
          <c:strCache>
            <c:ptCount val="1"/>
            <c:pt idx="0">
              <c:v>4M3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20:$H$20</c:f>
                <c:numCache>
                  <c:formatCode>General</c:formatCode>
                  <c:ptCount val="4"/>
                  <c:pt idx="0">
                    <c:v>10.816968277714814</c:v>
                  </c:pt>
                  <c:pt idx="1">
                    <c:v>4.9205826721156827</c:v>
                  </c:pt>
                  <c:pt idx="2">
                    <c:v>14.716535818220462</c:v>
                  </c:pt>
                  <c:pt idx="3">
                    <c:v>4.08842971464400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19:$H$19</c:f>
              <c:numCache>
                <c:formatCode>General</c:formatCode>
                <c:ptCount val="4"/>
                <c:pt idx="0">
                  <c:v>112.51700680272108</c:v>
                </c:pt>
                <c:pt idx="1">
                  <c:v>109.52380952380952</c:v>
                </c:pt>
                <c:pt idx="2">
                  <c:v>110.61224489795917</c:v>
                </c:pt>
                <c:pt idx="3">
                  <c:v>99.455782312925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6C-4998-9C8E-B0DDB29907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82</c:f>
          <c:strCache>
            <c:ptCount val="1"/>
            <c:pt idx="0">
              <c:v>M1-B8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83:$H$83</c:f>
                <c:numCache>
                  <c:formatCode>General</c:formatCode>
                  <c:ptCount val="4"/>
                  <c:pt idx="0">
                    <c:v>4.7384144518504856</c:v>
                  </c:pt>
                  <c:pt idx="1">
                    <c:v>7.1809042579762892</c:v>
                  </c:pt>
                  <c:pt idx="2">
                    <c:v>3.6684888511292413</c:v>
                  </c:pt>
                  <c:pt idx="3">
                    <c:v>1.20079484617152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82:$H$82</c:f>
              <c:numCache>
                <c:formatCode>General</c:formatCode>
                <c:ptCount val="4"/>
                <c:pt idx="0">
                  <c:v>87.59455370650528</c:v>
                </c:pt>
                <c:pt idx="1">
                  <c:v>80.030257186081698</c:v>
                </c:pt>
                <c:pt idx="2">
                  <c:v>75.642965204236006</c:v>
                </c:pt>
                <c:pt idx="3">
                  <c:v>55.370650529500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D7-44CE-AEFB-206F2200E1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85</c:f>
          <c:strCache>
            <c:ptCount val="1"/>
            <c:pt idx="0">
              <c:v>M1-D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86:$H$86</c:f>
                <c:numCache>
                  <c:formatCode>General</c:formatCode>
                  <c:ptCount val="4"/>
                  <c:pt idx="0">
                    <c:v>6.0580473396685655</c:v>
                  </c:pt>
                  <c:pt idx="1">
                    <c:v>4.8011665725092234</c:v>
                  </c:pt>
                  <c:pt idx="2">
                    <c:v>10.507288802453614</c:v>
                  </c:pt>
                  <c:pt idx="3">
                    <c:v>9.50311232679075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85:$H$85</c:f>
              <c:numCache>
                <c:formatCode>General</c:formatCode>
                <c:ptCount val="4"/>
                <c:pt idx="0">
                  <c:v>109.06200317965026</c:v>
                </c:pt>
                <c:pt idx="1">
                  <c:v>120.50874403815583</c:v>
                </c:pt>
                <c:pt idx="2">
                  <c:v>109.37996820349763</c:v>
                </c:pt>
                <c:pt idx="3">
                  <c:v>124.483306836248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B0-42FB-BE33-8973FF8EA2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88</c:f>
          <c:strCache>
            <c:ptCount val="1"/>
            <c:pt idx="0">
              <c:v>M1-E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89:$H$89</c:f>
                <c:numCache>
                  <c:formatCode>General</c:formatCode>
                  <c:ptCount val="4"/>
                  <c:pt idx="0">
                    <c:v>9.3491767355403219</c:v>
                  </c:pt>
                  <c:pt idx="1">
                    <c:v>9.7658554272390354</c:v>
                  </c:pt>
                  <c:pt idx="2">
                    <c:v>6.9772178865961925</c:v>
                  </c:pt>
                  <c:pt idx="3">
                    <c:v>4.8952162442854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88:$H$88</c:f>
              <c:numCache>
                <c:formatCode>General</c:formatCode>
                <c:ptCount val="4"/>
                <c:pt idx="0">
                  <c:v>108.16944024205749</c:v>
                </c:pt>
                <c:pt idx="1">
                  <c:v>93.040847201210283</c:v>
                </c:pt>
                <c:pt idx="2">
                  <c:v>100.15128593040846</c:v>
                </c:pt>
                <c:pt idx="3">
                  <c:v>76.853252647503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48-4F73-939B-168E26AF6D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91</c:f>
          <c:strCache>
            <c:ptCount val="1"/>
            <c:pt idx="0">
              <c:v>M1-E5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92:$H$92</c:f>
                <c:numCache>
                  <c:formatCode>General</c:formatCode>
                  <c:ptCount val="4"/>
                  <c:pt idx="0">
                    <c:v>8.1045935764924231</c:v>
                  </c:pt>
                  <c:pt idx="1">
                    <c:v>12.829713750028773</c:v>
                  </c:pt>
                  <c:pt idx="2">
                    <c:v>6.015217409465099</c:v>
                  </c:pt>
                  <c:pt idx="3">
                    <c:v>11.0177308413234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91:$H$91</c:f>
              <c:numCache>
                <c:formatCode>General</c:formatCode>
                <c:ptCount val="4"/>
                <c:pt idx="0">
                  <c:v>84.863945578231295</c:v>
                </c:pt>
                <c:pt idx="1">
                  <c:v>72.278911564625858</c:v>
                </c:pt>
                <c:pt idx="2">
                  <c:v>57.653061224489797</c:v>
                </c:pt>
                <c:pt idx="3">
                  <c:v>55.2721088435374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3D-41AD-8A98-6FB4211BF3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97</c:f>
          <c:strCache>
            <c:ptCount val="1"/>
            <c:pt idx="0">
              <c:v>MAb4-5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98:$H$98</c:f>
                <c:numCache>
                  <c:formatCode>General</c:formatCode>
                  <c:ptCount val="4"/>
                  <c:pt idx="0">
                    <c:v>8.041237113402067</c:v>
                  </c:pt>
                  <c:pt idx="1">
                    <c:v>2.4742268041237097</c:v>
                  </c:pt>
                  <c:pt idx="2">
                    <c:v>7.9775431431559198</c:v>
                  </c:pt>
                  <c:pt idx="3">
                    <c:v>3.05126774988634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97:$H$97</c:f>
              <c:numCache>
                <c:formatCode>General</c:formatCode>
                <c:ptCount val="4"/>
                <c:pt idx="0">
                  <c:v>103.91752577319589</c:v>
                </c:pt>
                <c:pt idx="1">
                  <c:v>88.453608247422679</c:v>
                </c:pt>
                <c:pt idx="2">
                  <c:v>83.711340206185568</c:v>
                </c:pt>
                <c:pt idx="3">
                  <c:v>74.639175257731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EB-4799-9919-56153859C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37</c:f>
          <c:strCache>
            <c:ptCount val="1"/>
            <c:pt idx="0">
              <c:v>No.16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38:$H$38</c:f>
                <c:numCache>
                  <c:formatCode>General</c:formatCode>
                  <c:ptCount val="4"/>
                  <c:pt idx="0">
                    <c:v>8.1312410841654739</c:v>
                  </c:pt>
                  <c:pt idx="1">
                    <c:v>3.32415982816863</c:v>
                  </c:pt>
                  <c:pt idx="2">
                    <c:v>13.269062429938481</c:v>
                  </c:pt>
                  <c:pt idx="3">
                    <c:v>14.0011194947960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37:$H$37</c:f>
              <c:numCache>
                <c:formatCode>General</c:formatCode>
                <c:ptCount val="4"/>
                <c:pt idx="0">
                  <c:v>103.13837375178316</c:v>
                </c:pt>
                <c:pt idx="1">
                  <c:v>90.014265335235379</c:v>
                </c:pt>
                <c:pt idx="2">
                  <c:v>88.730385164051356</c:v>
                </c:pt>
                <c:pt idx="3">
                  <c:v>91.012838801711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75-4EE1-B768-5394DA8660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43</c:f>
          <c:strCache>
            <c:ptCount val="1"/>
            <c:pt idx="0">
              <c:v>No.23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44:$H$44</c:f>
                <c:numCache>
                  <c:formatCode>General</c:formatCode>
                  <c:ptCount val="4"/>
                  <c:pt idx="0">
                    <c:v>5.1414611386419669</c:v>
                  </c:pt>
                  <c:pt idx="1">
                    <c:v>5.991440798858771</c:v>
                  </c:pt>
                  <c:pt idx="2">
                    <c:v>3.589085770444826</c:v>
                  </c:pt>
                  <c:pt idx="3">
                    <c:v>8.59123818825309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43:$H$43</c:f>
              <c:numCache>
                <c:formatCode>General</c:formatCode>
                <c:ptCount val="4"/>
                <c:pt idx="0">
                  <c:v>65.620542082738936</c:v>
                </c:pt>
                <c:pt idx="1">
                  <c:v>61.626248216833091</c:v>
                </c:pt>
                <c:pt idx="2">
                  <c:v>47.646219686162624</c:v>
                </c:pt>
                <c:pt idx="3">
                  <c:v>47.5035663338088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34-4311-9FD7-C30FFD93B4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46</c:f>
          <c:strCache>
            <c:ptCount val="1"/>
            <c:pt idx="0">
              <c:v>No.3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47:$H$47</c:f>
                <c:numCache>
                  <c:formatCode>General</c:formatCode>
                  <c:ptCount val="4"/>
                  <c:pt idx="0">
                    <c:v>8.1910854322143134</c:v>
                  </c:pt>
                  <c:pt idx="1">
                    <c:v>4.5760384971028376</c:v>
                  </c:pt>
                  <c:pt idx="2">
                    <c:v>9.8925754337151499</c:v>
                  </c:pt>
                  <c:pt idx="3">
                    <c:v>9.87095229215760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46:$H$46</c:f>
              <c:numCache>
                <c:formatCode>General</c:formatCode>
                <c:ptCount val="4"/>
                <c:pt idx="0">
                  <c:v>93.580599144079883</c:v>
                </c:pt>
                <c:pt idx="1">
                  <c:v>92.724679029957201</c:v>
                </c:pt>
                <c:pt idx="2">
                  <c:v>85.306704707560627</c:v>
                </c:pt>
                <c:pt idx="3">
                  <c:v>88.159771754636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F9-4C4E-8903-ECA5A83454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49</c:f>
          <c:strCache>
            <c:ptCount val="1"/>
            <c:pt idx="0">
              <c:v>No.33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50:$H$50</c:f>
                <c:numCache>
                  <c:formatCode>General</c:formatCode>
                  <c:ptCount val="4"/>
                  <c:pt idx="0">
                    <c:v>4.5642849839387543</c:v>
                  </c:pt>
                  <c:pt idx="1">
                    <c:v>12.22434215285948</c:v>
                  </c:pt>
                  <c:pt idx="2">
                    <c:v>8.9736496523650722</c:v>
                  </c:pt>
                  <c:pt idx="3">
                    <c:v>3.13751842309407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49:$H$49</c:f>
              <c:numCache>
                <c:formatCode>General</c:formatCode>
                <c:ptCount val="4"/>
                <c:pt idx="0">
                  <c:v>107.04419889502763</c:v>
                </c:pt>
                <c:pt idx="1">
                  <c:v>85.911602209944746</c:v>
                </c:pt>
                <c:pt idx="2">
                  <c:v>84.116022099447505</c:v>
                </c:pt>
                <c:pt idx="3">
                  <c:v>84.392265193370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8F-4655-A390-6F7CA674C4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52</c:f>
          <c:strCache>
            <c:ptCount val="1"/>
            <c:pt idx="0">
              <c:v>No.40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53:$H$53</c:f>
                <c:numCache>
                  <c:formatCode>General</c:formatCode>
                  <c:ptCount val="4"/>
                  <c:pt idx="0">
                    <c:v>12.885341275248361</c:v>
                  </c:pt>
                  <c:pt idx="1">
                    <c:v>3.7977146643280468</c:v>
                  </c:pt>
                  <c:pt idx="2">
                    <c:v>7.7001988203129059</c:v>
                  </c:pt>
                  <c:pt idx="3">
                    <c:v>16.0536220672463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52:$H$52</c:f>
              <c:numCache>
                <c:formatCode>General</c:formatCode>
                <c:ptCount val="4"/>
                <c:pt idx="0">
                  <c:v>100.27624309392264</c:v>
                </c:pt>
                <c:pt idx="1">
                  <c:v>86.60220994475138</c:v>
                </c:pt>
                <c:pt idx="2">
                  <c:v>75.138121546961315</c:v>
                </c:pt>
                <c:pt idx="3">
                  <c:v>62.1546961325966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24-4503-820C-28DCF75118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4</c:f>
          <c:strCache>
            <c:ptCount val="1"/>
            <c:pt idx="0">
              <c:v>No.2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5:$H$5</c:f>
                <c:numCache>
                  <c:formatCode>General</c:formatCode>
                  <c:ptCount val="4"/>
                  <c:pt idx="0">
                    <c:v>13.379783050966141</c:v>
                  </c:pt>
                  <c:pt idx="1">
                    <c:v>3.5619016963399837</c:v>
                  </c:pt>
                  <c:pt idx="2">
                    <c:v>8.7648247872429454</c:v>
                  </c:pt>
                  <c:pt idx="3">
                    <c:v>6.05498540986754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4:$H$4</c:f>
              <c:numCache>
                <c:formatCode>General</c:formatCode>
                <c:ptCount val="4"/>
                <c:pt idx="0">
                  <c:v>107.11678832116787</c:v>
                </c:pt>
                <c:pt idx="1">
                  <c:v>98.9051094890511</c:v>
                </c:pt>
                <c:pt idx="2">
                  <c:v>98.72262773722629</c:v>
                </c:pt>
                <c:pt idx="3">
                  <c:v>96.1678832116788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79-42D8-9370-7CA86E3524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55</c:f>
          <c:strCache>
            <c:ptCount val="1"/>
            <c:pt idx="0">
              <c:v>5M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56:$H$56</c:f>
                <c:numCache>
                  <c:formatCode>General</c:formatCode>
                  <c:ptCount val="4"/>
                  <c:pt idx="0">
                    <c:v>4.804610390816916</c:v>
                  </c:pt>
                  <c:pt idx="1">
                    <c:v>6.0920769908017141</c:v>
                  </c:pt>
                  <c:pt idx="2">
                    <c:v>4.4604758046977171</c:v>
                  </c:pt>
                  <c:pt idx="3">
                    <c:v>2.34181787455681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55:$H$55</c:f>
              <c:numCache>
                <c:formatCode>General</c:formatCode>
                <c:ptCount val="4"/>
                <c:pt idx="0">
                  <c:v>105.97938144329898</c:v>
                </c:pt>
                <c:pt idx="1">
                  <c:v>85.360824742268051</c:v>
                </c:pt>
                <c:pt idx="2">
                  <c:v>78.55670103092784</c:v>
                </c:pt>
                <c:pt idx="3">
                  <c:v>69.484536082474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66-4167-A3CA-C73DB6868C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58</c:f>
          <c:strCache>
            <c:ptCount val="1"/>
            <c:pt idx="0">
              <c:v>5M3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59:$H$59</c:f>
                <c:numCache>
                  <c:formatCode>General</c:formatCode>
                  <c:ptCount val="4"/>
                  <c:pt idx="0">
                    <c:v>5.8058743655379237</c:v>
                  </c:pt>
                  <c:pt idx="1">
                    <c:v>1.6495721976846502</c:v>
                  </c:pt>
                  <c:pt idx="2">
                    <c:v>13.415683495596978</c:v>
                  </c:pt>
                  <c:pt idx="3">
                    <c:v>7.30524830403199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58:$H$58</c:f>
              <c:numCache>
                <c:formatCode>General</c:formatCode>
                <c:ptCount val="4"/>
                <c:pt idx="0">
                  <c:v>83.401360544217695</c:v>
                </c:pt>
                <c:pt idx="1">
                  <c:v>89.523809523809518</c:v>
                </c:pt>
                <c:pt idx="2">
                  <c:v>86.666666666666671</c:v>
                </c:pt>
                <c:pt idx="3">
                  <c:v>81.3605442176870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B4-4367-AF04-D4A0FC701D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61</c:f>
          <c:strCache>
            <c:ptCount val="1"/>
            <c:pt idx="0">
              <c:v>5M5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62:$H$62</c:f>
                <c:numCache>
                  <c:formatCode>General</c:formatCode>
                  <c:ptCount val="4"/>
                  <c:pt idx="0">
                    <c:v>3.3499693967735213</c:v>
                  </c:pt>
                  <c:pt idx="1">
                    <c:v>3.3386327503974549</c:v>
                  </c:pt>
                  <c:pt idx="2">
                    <c:v>5.0998457654516507</c:v>
                  </c:pt>
                  <c:pt idx="3">
                    <c:v>5.48662446001189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61:$H$61</c:f>
              <c:numCache>
                <c:formatCode>General</c:formatCode>
                <c:ptCount val="4"/>
                <c:pt idx="0">
                  <c:v>75.675675675675677</c:v>
                </c:pt>
                <c:pt idx="1">
                  <c:v>65.341812400635931</c:v>
                </c:pt>
                <c:pt idx="2">
                  <c:v>47.535771065182836</c:v>
                </c:pt>
                <c:pt idx="3">
                  <c:v>36.565977742448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A7-44D8-81F6-2AE22870CD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64</c:f>
          <c:strCache>
            <c:ptCount val="1"/>
            <c:pt idx="0">
              <c:v>5M9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65:$H$65</c:f>
                <c:numCache>
                  <c:formatCode>General</c:formatCode>
                  <c:ptCount val="4"/>
                  <c:pt idx="0">
                    <c:v>4.2613495954736962</c:v>
                  </c:pt>
                  <c:pt idx="1">
                    <c:v>4.4959759569682483</c:v>
                  </c:pt>
                  <c:pt idx="2">
                    <c:v>9.9673213101454365</c:v>
                  </c:pt>
                  <c:pt idx="3">
                    <c:v>5.48115294652617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64:$H$64</c:f>
              <c:numCache>
                <c:formatCode>General</c:formatCode>
                <c:ptCount val="4"/>
                <c:pt idx="0">
                  <c:v>66.530612244897952</c:v>
                </c:pt>
                <c:pt idx="1">
                  <c:v>52.380952380952387</c:v>
                </c:pt>
                <c:pt idx="2">
                  <c:v>46.802721088435383</c:v>
                </c:pt>
                <c:pt idx="3">
                  <c:v>32.5170068027210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56-42EB-8FAC-C8B6A7FEC9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67</c:f>
          <c:strCache>
            <c:ptCount val="1"/>
            <c:pt idx="0">
              <c:v>C3A1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68:$H$68</c:f>
                <c:numCache>
                  <c:formatCode>General</c:formatCode>
                  <c:ptCount val="4"/>
                  <c:pt idx="0">
                    <c:v>4.3136391616893368</c:v>
                  </c:pt>
                  <c:pt idx="1">
                    <c:v>6.4876797707690077</c:v>
                  </c:pt>
                  <c:pt idx="2">
                    <c:v>7.0457676382420713</c:v>
                  </c:pt>
                  <c:pt idx="3">
                    <c:v>5.63831925978342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67:$H$67</c:f>
              <c:numCache>
                <c:formatCode>General</c:formatCode>
                <c:ptCount val="4"/>
                <c:pt idx="0">
                  <c:v>72.768532526475028</c:v>
                </c:pt>
                <c:pt idx="1">
                  <c:v>60.211800302571852</c:v>
                </c:pt>
                <c:pt idx="2">
                  <c:v>59.455370650529495</c:v>
                </c:pt>
                <c:pt idx="3">
                  <c:v>52.4962178517397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A5-4E51-B00F-04A76D1556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8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70</c:f>
          <c:strCache>
            <c:ptCount val="1"/>
            <c:pt idx="0">
              <c:v>C6C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71:$H$71</c:f>
                <c:numCache>
                  <c:formatCode>General</c:formatCode>
                  <c:ptCount val="4"/>
                  <c:pt idx="0">
                    <c:v>1.2823404514165055</c:v>
                  </c:pt>
                  <c:pt idx="1">
                    <c:v>11.229986787577236</c:v>
                  </c:pt>
                  <c:pt idx="2">
                    <c:v>3.0387368761701716</c:v>
                  </c:pt>
                  <c:pt idx="3">
                    <c:v>2.48960075009899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70:$H$70</c:f>
              <c:numCache>
                <c:formatCode>General</c:formatCode>
                <c:ptCount val="4"/>
                <c:pt idx="0">
                  <c:v>78.028747433264883</c:v>
                </c:pt>
                <c:pt idx="1">
                  <c:v>61.190965092402472</c:v>
                </c:pt>
                <c:pt idx="2">
                  <c:v>36.755646817248454</c:v>
                </c:pt>
                <c:pt idx="3">
                  <c:v>18.0698151950718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24-4691-BD14-98121195A3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8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73</c:f>
          <c:strCache>
            <c:ptCount val="1"/>
            <c:pt idx="0">
              <c:v>5D12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74:$H$74</c:f>
                <c:numCache>
                  <c:formatCode>General</c:formatCode>
                  <c:ptCount val="4"/>
                  <c:pt idx="0">
                    <c:v>14.602178064489609</c:v>
                  </c:pt>
                  <c:pt idx="1">
                    <c:v>2.6268222006133986</c:v>
                  </c:pt>
                  <c:pt idx="2">
                    <c:v>14.124412936369746</c:v>
                  </c:pt>
                  <c:pt idx="3">
                    <c:v>7.30108903224485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73:$H$73</c:f>
              <c:numCache>
                <c:formatCode>General</c:formatCode>
                <c:ptCount val="4"/>
                <c:pt idx="0">
                  <c:v>102.22575516693165</c:v>
                </c:pt>
                <c:pt idx="1">
                  <c:v>95.071542130365671</c:v>
                </c:pt>
                <c:pt idx="2">
                  <c:v>94.912559618441961</c:v>
                </c:pt>
                <c:pt idx="3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94-4486-ACE0-704B2B289A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76</c:f>
          <c:strCache>
            <c:ptCount val="1"/>
            <c:pt idx="0">
              <c:v>6D12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77:$H$77</c:f>
                <c:numCache>
                  <c:formatCode>General</c:formatCode>
                  <c:ptCount val="4"/>
                  <c:pt idx="0">
                    <c:v>6.2003179650238494</c:v>
                  </c:pt>
                  <c:pt idx="1">
                    <c:v>15.299537296354883</c:v>
                  </c:pt>
                  <c:pt idx="2">
                    <c:v>27.375015868556591</c:v>
                  </c:pt>
                  <c:pt idx="3">
                    <c:v>14.8773996443392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76:$H$76</c:f>
              <c:numCache>
                <c:formatCode>General</c:formatCode>
                <c:ptCount val="4"/>
                <c:pt idx="0">
                  <c:v>106.83624801271861</c:v>
                </c:pt>
                <c:pt idx="1">
                  <c:v>106.35930047694755</c:v>
                </c:pt>
                <c:pt idx="2">
                  <c:v>100.47694753577106</c:v>
                </c:pt>
                <c:pt idx="3">
                  <c:v>101.58982511923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F1-4D5C-882C-1A414A18B1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79</c:f>
          <c:strCache>
            <c:ptCount val="1"/>
            <c:pt idx="0">
              <c:v>8E9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80:$H$80</c:f>
                <c:numCache>
                  <c:formatCode>General</c:formatCode>
                  <c:ptCount val="4"/>
                  <c:pt idx="0">
                    <c:v>10.474764012737237</c:v>
                  </c:pt>
                  <c:pt idx="1">
                    <c:v>5.9570728124627061</c:v>
                  </c:pt>
                  <c:pt idx="2">
                    <c:v>12.510216580544357</c:v>
                  </c:pt>
                  <c:pt idx="3">
                    <c:v>9.42298347391888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79:$H$79</c:f>
              <c:numCache>
                <c:formatCode>General</c:formatCode>
                <c:ptCount val="4"/>
                <c:pt idx="0">
                  <c:v>78.060413354531008</c:v>
                </c:pt>
                <c:pt idx="1">
                  <c:v>97.77424483306838</c:v>
                </c:pt>
                <c:pt idx="2">
                  <c:v>94.912559618441989</c:v>
                </c:pt>
                <c:pt idx="3">
                  <c:v>97.4562798092209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19-4649-8FD4-FA7769B4AF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生存なし!$D$79</c:f>
          <c:strCache>
            <c:ptCount val="1"/>
            <c:pt idx="0">
              <c:v>Survival curve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生存なし!$E$80</c:f>
              <c:strCache>
                <c:ptCount val="1"/>
                <c:pt idx="0">
                  <c:v>PBS(n=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E$81:$E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80</c:v>
                </c:pt>
                <c:pt idx="13">
                  <c:v>8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577-4A1E-AA82-6D72DBB9D42B}"/>
            </c:ext>
          </c:extLst>
        </c:ser>
        <c:ser>
          <c:idx val="1"/>
          <c:order val="1"/>
          <c:tx>
            <c:strRef>
              <c:f>生存なし!$M$80</c:f>
              <c:strCache>
                <c:ptCount val="1"/>
                <c:pt idx="0">
                  <c:v>Ab3(n=5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M$81:$M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80</c:v>
                </c:pt>
                <c:pt idx="13">
                  <c:v>80</c:v>
                </c:pt>
                <c:pt idx="14">
                  <c:v>80</c:v>
                </c:pt>
                <c:pt idx="15">
                  <c:v>80</c:v>
                </c:pt>
                <c:pt idx="16">
                  <c:v>20</c:v>
                </c:pt>
                <c:pt idx="17">
                  <c:v>20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577-4A1E-AA82-6D72DBB9D42B}"/>
            </c:ext>
          </c:extLst>
        </c:ser>
        <c:ser>
          <c:idx val="2"/>
          <c:order val="2"/>
          <c:tx>
            <c:strRef>
              <c:f>生存なし!$N$80</c:f>
              <c:strCache>
                <c:ptCount val="1"/>
                <c:pt idx="0">
                  <c:v>No.22(n=5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N$81:$N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80</c:v>
                </c:pt>
                <c:pt idx="13">
                  <c:v>8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577-4A1E-AA82-6D72DBB9D4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653808"/>
        <c:axId val="194647568"/>
      </c:scatterChart>
      <c:valAx>
        <c:axId val="194653808"/>
        <c:scaling>
          <c:orientation val="minMax"/>
          <c:max val="1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p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47568"/>
        <c:crosses val="autoZero"/>
        <c:crossBetween val="midCat"/>
        <c:majorUnit val="1"/>
      </c:valAx>
      <c:valAx>
        <c:axId val="19464756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Survival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5380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7</c:f>
          <c:strCache>
            <c:ptCount val="1"/>
            <c:pt idx="0">
              <c:v>No.4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8:$H$8</c:f>
                <c:numCache>
                  <c:formatCode>General</c:formatCode>
                  <c:ptCount val="4"/>
                  <c:pt idx="0">
                    <c:v>13.967902360043281</c:v>
                  </c:pt>
                  <c:pt idx="1">
                    <c:v>12.196280884311671</c:v>
                  </c:pt>
                  <c:pt idx="2">
                    <c:v>19.139717522193216</c:v>
                  </c:pt>
                  <c:pt idx="3">
                    <c:v>5.48356905157544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7:$H$7</c:f>
              <c:numCache>
                <c:formatCode>General</c:formatCode>
                <c:ptCount val="4"/>
                <c:pt idx="0">
                  <c:v>99.087591240875938</c:v>
                </c:pt>
                <c:pt idx="1">
                  <c:v>89.051094890510953</c:v>
                </c:pt>
                <c:pt idx="2">
                  <c:v>94.34306569343066</c:v>
                </c:pt>
                <c:pt idx="3">
                  <c:v>99.4525547445255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4C-4212-B54A-1AF7F41FC9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生存なし!$D$79</c:f>
          <c:strCache>
            <c:ptCount val="1"/>
            <c:pt idx="0">
              <c:v>Survival curve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生存なし!$E$80</c:f>
              <c:strCache>
                <c:ptCount val="1"/>
                <c:pt idx="0">
                  <c:v>PBS(n=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E$81:$E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80</c:v>
                </c:pt>
                <c:pt idx="13">
                  <c:v>8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5A3-458D-9A69-5E6B5E57CD58}"/>
            </c:ext>
          </c:extLst>
        </c:ser>
        <c:ser>
          <c:idx val="1"/>
          <c:order val="1"/>
          <c:tx>
            <c:strRef>
              <c:f>生存なし!$G$80</c:f>
              <c:strCache>
                <c:ptCount val="1"/>
                <c:pt idx="0">
                  <c:v>5D12(n=3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G$81:$G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33</c:v>
                </c:pt>
                <c:pt idx="15">
                  <c:v>33</c:v>
                </c:pt>
                <c:pt idx="1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5A3-458D-9A69-5E6B5E57CD58}"/>
            </c:ext>
          </c:extLst>
        </c:ser>
        <c:ser>
          <c:idx val="2"/>
          <c:order val="2"/>
          <c:tx>
            <c:strRef>
              <c:f>生存なし!$H$80</c:f>
              <c:strCache>
                <c:ptCount val="1"/>
                <c:pt idx="0">
                  <c:v>6D12(n=3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H$81:$H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33</c:v>
                </c:pt>
                <c:pt idx="13">
                  <c:v>33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5A3-458D-9A69-5E6B5E57CD58}"/>
            </c:ext>
          </c:extLst>
        </c:ser>
        <c:ser>
          <c:idx val="3"/>
          <c:order val="3"/>
          <c:tx>
            <c:strRef>
              <c:f>生存なし!$I$80</c:f>
              <c:strCache>
                <c:ptCount val="1"/>
                <c:pt idx="0">
                  <c:v>8E9(n=3)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I$81:$I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33</c:v>
                </c:pt>
                <c:pt idx="13">
                  <c:v>33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5A3-458D-9A69-5E6B5E57CD58}"/>
            </c:ext>
          </c:extLst>
        </c:ser>
        <c:ser>
          <c:idx val="4"/>
          <c:order val="4"/>
          <c:tx>
            <c:strRef>
              <c:f>生存なし!$K$80</c:f>
              <c:strCache>
                <c:ptCount val="1"/>
                <c:pt idx="0">
                  <c:v>C3A11(n=3)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K$81:$K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33</c:v>
                </c:pt>
                <c:pt idx="15">
                  <c:v>33</c:v>
                </c:pt>
                <c:pt idx="1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5A3-458D-9A69-5E6B5E57CD58}"/>
            </c:ext>
          </c:extLst>
        </c:ser>
        <c:ser>
          <c:idx val="5"/>
          <c:order val="5"/>
          <c:tx>
            <c:strRef>
              <c:f>生存なし!$L$80</c:f>
              <c:strCache>
                <c:ptCount val="1"/>
                <c:pt idx="0">
                  <c:v>C6C1(n=5)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L$81:$L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60</c:v>
                </c:pt>
                <c:pt idx="13">
                  <c:v>6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5A3-458D-9A69-5E6B5E57CD58}"/>
            </c:ext>
          </c:extLst>
        </c:ser>
        <c:ser>
          <c:idx val="6"/>
          <c:order val="6"/>
          <c:tx>
            <c:strRef>
              <c:f>生存なし!$O$80</c:f>
              <c:strCache>
                <c:ptCount val="1"/>
                <c:pt idx="0">
                  <c:v>MAb4-5(n=5)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O$81:$O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60</c:v>
                </c:pt>
                <c:pt idx="15">
                  <c:v>60</c:v>
                </c:pt>
                <c:pt idx="16">
                  <c:v>20</c:v>
                </c:pt>
                <c:pt idx="17">
                  <c:v>20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D5A3-458D-9A69-5E6B5E57CD58}"/>
            </c:ext>
          </c:extLst>
        </c:ser>
        <c:ser>
          <c:idx val="7"/>
          <c:order val="7"/>
          <c:tx>
            <c:strRef>
              <c:f>生存なし!$P$80</c:f>
              <c:strCache>
                <c:ptCount val="1"/>
                <c:pt idx="0">
                  <c:v>M1-B8(n=5)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P$81:$P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80</c:v>
                </c:pt>
                <c:pt idx="13">
                  <c:v>8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5A3-458D-9A69-5E6B5E57CD58}"/>
            </c:ext>
          </c:extLst>
        </c:ser>
        <c:ser>
          <c:idx val="8"/>
          <c:order val="8"/>
          <c:tx>
            <c:strRef>
              <c:f>生存なし!$Q$80</c:f>
              <c:strCache>
                <c:ptCount val="1"/>
                <c:pt idx="0">
                  <c:v>M1-D1(n=6)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Q$81:$Q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67</c:v>
                </c:pt>
                <c:pt idx="15">
                  <c:v>67</c:v>
                </c:pt>
                <c:pt idx="16">
                  <c:v>17</c:v>
                </c:pt>
                <c:pt idx="17">
                  <c:v>17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D5A3-458D-9A69-5E6B5E57CD58}"/>
            </c:ext>
          </c:extLst>
        </c:ser>
        <c:ser>
          <c:idx val="9"/>
          <c:order val="9"/>
          <c:tx>
            <c:strRef>
              <c:f>生存なし!$R$80</c:f>
              <c:strCache>
                <c:ptCount val="1"/>
                <c:pt idx="0">
                  <c:v>M1-E1(n=5)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生存なし!$D$81:$D$108</c:f>
              <c:numCache>
                <c:formatCode>General</c:formatCode>
                <c:ptCount val="2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</c:numCache>
            </c:numRef>
          </c:xVal>
          <c:yVal>
            <c:numRef>
              <c:f>生存なし!$R$81:$R$108</c:f>
              <c:numCache>
                <c:formatCode>General</c:formatCode>
                <c:ptCount val="28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40</c:v>
                </c:pt>
                <c:pt idx="15">
                  <c:v>40</c:v>
                </c:pt>
                <c:pt idx="1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D5A3-458D-9A69-5E6B5E57CD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653808"/>
        <c:axId val="194647568"/>
      </c:scatterChart>
      <c:valAx>
        <c:axId val="194653808"/>
        <c:scaling>
          <c:orientation val="minMax"/>
          <c:max val="1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p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47568"/>
        <c:crosses val="autoZero"/>
        <c:crossBetween val="midCat"/>
        <c:majorUnit val="1"/>
      </c:valAx>
      <c:valAx>
        <c:axId val="19464756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Survival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5380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生存なし (体重)'!$B$68</c:f>
          <c:strCache>
            <c:ptCount val="1"/>
            <c:pt idx="0">
              <c:v>Body weight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生存なし (体重)'!$B$69</c:f>
              <c:strCache>
                <c:ptCount val="1"/>
                <c:pt idx="0">
                  <c:v>PBS(n=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75:$J$7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9760515017418596</c:v>
                  </c:pt>
                  <c:pt idx="2">
                    <c:v>0.73970847060205891</c:v>
                  </c:pt>
                  <c:pt idx="3">
                    <c:v>1.9728209979388709</c:v>
                  </c:pt>
                  <c:pt idx="4">
                    <c:v>3.2942950830683793</c:v>
                  </c:pt>
                  <c:pt idx="5">
                    <c:v>3.4559579070225022</c:v>
                  </c:pt>
                  <c:pt idx="6">
                    <c:v>4.627350518369246</c:v>
                  </c:pt>
                </c:numCache>
              </c:numRef>
            </c:plus>
            <c:minus>
              <c:numRef>
                <c:f>'生存なし (体重)'!$D$75:$J$7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9760515017418596</c:v>
                  </c:pt>
                  <c:pt idx="2">
                    <c:v>0.73970847060205891</c:v>
                  </c:pt>
                  <c:pt idx="3">
                    <c:v>1.9728209979388709</c:v>
                  </c:pt>
                  <c:pt idx="4">
                    <c:v>3.2942950830683793</c:v>
                  </c:pt>
                  <c:pt idx="5">
                    <c:v>3.4559579070225022</c:v>
                  </c:pt>
                  <c:pt idx="6">
                    <c:v>4.6273505183692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74:$R$74</c:f>
              <c:numCache>
                <c:formatCode>General</c:formatCode>
                <c:ptCount val="15"/>
                <c:pt idx="0">
                  <c:v>100</c:v>
                </c:pt>
                <c:pt idx="1">
                  <c:v>100.36511108122447</c:v>
                </c:pt>
                <c:pt idx="2">
                  <c:v>100.96357982410477</c:v>
                </c:pt>
                <c:pt idx="3">
                  <c:v>97.705456978358939</c:v>
                </c:pt>
                <c:pt idx="4">
                  <c:v>88.54933593754825</c:v>
                </c:pt>
                <c:pt idx="5">
                  <c:v>84.95304678754303</c:v>
                </c:pt>
                <c:pt idx="6">
                  <c:v>78.9282521918892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41C-4216-B1FE-CD335C498E45}"/>
            </c:ext>
          </c:extLst>
        </c:ser>
        <c:ser>
          <c:idx val="1"/>
          <c:order val="1"/>
          <c:tx>
            <c:strRef>
              <c:f>'生存なし (体重)'!$B$93</c:f>
              <c:strCache>
                <c:ptCount val="1"/>
                <c:pt idx="0">
                  <c:v>5D12(n=3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97:$J$9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601581440300353</c:v>
                  </c:pt>
                  <c:pt idx="2">
                    <c:v>2.9119617935317752</c:v>
                  </c:pt>
                  <c:pt idx="3">
                    <c:v>1.8468890665432063</c:v>
                  </c:pt>
                  <c:pt idx="4">
                    <c:v>1.675995498178001</c:v>
                  </c:pt>
                  <c:pt idx="5">
                    <c:v>1.362541802502319</c:v>
                  </c:pt>
                  <c:pt idx="6">
                    <c:v>2.4239408332683654</c:v>
                  </c:pt>
                </c:numCache>
              </c:numRef>
            </c:plus>
            <c:minus>
              <c:numRef>
                <c:f>'生存なし (体重)'!$D$97:$J$9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601581440300353</c:v>
                  </c:pt>
                  <c:pt idx="2">
                    <c:v>2.9119617935317752</c:v>
                  </c:pt>
                  <c:pt idx="3">
                    <c:v>1.8468890665432063</c:v>
                  </c:pt>
                  <c:pt idx="4">
                    <c:v>1.675995498178001</c:v>
                  </c:pt>
                  <c:pt idx="5">
                    <c:v>1.362541802502319</c:v>
                  </c:pt>
                  <c:pt idx="6">
                    <c:v>2.42394083326836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96:$R$96</c:f>
              <c:numCache>
                <c:formatCode>General</c:formatCode>
                <c:ptCount val="15"/>
                <c:pt idx="0">
                  <c:v>100</c:v>
                </c:pt>
                <c:pt idx="1">
                  <c:v>100.46978580430442</c:v>
                </c:pt>
                <c:pt idx="2">
                  <c:v>99.240896971683853</c:v>
                </c:pt>
                <c:pt idx="3">
                  <c:v>94.730656731163492</c:v>
                </c:pt>
                <c:pt idx="4">
                  <c:v>87.615356518247154</c:v>
                </c:pt>
                <c:pt idx="5">
                  <c:v>85.239252123055238</c:v>
                </c:pt>
                <c:pt idx="6">
                  <c:v>76.785037241478577</c:v>
                </c:pt>
                <c:pt idx="7">
                  <c:v>76.4505119453924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41C-4216-B1FE-CD335C498E45}"/>
            </c:ext>
          </c:extLst>
        </c:ser>
        <c:ser>
          <c:idx val="2"/>
          <c:order val="2"/>
          <c:tx>
            <c:strRef>
              <c:f>'生存なし (体重)'!$B$99</c:f>
              <c:strCache>
                <c:ptCount val="1"/>
                <c:pt idx="0">
                  <c:v>6D12(n=3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03:$I$10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8215310514244076</c:v>
                  </c:pt>
                  <c:pt idx="2">
                    <c:v>1.7082215356586341</c:v>
                  </c:pt>
                  <c:pt idx="3">
                    <c:v>0.71451179205817528</c:v>
                  </c:pt>
                  <c:pt idx="4">
                    <c:v>1.3978334223973623</c:v>
                  </c:pt>
                  <c:pt idx="5">
                    <c:v>0.54120929799738626</c:v>
                  </c:pt>
                </c:numCache>
              </c:numRef>
            </c:plus>
            <c:minus>
              <c:numRef>
                <c:f>'生存なし (体重)'!$D$103:$I$10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8215310514244076</c:v>
                  </c:pt>
                  <c:pt idx="2">
                    <c:v>1.7082215356586341</c:v>
                  </c:pt>
                  <c:pt idx="3">
                    <c:v>0.71451179205817528</c:v>
                  </c:pt>
                  <c:pt idx="4">
                    <c:v>1.3978334223973623</c:v>
                  </c:pt>
                  <c:pt idx="5">
                    <c:v>0.541209297997386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02:$R$102</c:f>
              <c:numCache>
                <c:formatCode>General</c:formatCode>
                <c:ptCount val="15"/>
                <c:pt idx="0">
                  <c:v>100</c:v>
                </c:pt>
                <c:pt idx="1">
                  <c:v>100.74728092297255</c:v>
                </c:pt>
                <c:pt idx="2">
                  <c:v>101.17803324830992</c:v>
                </c:pt>
                <c:pt idx="3">
                  <c:v>96.977289569396547</c:v>
                </c:pt>
                <c:pt idx="4">
                  <c:v>87.138232162488109</c:v>
                </c:pt>
                <c:pt idx="5">
                  <c:v>82.651184748995149</c:v>
                </c:pt>
                <c:pt idx="6">
                  <c:v>75.0915750915750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41C-4216-B1FE-CD335C498E45}"/>
            </c:ext>
          </c:extLst>
        </c:ser>
        <c:ser>
          <c:idx val="3"/>
          <c:order val="3"/>
          <c:tx>
            <c:strRef>
              <c:f>'生存なし (体重)'!$B$105</c:f>
              <c:strCache>
                <c:ptCount val="1"/>
                <c:pt idx="0">
                  <c:v>8E9(n=3)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09:$I$10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1566958975882589</c:v>
                  </c:pt>
                  <c:pt idx="2">
                    <c:v>2.3918979987170474</c:v>
                  </c:pt>
                  <c:pt idx="3">
                    <c:v>2.5594905008260054</c:v>
                  </c:pt>
                  <c:pt idx="4">
                    <c:v>2.3652151482481902</c:v>
                  </c:pt>
                  <c:pt idx="5">
                    <c:v>2.4739836049460071</c:v>
                  </c:pt>
                </c:numCache>
              </c:numRef>
            </c:plus>
            <c:minus>
              <c:numRef>
                <c:f>'生存なし (体重)'!$D$109:$I$10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1566958975882589</c:v>
                  </c:pt>
                  <c:pt idx="2">
                    <c:v>2.3918979987170474</c:v>
                  </c:pt>
                  <c:pt idx="3">
                    <c:v>2.5594905008260054</c:v>
                  </c:pt>
                  <c:pt idx="4">
                    <c:v>2.3652151482481902</c:v>
                  </c:pt>
                  <c:pt idx="5">
                    <c:v>2.47398360494600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08:$R$108</c:f>
              <c:numCache>
                <c:formatCode>General</c:formatCode>
                <c:ptCount val="15"/>
                <c:pt idx="0">
                  <c:v>100</c:v>
                </c:pt>
                <c:pt idx="1">
                  <c:v>101.11186756464254</c:v>
                </c:pt>
                <c:pt idx="2">
                  <c:v>100.67468805226319</c:v>
                </c:pt>
                <c:pt idx="3">
                  <c:v>97.050948038789969</c:v>
                </c:pt>
                <c:pt idx="4">
                  <c:v>88.666926362524691</c:v>
                </c:pt>
                <c:pt idx="5">
                  <c:v>83.977048485097569</c:v>
                </c:pt>
                <c:pt idx="6">
                  <c:v>74.4897959183673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41C-4216-B1FE-CD335C498E45}"/>
            </c:ext>
          </c:extLst>
        </c:ser>
        <c:ser>
          <c:idx val="4"/>
          <c:order val="4"/>
          <c:tx>
            <c:strRef>
              <c:f>'生存なし (体重)'!$B$111</c:f>
              <c:strCache>
                <c:ptCount val="1"/>
                <c:pt idx="0">
                  <c:v>C3A11(n=3)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15:$J$11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8225607385797209</c:v>
                  </c:pt>
                  <c:pt idx="2">
                    <c:v>1.3823790880149507</c:v>
                  </c:pt>
                  <c:pt idx="3">
                    <c:v>0.72475207112552376</c:v>
                  </c:pt>
                  <c:pt idx="4">
                    <c:v>0.58809408284231368</c:v>
                  </c:pt>
                  <c:pt idx="5">
                    <c:v>0.24069440731472685</c:v>
                  </c:pt>
                  <c:pt idx="6">
                    <c:v>1.5037662558439397</c:v>
                  </c:pt>
                </c:numCache>
              </c:numRef>
            </c:plus>
            <c:minus>
              <c:numRef>
                <c:f>'生存なし (体重)'!$D$115:$J$11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8225607385797209</c:v>
                  </c:pt>
                  <c:pt idx="2">
                    <c:v>1.3823790880149507</c:v>
                  </c:pt>
                  <c:pt idx="3">
                    <c:v>0.72475207112552376</c:v>
                  </c:pt>
                  <c:pt idx="4">
                    <c:v>0.58809408284231368</c:v>
                  </c:pt>
                  <c:pt idx="5">
                    <c:v>0.24069440731472685</c:v>
                  </c:pt>
                  <c:pt idx="6">
                    <c:v>1.50376625584393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14:$R$114</c:f>
              <c:numCache>
                <c:formatCode>General</c:formatCode>
                <c:ptCount val="15"/>
                <c:pt idx="0">
                  <c:v>100</c:v>
                </c:pt>
                <c:pt idx="1">
                  <c:v>100.8594371328151</c:v>
                </c:pt>
                <c:pt idx="2">
                  <c:v>99.813334537626645</c:v>
                </c:pt>
                <c:pt idx="3">
                  <c:v>96.102489176731936</c:v>
                </c:pt>
                <c:pt idx="4">
                  <c:v>90.649934622563237</c:v>
                </c:pt>
                <c:pt idx="5">
                  <c:v>86.500211281387166</c:v>
                </c:pt>
                <c:pt idx="6">
                  <c:v>80.521912731564086</c:v>
                </c:pt>
                <c:pt idx="7">
                  <c:v>74.8633879781420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41C-4216-B1FE-CD335C498E45}"/>
            </c:ext>
          </c:extLst>
        </c:ser>
        <c:ser>
          <c:idx val="5"/>
          <c:order val="5"/>
          <c:tx>
            <c:strRef>
              <c:f>'生存なし (体重)'!$B$117</c:f>
              <c:strCache>
                <c:ptCount val="1"/>
                <c:pt idx="0">
                  <c:v>C6C1(n=5)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23:$J$1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376445338858405</c:v>
                  </c:pt>
                  <c:pt idx="2">
                    <c:v>0.80615047298330667</c:v>
                  </c:pt>
                  <c:pt idx="3">
                    <c:v>1.911503182749327</c:v>
                  </c:pt>
                  <c:pt idx="4">
                    <c:v>1.9697386105925396</c:v>
                  </c:pt>
                  <c:pt idx="5">
                    <c:v>2.26776033541385</c:v>
                  </c:pt>
                  <c:pt idx="6">
                    <c:v>3.2653447989461912</c:v>
                  </c:pt>
                </c:numCache>
              </c:numRef>
            </c:plus>
            <c:minus>
              <c:numRef>
                <c:f>'生存なし (体重)'!$D$123:$J$1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376445338858405</c:v>
                  </c:pt>
                  <c:pt idx="2">
                    <c:v>0.80615047298330667</c:v>
                  </c:pt>
                  <c:pt idx="3">
                    <c:v>1.911503182749327</c:v>
                  </c:pt>
                  <c:pt idx="4">
                    <c:v>1.9697386105925396</c:v>
                  </c:pt>
                  <c:pt idx="5">
                    <c:v>2.26776033541385</c:v>
                  </c:pt>
                  <c:pt idx="6">
                    <c:v>3.26534479894619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22:$R$122</c:f>
              <c:numCache>
                <c:formatCode>General</c:formatCode>
                <c:ptCount val="15"/>
                <c:pt idx="0">
                  <c:v>100</c:v>
                </c:pt>
                <c:pt idx="1">
                  <c:v>100.73735696100323</c:v>
                </c:pt>
                <c:pt idx="2">
                  <c:v>101.14165735788723</c:v>
                </c:pt>
                <c:pt idx="3">
                  <c:v>96.42067980079527</c:v>
                </c:pt>
                <c:pt idx="4">
                  <c:v>88.320076143929299</c:v>
                </c:pt>
                <c:pt idx="5">
                  <c:v>84.175354595581723</c:v>
                </c:pt>
                <c:pt idx="6">
                  <c:v>78.7421873237212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41C-4216-B1FE-CD335C498E45}"/>
            </c:ext>
          </c:extLst>
        </c:ser>
        <c:ser>
          <c:idx val="6"/>
          <c:order val="6"/>
          <c:tx>
            <c:strRef>
              <c:f>'生存なし (体重)'!$B$125</c:f>
              <c:strCache>
                <c:ptCount val="1"/>
                <c:pt idx="0">
                  <c:v>MAb4-5(n=5)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31:$K$13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1023283067399645</c:v>
                  </c:pt>
                  <c:pt idx="2">
                    <c:v>0.75372913832784871</c:v>
                  </c:pt>
                  <c:pt idx="3">
                    <c:v>1.5292462808053191</c:v>
                  </c:pt>
                  <c:pt idx="4">
                    <c:v>3.1234526139021628</c:v>
                  </c:pt>
                  <c:pt idx="5">
                    <c:v>3.1567967811814071</c:v>
                  </c:pt>
                  <c:pt idx="6">
                    <c:v>3.4101799406387636</c:v>
                  </c:pt>
                  <c:pt idx="7">
                    <c:v>4.3043525218721728</c:v>
                  </c:pt>
                </c:numCache>
              </c:numRef>
            </c:plus>
            <c:minus>
              <c:numRef>
                <c:f>'生存なし (体重)'!$D$131:$K$13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1023283067399645</c:v>
                  </c:pt>
                  <c:pt idx="2">
                    <c:v>0.75372913832784871</c:v>
                  </c:pt>
                  <c:pt idx="3">
                    <c:v>1.5292462808053191</c:v>
                  </c:pt>
                  <c:pt idx="4">
                    <c:v>3.1234526139021628</c:v>
                  </c:pt>
                  <c:pt idx="5">
                    <c:v>3.1567967811814071</c:v>
                  </c:pt>
                  <c:pt idx="6">
                    <c:v>3.4101799406387636</c:v>
                  </c:pt>
                  <c:pt idx="7">
                    <c:v>4.30435252187217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30:$R$130</c:f>
              <c:numCache>
                <c:formatCode>General</c:formatCode>
                <c:ptCount val="15"/>
                <c:pt idx="0">
                  <c:v>100</c:v>
                </c:pt>
                <c:pt idx="1">
                  <c:v>101.84392549184064</c:v>
                </c:pt>
                <c:pt idx="2">
                  <c:v>100.56534604390889</c:v>
                </c:pt>
                <c:pt idx="3">
                  <c:v>100.05622160812106</c:v>
                </c:pt>
                <c:pt idx="4">
                  <c:v>93.298488408847447</c:v>
                </c:pt>
                <c:pt idx="5">
                  <c:v>87.580444635400283</c:v>
                </c:pt>
                <c:pt idx="6">
                  <c:v>82.418973765914927</c:v>
                </c:pt>
                <c:pt idx="7">
                  <c:v>75.433272299920773</c:v>
                </c:pt>
                <c:pt idx="8">
                  <c:v>76.7857142857142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F41C-4216-B1FE-CD335C498E45}"/>
            </c:ext>
          </c:extLst>
        </c:ser>
        <c:ser>
          <c:idx val="7"/>
          <c:order val="7"/>
          <c:tx>
            <c:strRef>
              <c:f>'生存なし (体重)'!$B$133</c:f>
              <c:strCache>
                <c:ptCount val="1"/>
                <c:pt idx="0">
                  <c:v>M1-B8(n=5)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39:$J$13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91536105362290765</c:v>
                  </c:pt>
                  <c:pt idx="2">
                    <c:v>1.2815122631451186</c:v>
                  </c:pt>
                  <c:pt idx="3">
                    <c:v>1.4393066366681262</c:v>
                  </c:pt>
                  <c:pt idx="4">
                    <c:v>2.1262121895917869</c:v>
                  </c:pt>
                  <c:pt idx="5">
                    <c:v>1.5388515419323636</c:v>
                  </c:pt>
                  <c:pt idx="6">
                    <c:v>1.6126491803287319</c:v>
                  </c:pt>
                </c:numCache>
              </c:numRef>
            </c:plus>
            <c:minus>
              <c:numRef>
                <c:f>'生存なし (体重)'!$D$139:$J$13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91536105362290765</c:v>
                  </c:pt>
                  <c:pt idx="2">
                    <c:v>1.2815122631451186</c:v>
                  </c:pt>
                  <c:pt idx="3">
                    <c:v>1.4393066366681262</c:v>
                  </c:pt>
                  <c:pt idx="4">
                    <c:v>2.1262121895917869</c:v>
                  </c:pt>
                  <c:pt idx="5">
                    <c:v>1.5388515419323636</c:v>
                  </c:pt>
                  <c:pt idx="6">
                    <c:v>1.61264918032873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38:$R$138</c:f>
              <c:numCache>
                <c:formatCode>General</c:formatCode>
                <c:ptCount val="15"/>
                <c:pt idx="0">
                  <c:v>100</c:v>
                </c:pt>
                <c:pt idx="1">
                  <c:v>101.55050744023656</c:v>
                </c:pt>
                <c:pt idx="2">
                  <c:v>100.91215665897001</c:v>
                </c:pt>
                <c:pt idx="3">
                  <c:v>98.789068477781541</c:v>
                </c:pt>
                <c:pt idx="4">
                  <c:v>91.554549581103771</c:v>
                </c:pt>
                <c:pt idx="5">
                  <c:v>85.539990867443962</c:v>
                </c:pt>
                <c:pt idx="6">
                  <c:v>80.4946038757581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F41C-4216-B1FE-CD335C498E45}"/>
            </c:ext>
          </c:extLst>
        </c:ser>
        <c:ser>
          <c:idx val="8"/>
          <c:order val="8"/>
          <c:tx>
            <c:strRef>
              <c:f>'生存なし (体重)'!$B$141</c:f>
              <c:strCache>
                <c:ptCount val="1"/>
                <c:pt idx="0">
                  <c:v>M1-D1(n=6)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48:$L$148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3796517757755762</c:v>
                  </c:pt>
                  <c:pt idx="2">
                    <c:v>2.8129396942228304</c:v>
                  </c:pt>
                  <c:pt idx="3">
                    <c:v>0.95717948393613372</c:v>
                  </c:pt>
                  <c:pt idx="4">
                    <c:v>1.4306524903361315</c:v>
                  </c:pt>
                  <c:pt idx="5">
                    <c:v>1.7853894781270714</c:v>
                  </c:pt>
                  <c:pt idx="6">
                    <c:v>2.8214228579185474</c:v>
                  </c:pt>
                  <c:pt idx="7">
                    <c:v>1.6700453732470155</c:v>
                  </c:pt>
                </c:numCache>
              </c:numRef>
            </c:plus>
            <c:minus>
              <c:numRef>
                <c:f>'生存なし (体重)'!$D$148:$L$148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3796517757755762</c:v>
                  </c:pt>
                  <c:pt idx="2">
                    <c:v>2.8129396942228304</c:v>
                  </c:pt>
                  <c:pt idx="3">
                    <c:v>0.95717948393613372</c:v>
                  </c:pt>
                  <c:pt idx="4">
                    <c:v>1.4306524903361315</c:v>
                  </c:pt>
                  <c:pt idx="5">
                    <c:v>1.7853894781270714</c:v>
                  </c:pt>
                  <c:pt idx="6">
                    <c:v>2.8214228579185474</c:v>
                  </c:pt>
                  <c:pt idx="7">
                    <c:v>1.67004537324701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47:$R$147</c:f>
              <c:numCache>
                <c:formatCode>General</c:formatCode>
                <c:ptCount val="15"/>
                <c:pt idx="0">
                  <c:v>100</c:v>
                </c:pt>
                <c:pt idx="1">
                  <c:v>101.92815231628295</c:v>
                </c:pt>
                <c:pt idx="2">
                  <c:v>102.39549543711492</c:v>
                </c:pt>
                <c:pt idx="3">
                  <c:v>99.079776161858092</c:v>
                </c:pt>
                <c:pt idx="4">
                  <c:v>93.071214821540948</c:v>
                </c:pt>
                <c:pt idx="5">
                  <c:v>88.563380314356792</c:v>
                </c:pt>
                <c:pt idx="6">
                  <c:v>83.089935514425292</c:v>
                </c:pt>
                <c:pt idx="7">
                  <c:v>76.141515077092535</c:v>
                </c:pt>
                <c:pt idx="8">
                  <c:v>72.3484848484848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F41C-4216-B1FE-CD335C498E45}"/>
            </c:ext>
          </c:extLst>
        </c:ser>
        <c:ser>
          <c:idx val="9"/>
          <c:order val="9"/>
          <c:tx>
            <c:strRef>
              <c:f>'生存なし (体重)'!$B$150</c:f>
              <c:strCache>
                <c:ptCount val="1"/>
                <c:pt idx="0">
                  <c:v>M1-E1(n=5)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156:$K$15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0481618561181938</c:v>
                  </c:pt>
                  <c:pt idx="2">
                    <c:v>0.73860534259327182</c:v>
                  </c:pt>
                  <c:pt idx="3">
                    <c:v>1.2956962376099521</c:v>
                  </c:pt>
                  <c:pt idx="4">
                    <c:v>2.6458433755260193</c:v>
                  </c:pt>
                  <c:pt idx="5">
                    <c:v>2.6309328356350656</c:v>
                  </c:pt>
                  <c:pt idx="6">
                    <c:v>3.7114108787244873</c:v>
                  </c:pt>
                  <c:pt idx="7">
                    <c:v>1.6335609720472957</c:v>
                  </c:pt>
                </c:numCache>
              </c:numRef>
            </c:plus>
            <c:minus>
              <c:numRef>
                <c:f>'生存なし (体重)'!$D$156:$K$15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0481618561181938</c:v>
                  </c:pt>
                  <c:pt idx="2">
                    <c:v>0.73860534259327182</c:v>
                  </c:pt>
                  <c:pt idx="3">
                    <c:v>1.2956962376099521</c:v>
                  </c:pt>
                  <c:pt idx="4">
                    <c:v>2.6458433755260193</c:v>
                  </c:pt>
                  <c:pt idx="5">
                    <c:v>2.6309328356350656</c:v>
                  </c:pt>
                  <c:pt idx="6">
                    <c:v>3.7114108787244873</c:v>
                  </c:pt>
                  <c:pt idx="7">
                    <c:v>1.63356097204729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155:$R$155</c:f>
              <c:numCache>
                <c:formatCode>General</c:formatCode>
                <c:ptCount val="15"/>
                <c:pt idx="0">
                  <c:v>100</c:v>
                </c:pt>
                <c:pt idx="1">
                  <c:v>101.43508151895745</c:v>
                </c:pt>
                <c:pt idx="2">
                  <c:v>99.287081158044614</c:v>
                </c:pt>
                <c:pt idx="3">
                  <c:v>98.502513134677528</c:v>
                </c:pt>
                <c:pt idx="4">
                  <c:v>92.302186718974752</c:v>
                </c:pt>
                <c:pt idx="5">
                  <c:v>86.909799001501511</c:v>
                </c:pt>
                <c:pt idx="6">
                  <c:v>80.093649908901881</c:v>
                </c:pt>
                <c:pt idx="7">
                  <c:v>75.644897959183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F41C-4216-B1FE-CD335C498E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2360576"/>
        <c:axId val="1502360160"/>
      </c:lineChart>
      <c:catAx>
        <c:axId val="1502360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p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02360160"/>
        <c:crosses val="autoZero"/>
        <c:auto val="1"/>
        <c:lblAlgn val="ctr"/>
        <c:lblOffset val="100"/>
        <c:noMultiLvlLbl val="0"/>
      </c:catAx>
      <c:valAx>
        <c:axId val="1502360160"/>
        <c:scaling>
          <c:orientation val="minMax"/>
          <c:max val="110"/>
          <c:min val="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0dp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0236057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生存なし (体重)'!$B$68</c:f>
          <c:strCache>
            <c:ptCount val="1"/>
            <c:pt idx="0">
              <c:v>Body weight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生存なし (体重)'!$B$69</c:f>
              <c:strCache>
                <c:ptCount val="1"/>
                <c:pt idx="0">
                  <c:v>PBS(n=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75:$J$7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9760515017418596</c:v>
                  </c:pt>
                  <c:pt idx="2">
                    <c:v>0.73970847060205891</c:v>
                  </c:pt>
                  <c:pt idx="3">
                    <c:v>1.9728209979388709</c:v>
                  </c:pt>
                  <c:pt idx="4">
                    <c:v>3.2942950830683793</c:v>
                  </c:pt>
                  <c:pt idx="5">
                    <c:v>3.4559579070225022</c:v>
                  </c:pt>
                  <c:pt idx="6">
                    <c:v>4.627350518369246</c:v>
                  </c:pt>
                </c:numCache>
              </c:numRef>
            </c:plus>
            <c:minus>
              <c:numRef>
                <c:f>'生存なし (体重)'!$D$75:$J$7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9760515017418596</c:v>
                  </c:pt>
                  <c:pt idx="2">
                    <c:v>0.73970847060205891</c:v>
                  </c:pt>
                  <c:pt idx="3">
                    <c:v>1.9728209979388709</c:v>
                  </c:pt>
                  <c:pt idx="4">
                    <c:v>3.2942950830683793</c:v>
                  </c:pt>
                  <c:pt idx="5">
                    <c:v>3.4559579070225022</c:v>
                  </c:pt>
                  <c:pt idx="6">
                    <c:v>4.6273505183692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74:$R$74</c:f>
              <c:numCache>
                <c:formatCode>General</c:formatCode>
                <c:ptCount val="15"/>
                <c:pt idx="0">
                  <c:v>100</c:v>
                </c:pt>
                <c:pt idx="1">
                  <c:v>100.36511108122447</c:v>
                </c:pt>
                <c:pt idx="2">
                  <c:v>100.96357982410477</c:v>
                </c:pt>
                <c:pt idx="3">
                  <c:v>97.705456978358939</c:v>
                </c:pt>
                <c:pt idx="4">
                  <c:v>88.54933593754825</c:v>
                </c:pt>
                <c:pt idx="5">
                  <c:v>84.95304678754303</c:v>
                </c:pt>
                <c:pt idx="6">
                  <c:v>78.9282521918892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E58-431D-959D-E64899E68851}"/>
            </c:ext>
          </c:extLst>
        </c:ser>
        <c:ser>
          <c:idx val="1"/>
          <c:order val="1"/>
          <c:tx>
            <c:strRef>
              <c:f>'生存なし (体重)'!$B$77</c:f>
              <c:strCache>
                <c:ptCount val="1"/>
                <c:pt idx="0">
                  <c:v>Ab3(n=5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83:$R$83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2.1500911448689126</c:v>
                  </c:pt>
                  <c:pt idx="2">
                    <c:v>1.4426944414544915</c:v>
                  </c:pt>
                  <c:pt idx="3">
                    <c:v>1.8409500586207941</c:v>
                  </c:pt>
                  <c:pt idx="4">
                    <c:v>1.5525184949888218</c:v>
                  </c:pt>
                  <c:pt idx="5">
                    <c:v>2.044222027627161</c:v>
                  </c:pt>
                  <c:pt idx="6">
                    <c:v>2.3933555899542256</c:v>
                  </c:pt>
                  <c:pt idx="7">
                    <c:v>3.3337230267891425</c:v>
                  </c:pt>
                </c:numCache>
              </c:numRef>
            </c:plus>
            <c:minus>
              <c:numRef>
                <c:f>'生存なし (体重)'!$D$83:$R$83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2.1500911448689126</c:v>
                  </c:pt>
                  <c:pt idx="2">
                    <c:v>1.4426944414544915</c:v>
                  </c:pt>
                  <c:pt idx="3">
                    <c:v>1.8409500586207941</c:v>
                  </c:pt>
                  <c:pt idx="4">
                    <c:v>1.5525184949888218</c:v>
                  </c:pt>
                  <c:pt idx="5">
                    <c:v>2.044222027627161</c:v>
                  </c:pt>
                  <c:pt idx="6">
                    <c:v>2.3933555899542256</c:v>
                  </c:pt>
                  <c:pt idx="7">
                    <c:v>3.33372302678914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82:$R$82</c:f>
              <c:numCache>
                <c:formatCode>General</c:formatCode>
                <c:ptCount val="15"/>
                <c:pt idx="0">
                  <c:v>100</c:v>
                </c:pt>
                <c:pt idx="1">
                  <c:v>101.26291887984117</c:v>
                </c:pt>
                <c:pt idx="2">
                  <c:v>102.14059587374955</c:v>
                </c:pt>
                <c:pt idx="3">
                  <c:v>101.02631310362366</c:v>
                </c:pt>
                <c:pt idx="4">
                  <c:v>93.338815630655532</c:v>
                </c:pt>
                <c:pt idx="5">
                  <c:v>87.281282454686604</c:v>
                </c:pt>
                <c:pt idx="6">
                  <c:v>83.025325513365402</c:v>
                </c:pt>
                <c:pt idx="7">
                  <c:v>75.859064713902484</c:v>
                </c:pt>
                <c:pt idx="8">
                  <c:v>72.5388601036269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E58-431D-959D-E64899E68851}"/>
            </c:ext>
          </c:extLst>
        </c:ser>
        <c:ser>
          <c:idx val="2"/>
          <c:order val="2"/>
          <c:tx>
            <c:strRef>
              <c:f>'生存なし (体重)'!$B$85</c:f>
              <c:strCache>
                <c:ptCount val="1"/>
                <c:pt idx="0">
                  <c:v>No.22(n=5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生存なし (体重)'!$D$91:$J$9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94355466970679358</c:v>
                  </c:pt>
                  <c:pt idx="2">
                    <c:v>1.6303253670319149</c:v>
                  </c:pt>
                  <c:pt idx="3">
                    <c:v>3.3799118082482384</c:v>
                  </c:pt>
                  <c:pt idx="4">
                    <c:v>3.5825171424455058</c:v>
                  </c:pt>
                  <c:pt idx="5">
                    <c:v>4.7800259602158715</c:v>
                  </c:pt>
                  <c:pt idx="6">
                    <c:v>5.5730933630375201</c:v>
                  </c:pt>
                </c:numCache>
              </c:numRef>
            </c:plus>
            <c:minus>
              <c:numRef>
                <c:f>'生存なし (体重)'!$D$91:$J$9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94355466970679358</c:v>
                  </c:pt>
                  <c:pt idx="2">
                    <c:v>1.6303253670319149</c:v>
                  </c:pt>
                  <c:pt idx="3">
                    <c:v>3.3799118082482384</c:v>
                  </c:pt>
                  <c:pt idx="4">
                    <c:v>3.5825171424455058</c:v>
                  </c:pt>
                  <c:pt idx="5">
                    <c:v>4.7800259602158715</c:v>
                  </c:pt>
                  <c:pt idx="6">
                    <c:v>5.57309336303752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生存なし (体重)'!$D$2:$R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生存なし (体重)'!$D$90:$R$90</c:f>
              <c:numCache>
                <c:formatCode>General</c:formatCode>
                <c:ptCount val="15"/>
                <c:pt idx="0">
                  <c:v>100</c:v>
                </c:pt>
                <c:pt idx="1">
                  <c:v>100.01476173889967</c:v>
                </c:pt>
                <c:pt idx="2">
                  <c:v>100.75237653814231</c:v>
                </c:pt>
                <c:pt idx="3">
                  <c:v>98.513902870672823</c:v>
                </c:pt>
                <c:pt idx="4">
                  <c:v>91.304487155297238</c:v>
                </c:pt>
                <c:pt idx="5">
                  <c:v>85.221766041087534</c:v>
                </c:pt>
                <c:pt idx="6">
                  <c:v>79.6144558023845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E58-431D-959D-E64899E688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4686672"/>
        <c:axId val="194685008"/>
      </c:lineChart>
      <c:catAx>
        <c:axId val="194686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p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85008"/>
        <c:crosses val="autoZero"/>
        <c:auto val="1"/>
        <c:lblAlgn val="ctr"/>
        <c:lblOffset val="100"/>
        <c:noMultiLvlLbl val="0"/>
      </c:catAx>
      <c:valAx>
        <c:axId val="194685008"/>
        <c:scaling>
          <c:orientation val="minMax"/>
          <c:max val="110"/>
          <c:min val="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0dp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866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Ab10-biotin'!$B$2</c:f>
          <c:strCache>
            <c:ptCount val="1"/>
            <c:pt idx="0">
              <c:v>Binding of Ab10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b10-biotin'!$H$4:$H$17</c:f>
                <c:numCache>
                  <c:formatCode>General</c:formatCode>
                  <c:ptCount val="14"/>
                  <c:pt idx="0">
                    <c:v>0.69902004499217396</c:v>
                  </c:pt>
                  <c:pt idx="1">
                    <c:v>3.6082108517746931</c:v>
                  </c:pt>
                  <c:pt idx="2">
                    <c:v>4.2534803434175501</c:v>
                  </c:pt>
                  <c:pt idx="3">
                    <c:v>1.6807531225342056</c:v>
                  </c:pt>
                  <c:pt idx="5">
                    <c:v>2.6312160502135593</c:v>
                  </c:pt>
                  <c:pt idx="6">
                    <c:v>4.3089977323544195</c:v>
                  </c:pt>
                  <c:pt idx="7">
                    <c:v>3.5772126820964263</c:v>
                  </c:pt>
                  <c:pt idx="8">
                    <c:v>2.629598084772196</c:v>
                  </c:pt>
                  <c:pt idx="10">
                    <c:v>17.37568211176302</c:v>
                  </c:pt>
                  <c:pt idx="11">
                    <c:v>7.046729048114857</c:v>
                  </c:pt>
                  <c:pt idx="12">
                    <c:v>9.6048953322693613</c:v>
                  </c:pt>
                  <c:pt idx="13">
                    <c:v>5.66392012504009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Ab10-biotin'!$B$4:$C$17</c:f>
              <c:multiLvlStrCache>
                <c:ptCount val="1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</c:lvl>
                <c:lvl>
                  <c:pt idx="0">
                    <c:v>Ab10</c:v>
                  </c:pt>
                  <c:pt idx="5">
                    <c:v>4M5</c:v>
                  </c:pt>
                  <c:pt idx="10">
                    <c:v>M1-E5</c:v>
                  </c:pt>
                </c:lvl>
              </c:multiLvlStrCache>
            </c:multiLvlStrRef>
          </c:cat>
          <c:val>
            <c:numRef>
              <c:f>'Ab10-biotin'!$G$4:$G$17</c:f>
              <c:numCache>
                <c:formatCode>General</c:formatCode>
                <c:ptCount val="14"/>
                <c:pt idx="0">
                  <c:v>13.968184789714536</c:v>
                </c:pt>
                <c:pt idx="1">
                  <c:v>31.553715406406628</c:v>
                </c:pt>
                <c:pt idx="2">
                  <c:v>72.804532577903686</c:v>
                </c:pt>
                <c:pt idx="3">
                  <c:v>109.56635432556114</c:v>
                </c:pt>
                <c:pt idx="5">
                  <c:v>103.78531073446329</c:v>
                </c:pt>
                <c:pt idx="6">
                  <c:v>96.723163841807903</c:v>
                </c:pt>
                <c:pt idx="7">
                  <c:v>91.299435028248581</c:v>
                </c:pt>
                <c:pt idx="8">
                  <c:v>91.224105461393606</c:v>
                </c:pt>
                <c:pt idx="10">
                  <c:v>107.10394421442582</c:v>
                </c:pt>
                <c:pt idx="11">
                  <c:v>102.63674003050774</c:v>
                </c:pt>
                <c:pt idx="12">
                  <c:v>124.36260623229464</c:v>
                </c:pt>
                <c:pt idx="13">
                  <c:v>115.864022662889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75-41C4-AAFB-21D2F7F38D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% of control (no compet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4M5-biotin'!$B$2</c:f>
          <c:strCache>
            <c:ptCount val="1"/>
            <c:pt idx="0">
              <c:v>Binding of 4M5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4M5-biotin'!$H$4:$H$17</c:f>
                <c:numCache>
                  <c:formatCode>General</c:formatCode>
                  <c:ptCount val="14"/>
                  <c:pt idx="0">
                    <c:v>6.5957554881925837</c:v>
                  </c:pt>
                  <c:pt idx="1">
                    <c:v>6.3899847434737866</c:v>
                  </c:pt>
                  <c:pt idx="2">
                    <c:v>7.1998556472595867</c:v>
                  </c:pt>
                  <c:pt idx="3">
                    <c:v>6.7899701289003627</c:v>
                  </c:pt>
                  <c:pt idx="5">
                    <c:v>1.184750092658756</c:v>
                  </c:pt>
                  <c:pt idx="6">
                    <c:v>0.81298800945458316</c:v>
                  </c:pt>
                  <c:pt idx="7">
                    <c:v>1.1516961484069776</c:v>
                  </c:pt>
                  <c:pt idx="8">
                    <c:v>10.737272899526582</c:v>
                  </c:pt>
                  <c:pt idx="10">
                    <c:v>1.5159532026942943</c:v>
                  </c:pt>
                  <c:pt idx="11">
                    <c:v>9.4153045153089945</c:v>
                  </c:pt>
                  <c:pt idx="12">
                    <c:v>4.8540914804918147</c:v>
                  </c:pt>
                  <c:pt idx="13">
                    <c:v>1.76951182565712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4M5-biotin'!$B$4:$C$17</c:f>
              <c:multiLvlStrCache>
                <c:ptCount val="1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</c:lvl>
                <c:lvl>
                  <c:pt idx="0">
                    <c:v>Ab10</c:v>
                  </c:pt>
                  <c:pt idx="5">
                    <c:v>4M5</c:v>
                  </c:pt>
                  <c:pt idx="10">
                    <c:v>M1-E5</c:v>
                  </c:pt>
                </c:lvl>
              </c:multiLvlStrCache>
            </c:multiLvlStrRef>
          </c:cat>
          <c:val>
            <c:numRef>
              <c:f>'4M5-biotin'!$G$4:$G$17</c:f>
              <c:numCache>
                <c:formatCode>General</c:formatCode>
                <c:ptCount val="14"/>
                <c:pt idx="0">
                  <c:v>93.520663627531576</c:v>
                </c:pt>
                <c:pt idx="1">
                  <c:v>91.218892459457436</c:v>
                </c:pt>
                <c:pt idx="2">
                  <c:v>106.6586951647859</c:v>
                </c:pt>
                <c:pt idx="3">
                  <c:v>97.85516777520364</c:v>
                </c:pt>
                <c:pt idx="5">
                  <c:v>12.654705236177227</c:v>
                </c:pt>
                <c:pt idx="6">
                  <c:v>33.291834492859756</c:v>
                </c:pt>
                <c:pt idx="7">
                  <c:v>80.673745880629795</c:v>
                </c:pt>
                <c:pt idx="8">
                  <c:v>97.326986451849152</c:v>
                </c:pt>
                <c:pt idx="10">
                  <c:v>78.379792242732222</c:v>
                </c:pt>
                <c:pt idx="11">
                  <c:v>87.855915103504969</c:v>
                </c:pt>
                <c:pt idx="12">
                  <c:v>90.89006800687541</c:v>
                </c:pt>
                <c:pt idx="13">
                  <c:v>91.0993199312457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E2-4429-A694-346A1B5D18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% of control (no compet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M1-E5-biotin'!$B$2</c:f>
          <c:strCache>
            <c:ptCount val="1"/>
            <c:pt idx="0">
              <c:v>Binding of M1-E5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1-E5-biotin'!$H$4:$H$17</c:f>
                <c:numCache>
                  <c:formatCode>General</c:formatCode>
                  <c:ptCount val="14"/>
                  <c:pt idx="0">
                    <c:v>3.463770774059248</c:v>
                  </c:pt>
                  <c:pt idx="1">
                    <c:v>2.6709155485827849</c:v>
                  </c:pt>
                  <c:pt idx="2">
                    <c:v>3.1596120117044357</c:v>
                  </c:pt>
                  <c:pt idx="3">
                    <c:v>5.6740311341842027</c:v>
                  </c:pt>
                  <c:pt idx="5">
                    <c:v>4.5559445216576391</c:v>
                  </c:pt>
                  <c:pt idx="6">
                    <c:v>8.5898917861428306</c:v>
                  </c:pt>
                  <c:pt idx="7">
                    <c:v>5.5543596949234137</c:v>
                  </c:pt>
                  <c:pt idx="8">
                    <c:v>1.6675962790916223</c:v>
                  </c:pt>
                  <c:pt idx="10">
                    <c:v>0.36135763837270723</c:v>
                  </c:pt>
                  <c:pt idx="11">
                    <c:v>6.5221416941054278</c:v>
                  </c:pt>
                  <c:pt idx="12">
                    <c:v>7.9266670951122471</c:v>
                  </c:pt>
                  <c:pt idx="13">
                    <c:v>11.0294141105257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M1-E5-biotin'!$B$4:$C$17</c:f>
              <c:multiLvlStrCache>
                <c:ptCount val="1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</c:lvl>
                <c:lvl>
                  <c:pt idx="0">
                    <c:v>Ab10</c:v>
                  </c:pt>
                  <c:pt idx="5">
                    <c:v>4M5</c:v>
                  </c:pt>
                  <c:pt idx="10">
                    <c:v>M1-E5</c:v>
                  </c:pt>
                </c:lvl>
              </c:multiLvlStrCache>
            </c:multiLvlStrRef>
          </c:cat>
          <c:val>
            <c:numRef>
              <c:f>'M1-E5-biotin'!$G$4:$G$17</c:f>
              <c:numCache>
                <c:formatCode>General</c:formatCode>
                <c:ptCount val="14"/>
                <c:pt idx="0">
                  <c:v>95.577956000294307</c:v>
                </c:pt>
                <c:pt idx="1">
                  <c:v>101.02273563387534</c:v>
                </c:pt>
                <c:pt idx="2">
                  <c:v>101.74380104480906</c:v>
                </c:pt>
                <c:pt idx="3">
                  <c:v>106.4822308880877</c:v>
                </c:pt>
                <c:pt idx="5">
                  <c:v>98.569665287156013</c:v>
                </c:pt>
                <c:pt idx="6">
                  <c:v>99.165033035649458</c:v>
                </c:pt>
                <c:pt idx="7">
                  <c:v>99.949175923909095</c:v>
                </c:pt>
                <c:pt idx="8">
                  <c:v>100.34124736803891</c:v>
                </c:pt>
                <c:pt idx="10">
                  <c:v>7.5049665219630626</c:v>
                </c:pt>
                <c:pt idx="11">
                  <c:v>54.006327716871454</c:v>
                </c:pt>
                <c:pt idx="12">
                  <c:v>113.06011331027884</c:v>
                </c:pt>
                <c:pt idx="13">
                  <c:v>104.304319034655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F1-46A1-AFE8-2AE3AFAFF4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% of control (no compet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No.22-biotin'!$B$2</c:f>
          <c:strCache>
            <c:ptCount val="1"/>
            <c:pt idx="0">
              <c:v>Binding of No.22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o.22-biotin'!$H$4:$H$17</c:f>
                <c:numCache>
                  <c:formatCode>General</c:formatCode>
                  <c:ptCount val="14"/>
                  <c:pt idx="0">
                    <c:v>1.1543474235555735</c:v>
                  </c:pt>
                  <c:pt idx="1">
                    <c:v>3.82583827723596</c:v>
                  </c:pt>
                  <c:pt idx="2">
                    <c:v>5.98379690165679</c:v>
                  </c:pt>
                  <c:pt idx="3">
                    <c:v>2.9378970101718691</c:v>
                  </c:pt>
                  <c:pt idx="5">
                    <c:v>4.4504608402659969</c:v>
                  </c:pt>
                  <c:pt idx="6">
                    <c:v>4.5033929136090656</c:v>
                  </c:pt>
                  <c:pt idx="7">
                    <c:v>3.8653110820473513</c:v>
                  </c:pt>
                  <c:pt idx="8">
                    <c:v>5.8966799423367737</c:v>
                  </c:pt>
                  <c:pt idx="10">
                    <c:v>6.776041734793985</c:v>
                  </c:pt>
                  <c:pt idx="11">
                    <c:v>1.5679470842589147</c:v>
                  </c:pt>
                  <c:pt idx="12">
                    <c:v>8.6809599041159657</c:v>
                  </c:pt>
                  <c:pt idx="13">
                    <c:v>2.92344598519319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o.22-biotin'!$B$4:$C$17</c:f>
              <c:multiLvlStrCache>
                <c:ptCount val="1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</c:lvl>
                <c:lvl>
                  <c:pt idx="0">
                    <c:v>No.22</c:v>
                  </c:pt>
                  <c:pt idx="5">
                    <c:v>C6C1</c:v>
                  </c:pt>
                  <c:pt idx="10">
                    <c:v>Ab3</c:v>
                  </c:pt>
                </c:lvl>
              </c:multiLvlStrCache>
            </c:multiLvlStrRef>
          </c:cat>
          <c:val>
            <c:numRef>
              <c:f>'No.22-biotin'!$G$4:$G$17</c:f>
              <c:numCache>
                <c:formatCode>General</c:formatCode>
                <c:ptCount val="14"/>
                <c:pt idx="0">
                  <c:v>30.134665876175152</c:v>
                </c:pt>
                <c:pt idx="1">
                  <c:v>78.207842805115618</c:v>
                </c:pt>
                <c:pt idx="2">
                  <c:v>96.214110273566533</c:v>
                </c:pt>
                <c:pt idx="3">
                  <c:v>107.19064961463539</c:v>
                </c:pt>
                <c:pt idx="5">
                  <c:v>96.540713145290042</c:v>
                </c:pt>
                <c:pt idx="6">
                  <c:v>97.516409437644128</c:v>
                </c:pt>
                <c:pt idx="7">
                  <c:v>100.85151676423629</c:v>
                </c:pt>
                <c:pt idx="8">
                  <c:v>114.13872627284017</c:v>
                </c:pt>
                <c:pt idx="10">
                  <c:v>101.19068162208801</c:v>
                </c:pt>
                <c:pt idx="11">
                  <c:v>102.69197584124244</c:v>
                </c:pt>
                <c:pt idx="12">
                  <c:v>99.654874892148413</c:v>
                </c:pt>
                <c:pt idx="13">
                  <c:v>99.2407247627264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67-45A1-9BEC-E8EC666746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% of control (no compet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C6C1-biotin'!$B$2</c:f>
          <c:strCache>
            <c:ptCount val="1"/>
            <c:pt idx="0">
              <c:v>Binding of C6C1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6C1-biotin'!$H$4:$H$17</c:f>
                <c:numCache>
                  <c:formatCode>General</c:formatCode>
                  <c:ptCount val="14"/>
                  <c:pt idx="0">
                    <c:v>5.7507235662867897</c:v>
                  </c:pt>
                  <c:pt idx="1">
                    <c:v>3.1335270709392495</c:v>
                  </c:pt>
                  <c:pt idx="2">
                    <c:v>2.2350664445972601</c:v>
                  </c:pt>
                  <c:pt idx="3">
                    <c:v>1.9939863902516177</c:v>
                  </c:pt>
                  <c:pt idx="5">
                    <c:v>1.3191116305855177</c:v>
                  </c:pt>
                  <c:pt idx="6">
                    <c:v>2.2808188921280537</c:v>
                  </c:pt>
                  <c:pt idx="7">
                    <c:v>3.0333821785973432</c:v>
                  </c:pt>
                  <c:pt idx="8">
                    <c:v>6.3216631336080349</c:v>
                  </c:pt>
                  <c:pt idx="10">
                    <c:v>7.56997546170511</c:v>
                  </c:pt>
                  <c:pt idx="11">
                    <c:v>7.9055010226440636</c:v>
                  </c:pt>
                  <c:pt idx="12">
                    <c:v>2.0781702131869375</c:v>
                  </c:pt>
                  <c:pt idx="13">
                    <c:v>2.74321578776157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C6C1-biotin'!$B$4:$C$17</c:f>
              <c:multiLvlStrCache>
                <c:ptCount val="1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</c:lvl>
                <c:lvl>
                  <c:pt idx="0">
                    <c:v>No.22</c:v>
                  </c:pt>
                  <c:pt idx="5">
                    <c:v>C6C1</c:v>
                  </c:pt>
                  <c:pt idx="10">
                    <c:v>Ab3</c:v>
                  </c:pt>
                </c:lvl>
              </c:multiLvlStrCache>
            </c:multiLvlStrRef>
          </c:cat>
          <c:val>
            <c:numRef>
              <c:f>'C6C1-biotin'!$G$4:$G$17</c:f>
              <c:numCache>
                <c:formatCode>General</c:formatCode>
                <c:ptCount val="14"/>
                <c:pt idx="0">
                  <c:v>99.825921823073273</c:v>
                </c:pt>
                <c:pt idx="1">
                  <c:v>96.787466371261289</c:v>
                </c:pt>
                <c:pt idx="2">
                  <c:v>103.29166007279633</c:v>
                </c:pt>
                <c:pt idx="3">
                  <c:v>100.22155404336131</c:v>
                </c:pt>
                <c:pt idx="5">
                  <c:v>12.438677005855359</c:v>
                </c:pt>
                <c:pt idx="6">
                  <c:v>39.167589808514009</c:v>
                </c:pt>
                <c:pt idx="7">
                  <c:v>99.050482671308757</c:v>
                </c:pt>
                <c:pt idx="8">
                  <c:v>115.4296565912328</c:v>
                </c:pt>
                <c:pt idx="10">
                  <c:v>94.712286158631414</c:v>
                </c:pt>
                <c:pt idx="11">
                  <c:v>101.30637636080873</c:v>
                </c:pt>
                <c:pt idx="12">
                  <c:v>92.612752721617426</c:v>
                </c:pt>
                <c:pt idx="13">
                  <c:v>101.897356143079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6A-453D-813A-79ADB42ABC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% of control (no compet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Ab3-biotin'!$B$2</c:f>
          <c:strCache>
            <c:ptCount val="1"/>
            <c:pt idx="0">
              <c:v>Binding of Ab3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b3-biotin'!$H$4:$H$17</c:f>
                <c:numCache>
                  <c:formatCode>General</c:formatCode>
                  <c:ptCount val="14"/>
                  <c:pt idx="0">
                    <c:v>1.0489657598892601</c:v>
                  </c:pt>
                  <c:pt idx="1">
                    <c:v>1.377248737189027</c:v>
                  </c:pt>
                  <c:pt idx="2">
                    <c:v>2.8129581416763747</c:v>
                  </c:pt>
                  <c:pt idx="3">
                    <c:v>1.994122540130626</c:v>
                  </c:pt>
                  <c:pt idx="5">
                    <c:v>6.4651147787026044</c:v>
                  </c:pt>
                  <c:pt idx="6">
                    <c:v>6.1857771487280067</c:v>
                  </c:pt>
                  <c:pt idx="7">
                    <c:v>3.58526392288206</c:v>
                  </c:pt>
                  <c:pt idx="8">
                    <c:v>5.9147766664335562</c:v>
                  </c:pt>
                  <c:pt idx="10">
                    <c:v>2.2698873277185072</c:v>
                  </c:pt>
                  <c:pt idx="11">
                    <c:v>4.9140117879259275</c:v>
                  </c:pt>
                  <c:pt idx="12">
                    <c:v>9.0595621321094306</c:v>
                  </c:pt>
                  <c:pt idx="13">
                    <c:v>5.72366931132648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Ab3-biotin'!$B$4:$C$17</c:f>
              <c:multiLvlStrCache>
                <c:ptCount val="1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</c:lvl>
                <c:lvl>
                  <c:pt idx="0">
                    <c:v>No.22</c:v>
                  </c:pt>
                  <c:pt idx="5">
                    <c:v>C6C1</c:v>
                  </c:pt>
                  <c:pt idx="10">
                    <c:v>Ab3</c:v>
                  </c:pt>
                </c:lvl>
              </c:multiLvlStrCache>
            </c:multiLvlStrRef>
          </c:cat>
          <c:val>
            <c:numRef>
              <c:f>'Ab3-biotin'!$G$4:$G$17</c:f>
              <c:numCache>
                <c:formatCode>General</c:formatCode>
                <c:ptCount val="14"/>
                <c:pt idx="0">
                  <c:v>119.38082737394768</c:v>
                </c:pt>
                <c:pt idx="1">
                  <c:v>117.31691862043992</c:v>
                </c:pt>
                <c:pt idx="2">
                  <c:v>119.83343894269937</c:v>
                </c:pt>
                <c:pt idx="3">
                  <c:v>110.85362541866569</c:v>
                </c:pt>
                <c:pt idx="5">
                  <c:v>96.665604080331548</c:v>
                </c:pt>
                <c:pt idx="6">
                  <c:v>92.343002868983135</c:v>
                </c:pt>
                <c:pt idx="7">
                  <c:v>94.727446605036675</c:v>
                </c:pt>
                <c:pt idx="8">
                  <c:v>101.63850812878547</c:v>
                </c:pt>
                <c:pt idx="10">
                  <c:v>38.325566447051266</c:v>
                </c:pt>
                <c:pt idx="11">
                  <c:v>97.493170496545076</c:v>
                </c:pt>
                <c:pt idx="12">
                  <c:v>119.12260967379079</c:v>
                </c:pt>
                <c:pt idx="13">
                  <c:v>120.600996304033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A1-4F7B-B1BB-8BE7BF506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% of control (no competitor)</a:t>
                </a:r>
              </a:p>
            </c:rich>
          </c:tx>
          <c:layout>
            <c:manualLayout>
              <c:xMode val="edge"/>
              <c:yMode val="edge"/>
              <c:x val="3.1358024691358025E-2"/>
              <c:y val="0.191961507936507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Ab10-biotin'!$B$2</c:f>
          <c:strCache>
            <c:ptCount val="1"/>
            <c:pt idx="0">
              <c:v>Binding of Ab10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b10-biotin'!$H$19:$H$52</c:f>
                <c:numCache>
                  <c:formatCode>General</c:formatCode>
                  <c:ptCount val="34"/>
                  <c:pt idx="0">
                    <c:v>1.4684422492290796</c:v>
                  </c:pt>
                  <c:pt idx="1">
                    <c:v>3.2039079433686002</c:v>
                  </c:pt>
                  <c:pt idx="2">
                    <c:v>3.6522379018044688</c:v>
                  </c:pt>
                  <c:pt idx="3">
                    <c:v>2.4123767614393192</c:v>
                  </c:pt>
                  <c:pt idx="5">
                    <c:v>2.7149878655770374</c:v>
                  </c:pt>
                  <c:pt idx="6">
                    <c:v>4.0257920649702497</c:v>
                  </c:pt>
                  <c:pt idx="7">
                    <c:v>2.270025858898745</c:v>
                  </c:pt>
                  <c:pt idx="8">
                    <c:v>2.4647098881213236</c:v>
                  </c:pt>
                  <c:pt idx="10">
                    <c:v>1.8222183719715803</c:v>
                  </c:pt>
                  <c:pt idx="11">
                    <c:v>4.4540333530134397</c:v>
                  </c:pt>
                  <c:pt idx="12">
                    <c:v>2.9713818115575892</c:v>
                  </c:pt>
                  <c:pt idx="13">
                    <c:v>3.4179789713887692</c:v>
                  </c:pt>
                  <c:pt idx="15">
                    <c:v>2.4825255112086015</c:v>
                  </c:pt>
                  <c:pt idx="16">
                    <c:v>0.80888988057521582</c:v>
                  </c:pt>
                  <c:pt idx="17">
                    <c:v>4.5172781636148178</c:v>
                  </c:pt>
                  <c:pt idx="18">
                    <c:v>7.3095017043918373</c:v>
                  </c:pt>
                  <c:pt idx="20">
                    <c:v>1.4194838735957567</c:v>
                  </c:pt>
                  <c:pt idx="21">
                    <c:v>1.7937814899682079</c:v>
                  </c:pt>
                  <c:pt idx="22">
                    <c:v>2.3673007827909904</c:v>
                  </c:pt>
                  <c:pt idx="23">
                    <c:v>4.9793919274490914</c:v>
                  </c:pt>
                  <c:pt idx="25">
                    <c:v>4.7953866843559885</c:v>
                  </c:pt>
                  <c:pt idx="26">
                    <c:v>4.3035620679135533</c:v>
                  </c:pt>
                  <c:pt idx="27">
                    <c:v>3.3065732962242653</c:v>
                  </c:pt>
                  <c:pt idx="28">
                    <c:v>3.6230213113057186</c:v>
                  </c:pt>
                  <c:pt idx="30">
                    <c:v>0.77290382850842965</c:v>
                  </c:pt>
                  <c:pt idx="31">
                    <c:v>3.2112545056755035</c:v>
                  </c:pt>
                  <c:pt idx="32">
                    <c:v>1.9549335364577307</c:v>
                  </c:pt>
                  <c:pt idx="33">
                    <c:v>4.13069916866534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Ab10-biotin'!$B$19:$C$52</c:f>
              <c:multiLvlStrCache>
                <c:ptCount val="3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  <c:pt idx="30">
                    <c:v>4</c:v>
                  </c:pt>
                  <c:pt idx="31">
                    <c:v>1</c:v>
                  </c:pt>
                  <c:pt idx="32">
                    <c:v>0.25</c:v>
                  </c:pt>
                  <c:pt idx="33">
                    <c:v>0.0625</c:v>
                  </c:pt>
                </c:lvl>
                <c:lvl>
                  <c:pt idx="0">
                    <c:v>No.2</c:v>
                  </c:pt>
                  <c:pt idx="5">
                    <c:v>No.4</c:v>
                  </c:pt>
                  <c:pt idx="10">
                    <c:v>No.5</c:v>
                  </c:pt>
                  <c:pt idx="15">
                    <c:v>No.11</c:v>
                  </c:pt>
                  <c:pt idx="20">
                    <c:v>4M2</c:v>
                  </c:pt>
                  <c:pt idx="25">
                    <c:v>4M3</c:v>
                  </c:pt>
                  <c:pt idx="30">
                    <c:v>4M6</c:v>
                  </c:pt>
                </c:lvl>
              </c:multiLvlStrCache>
            </c:multiLvlStrRef>
          </c:cat>
          <c:val>
            <c:numRef>
              <c:f>'Ab10-biotin'!$G$19:$G$52</c:f>
              <c:numCache>
                <c:formatCode>General</c:formatCode>
                <c:ptCount val="34"/>
                <c:pt idx="0">
                  <c:v>88.587344665047837</c:v>
                </c:pt>
                <c:pt idx="1">
                  <c:v>94.800742751035557</c:v>
                </c:pt>
                <c:pt idx="2">
                  <c:v>97.714612198257385</c:v>
                </c:pt>
                <c:pt idx="3">
                  <c:v>97.32895300671332</c:v>
                </c:pt>
                <c:pt idx="5">
                  <c:v>79.17440365662047</c:v>
                </c:pt>
                <c:pt idx="6">
                  <c:v>88.987287530352816</c:v>
                </c:pt>
                <c:pt idx="7">
                  <c:v>92.358234537923167</c:v>
                </c:pt>
                <c:pt idx="8">
                  <c:v>90.429938580202816</c:v>
                </c:pt>
                <c:pt idx="10">
                  <c:v>84.687901728324519</c:v>
                </c:pt>
                <c:pt idx="11">
                  <c:v>94.143693758034559</c:v>
                </c:pt>
                <c:pt idx="12">
                  <c:v>96.571918297386063</c:v>
                </c:pt>
                <c:pt idx="13">
                  <c:v>95.500642765319242</c:v>
                </c:pt>
                <c:pt idx="15">
                  <c:v>87.616054849307247</c:v>
                </c:pt>
                <c:pt idx="16">
                  <c:v>92.072561062705333</c:v>
                </c:pt>
                <c:pt idx="17">
                  <c:v>99.542922439651463</c:v>
                </c:pt>
                <c:pt idx="18">
                  <c:v>97.643193829452926</c:v>
                </c:pt>
                <c:pt idx="20">
                  <c:v>109.6700471361234</c:v>
                </c:pt>
                <c:pt idx="21">
                  <c:v>109.45579202971004</c:v>
                </c:pt>
                <c:pt idx="22">
                  <c:v>112.26967576060561</c:v>
                </c:pt>
                <c:pt idx="23">
                  <c:v>120.1971146979003</c:v>
                </c:pt>
                <c:pt idx="25">
                  <c:v>83.747645951035778</c:v>
                </c:pt>
                <c:pt idx="26">
                  <c:v>82.523540489642201</c:v>
                </c:pt>
                <c:pt idx="27">
                  <c:v>87.438794726930325</c:v>
                </c:pt>
                <c:pt idx="28">
                  <c:v>92.580037664783447</c:v>
                </c:pt>
                <c:pt idx="30">
                  <c:v>89.744322239680045</c:v>
                </c:pt>
                <c:pt idx="31">
                  <c:v>93.20097128981574</c:v>
                </c:pt>
                <c:pt idx="32">
                  <c:v>99.942865304956442</c:v>
                </c:pt>
                <c:pt idx="33">
                  <c:v>110.56991858305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01-4010-83D6-486327EBF3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10</c:f>
          <c:strCache>
            <c:ptCount val="1"/>
            <c:pt idx="0">
              <c:v>No.5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11:$H$11</c:f>
                <c:numCache>
                  <c:formatCode>General</c:formatCode>
                  <c:ptCount val="4"/>
                  <c:pt idx="0">
                    <c:v>27.926863259460433</c:v>
                  </c:pt>
                  <c:pt idx="1">
                    <c:v>7.1448072811868117</c:v>
                  </c:pt>
                  <c:pt idx="2">
                    <c:v>6.9534886435246843</c:v>
                  </c:pt>
                  <c:pt idx="3">
                    <c:v>11.6173679141584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10:$H$10</c:f>
              <c:numCache>
                <c:formatCode>General</c:formatCode>
                <c:ptCount val="4"/>
                <c:pt idx="0">
                  <c:v>103.64963503649635</c:v>
                </c:pt>
                <c:pt idx="1">
                  <c:v>106.93430656934306</c:v>
                </c:pt>
                <c:pt idx="2">
                  <c:v>129.01459854014598</c:v>
                </c:pt>
                <c:pt idx="3">
                  <c:v>103.832116788321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35-47BB-AAD0-1EF80A62D3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Ab10-biotin'!$B$2</c:f>
          <c:strCache>
            <c:ptCount val="1"/>
            <c:pt idx="0">
              <c:v>Binding of Ab10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b10-biotin'!$H$54:$H$82</c:f>
                <c:numCache>
                  <c:formatCode>General</c:formatCode>
                  <c:ptCount val="29"/>
                  <c:pt idx="0">
                    <c:v>3.2362866846885709</c:v>
                  </c:pt>
                  <c:pt idx="1">
                    <c:v>3.6848484265980757</c:v>
                  </c:pt>
                  <c:pt idx="2">
                    <c:v>1.0641969448505024</c:v>
                  </c:pt>
                  <c:pt idx="3">
                    <c:v>0.6260938526983244</c:v>
                  </c:pt>
                  <c:pt idx="5">
                    <c:v>3.5494403225636328</c:v>
                  </c:pt>
                  <c:pt idx="6">
                    <c:v>4.5043853755373711</c:v>
                  </c:pt>
                  <c:pt idx="7">
                    <c:v>3.8789525055264682</c:v>
                  </c:pt>
                  <c:pt idx="8">
                    <c:v>4.1120366498942991</c:v>
                  </c:pt>
                  <c:pt idx="10">
                    <c:v>26.636668992639425</c:v>
                  </c:pt>
                  <c:pt idx="11">
                    <c:v>10.722153683810452</c:v>
                  </c:pt>
                  <c:pt idx="12">
                    <c:v>10.283710713840382</c:v>
                  </c:pt>
                  <c:pt idx="13">
                    <c:v>2.3598011306750988</c:v>
                  </c:pt>
                  <c:pt idx="15">
                    <c:v>3.7838187165638266</c:v>
                  </c:pt>
                  <c:pt idx="16">
                    <c:v>5.0476638113121091</c:v>
                  </c:pt>
                  <c:pt idx="17">
                    <c:v>8.7403044312824356</c:v>
                  </c:pt>
                  <c:pt idx="18">
                    <c:v>8.9236251265627509</c:v>
                  </c:pt>
                  <c:pt idx="20">
                    <c:v>11.196350947021998</c:v>
                  </c:pt>
                  <c:pt idx="21">
                    <c:v>9.1906088268459705</c:v>
                  </c:pt>
                  <c:pt idx="22">
                    <c:v>10.266172057769683</c:v>
                  </c:pt>
                  <c:pt idx="23">
                    <c:v>6.8882726382609238</c:v>
                  </c:pt>
                  <c:pt idx="25">
                    <c:v>4.2309341043829072</c:v>
                  </c:pt>
                  <c:pt idx="26">
                    <c:v>0.35334638542609603</c:v>
                  </c:pt>
                  <c:pt idx="27">
                    <c:v>3.4634439415590692</c:v>
                  </c:pt>
                  <c:pt idx="28">
                    <c:v>2.9217765637714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Ab10-biotin'!$B$54:$C$82</c:f>
              <c:multiLvlStrCache>
                <c:ptCount val="29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</c:lvl>
                <c:lvl>
                  <c:pt idx="0">
                    <c:v>4M7</c:v>
                  </c:pt>
                  <c:pt idx="5">
                    <c:v>4M8</c:v>
                  </c:pt>
                  <c:pt idx="10">
                    <c:v>M1-B8</c:v>
                  </c:pt>
                  <c:pt idx="15">
                    <c:v>M1-D1</c:v>
                  </c:pt>
                  <c:pt idx="20">
                    <c:v>M1-E1</c:v>
                  </c:pt>
                  <c:pt idx="25">
                    <c:v>MAb4-5</c:v>
                  </c:pt>
                </c:lvl>
              </c:multiLvlStrCache>
            </c:multiLvlStrRef>
          </c:cat>
          <c:val>
            <c:numRef>
              <c:f>'Ab10-biotin'!$G$54:$G$82</c:f>
              <c:numCache>
                <c:formatCode>General</c:formatCode>
                <c:ptCount val="29"/>
                <c:pt idx="0">
                  <c:v>104.14414414414416</c:v>
                </c:pt>
                <c:pt idx="1">
                  <c:v>101.03194103194106</c:v>
                </c:pt>
                <c:pt idx="2">
                  <c:v>97.690417690417704</c:v>
                </c:pt>
                <c:pt idx="3">
                  <c:v>101.90008190008193</c:v>
                </c:pt>
                <c:pt idx="5">
                  <c:v>86.076986076986088</c:v>
                </c:pt>
                <c:pt idx="6">
                  <c:v>85.37264537264538</c:v>
                </c:pt>
                <c:pt idx="7">
                  <c:v>82.113022113022126</c:v>
                </c:pt>
                <c:pt idx="8">
                  <c:v>86.502866502866524</c:v>
                </c:pt>
                <c:pt idx="10">
                  <c:v>89.910655916321659</c:v>
                </c:pt>
                <c:pt idx="11">
                  <c:v>99.782087600784507</c:v>
                </c:pt>
                <c:pt idx="12">
                  <c:v>104.38003922423188</c:v>
                </c:pt>
                <c:pt idx="13">
                  <c:v>107.53976901285687</c:v>
                </c:pt>
                <c:pt idx="15">
                  <c:v>110.93603744149766</c:v>
                </c:pt>
                <c:pt idx="16">
                  <c:v>120.98283931357254</c:v>
                </c:pt>
                <c:pt idx="17">
                  <c:v>136.00624024960999</c:v>
                </c:pt>
                <c:pt idx="18">
                  <c:v>135.56942277691107</c:v>
                </c:pt>
                <c:pt idx="20">
                  <c:v>110.65591632163871</c:v>
                </c:pt>
                <c:pt idx="21">
                  <c:v>108.76007844846372</c:v>
                </c:pt>
                <c:pt idx="22">
                  <c:v>114.99237306602747</c:v>
                </c:pt>
                <c:pt idx="23">
                  <c:v>106.40662453693615</c:v>
                </c:pt>
                <c:pt idx="25">
                  <c:v>108.26833073322932</c:v>
                </c:pt>
                <c:pt idx="26">
                  <c:v>103.43213728549141</c:v>
                </c:pt>
                <c:pt idx="27">
                  <c:v>96.006240249610002</c:v>
                </c:pt>
                <c:pt idx="28">
                  <c:v>98.6271450858034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E6-43DD-B387-6AE3A34FBA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4M5-biotin'!$B$2</c:f>
          <c:strCache>
            <c:ptCount val="1"/>
            <c:pt idx="0">
              <c:v>Binding of 4M5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4M5-biotin'!$H$19:$H$52</c:f>
                <c:numCache>
                  <c:formatCode>General</c:formatCode>
                  <c:ptCount val="34"/>
                  <c:pt idx="0">
                    <c:v>3.2100842761360275</c:v>
                  </c:pt>
                  <c:pt idx="1">
                    <c:v>1.2223077871538308</c:v>
                  </c:pt>
                  <c:pt idx="2">
                    <c:v>3.7717647686637963</c:v>
                  </c:pt>
                  <c:pt idx="3">
                    <c:v>2.5217929823201715</c:v>
                  </c:pt>
                  <c:pt idx="5">
                    <c:v>2.154101519478397</c:v>
                  </c:pt>
                  <c:pt idx="6">
                    <c:v>3.6851051526838776</c:v>
                  </c:pt>
                  <c:pt idx="7">
                    <c:v>1.2638947123650266</c:v>
                  </c:pt>
                  <c:pt idx="8">
                    <c:v>1.2781305000026026</c:v>
                  </c:pt>
                  <c:pt idx="10">
                    <c:v>4.0856925221343072</c:v>
                  </c:pt>
                  <c:pt idx="11">
                    <c:v>3.8502486700014309</c:v>
                  </c:pt>
                  <c:pt idx="12">
                    <c:v>1.3179571663921104</c:v>
                  </c:pt>
                  <c:pt idx="13">
                    <c:v>2.8469831821799771</c:v>
                  </c:pt>
                  <c:pt idx="15">
                    <c:v>4.9530865231088281</c:v>
                  </c:pt>
                  <c:pt idx="16">
                    <c:v>3.890700383422927</c:v>
                  </c:pt>
                  <c:pt idx="17">
                    <c:v>1.6205540232117794</c:v>
                  </c:pt>
                  <c:pt idx="18">
                    <c:v>1.6232860634034787</c:v>
                  </c:pt>
                  <c:pt idx="20">
                    <c:v>1.2615689070757279</c:v>
                  </c:pt>
                  <c:pt idx="21">
                    <c:v>1.6697180519956021</c:v>
                  </c:pt>
                  <c:pt idx="22">
                    <c:v>1.5714291974146566</c:v>
                  </c:pt>
                  <c:pt idx="23">
                    <c:v>2.934122772575007</c:v>
                  </c:pt>
                  <c:pt idx="25">
                    <c:v>1.619432031306921</c:v>
                  </c:pt>
                  <c:pt idx="26">
                    <c:v>1.6652796141884956</c:v>
                  </c:pt>
                  <c:pt idx="27">
                    <c:v>1.3445432852603441</c:v>
                  </c:pt>
                  <c:pt idx="28">
                    <c:v>3.4292870990281017</c:v>
                  </c:pt>
                  <c:pt idx="30">
                    <c:v>1.1037589179418938</c:v>
                  </c:pt>
                  <c:pt idx="31">
                    <c:v>1.5677389476304298</c:v>
                  </c:pt>
                  <c:pt idx="32">
                    <c:v>2.377634435761617</c:v>
                  </c:pt>
                  <c:pt idx="33">
                    <c:v>4.71694889209331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4M5-biotin'!$B$19:$C$52</c:f>
              <c:multiLvlStrCache>
                <c:ptCount val="3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  <c:pt idx="30">
                    <c:v>4</c:v>
                  </c:pt>
                  <c:pt idx="31">
                    <c:v>1</c:v>
                  </c:pt>
                  <c:pt idx="32">
                    <c:v>0.25</c:v>
                  </c:pt>
                  <c:pt idx="33">
                    <c:v>0.0625</c:v>
                  </c:pt>
                </c:lvl>
                <c:lvl>
                  <c:pt idx="0">
                    <c:v>No.2</c:v>
                  </c:pt>
                  <c:pt idx="5">
                    <c:v>No.4</c:v>
                  </c:pt>
                  <c:pt idx="10">
                    <c:v>No.5</c:v>
                  </c:pt>
                  <c:pt idx="15">
                    <c:v>No.11</c:v>
                  </c:pt>
                  <c:pt idx="20">
                    <c:v>4M2</c:v>
                  </c:pt>
                  <c:pt idx="25">
                    <c:v>4M3</c:v>
                  </c:pt>
                  <c:pt idx="30">
                    <c:v>4M6</c:v>
                  </c:pt>
                </c:lvl>
              </c:multiLvlStrCache>
            </c:multiLvlStrRef>
          </c:cat>
          <c:val>
            <c:numRef>
              <c:f>'4M5-biotin'!$G$19:$G$52</c:f>
              <c:numCache>
                <c:formatCode>General</c:formatCode>
                <c:ptCount val="34"/>
                <c:pt idx="0">
                  <c:v>87.126382678277253</c:v>
                </c:pt>
                <c:pt idx="1">
                  <c:v>88.522789676002205</c:v>
                </c:pt>
                <c:pt idx="2">
                  <c:v>88.538479642268783</c:v>
                </c:pt>
                <c:pt idx="3">
                  <c:v>89.730917078528293</c:v>
                </c:pt>
                <c:pt idx="5">
                  <c:v>79.391229308856992</c:v>
                </c:pt>
                <c:pt idx="6">
                  <c:v>85.871185376951459</c:v>
                </c:pt>
                <c:pt idx="7">
                  <c:v>97.575900211814542</c:v>
                </c:pt>
                <c:pt idx="8">
                  <c:v>101.23166235192595</c:v>
                </c:pt>
                <c:pt idx="10">
                  <c:v>96.901231662351918</c:v>
                </c:pt>
                <c:pt idx="11">
                  <c:v>97.152271122617094</c:v>
                </c:pt>
                <c:pt idx="12">
                  <c:v>104.54224523417275</c:v>
                </c:pt>
                <c:pt idx="13">
                  <c:v>105.93865223189771</c:v>
                </c:pt>
                <c:pt idx="15">
                  <c:v>80.771946340315381</c:v>
                </c:pt>
                <c:pt idx="16">
                  <c:v>82.121283439240614</c:v>
                </c:pt>
                <c:pt idx="17">
                  <c:v>82.152663371773755</c:v>
                </c:pt>
                <c:pt idx="18">
                  <c:v>85.96532517455087</c:v>
                </c:pt>
                <c:pt idx="20">
                  <c:v>80.205053094104713</c:v>
                </c:pt>
                <c:pt idx="21">
                  <c:v>84.979860856828992</c:v>
                </c:pt>
                <c:pt idx="22">
                  <c:v>86.254119370194061</c:v>
                </c:pt>
                <c:pt idx="23">
                  <c:v>85.067740754302449</c:v>
                </c:pt>
                <c:pt idx="25">
                  <c:v>51.439033321127795</c:v>
                </c:pt>
                <c:pt idx="26">
                  <c:v>67.125595020139144</c:v>
                </c:pt>
                <c:pt idx="27">
                  <c:v>80.556572683998525</c:v>
                </c:pt>
                <c:pt idx="28">
                  <c:v>86.122299523983884</c:v>
                </c:pt>
                <c:pt idx="30">
                  <c:v>14.632002929329916</c:v>
                </c:pt>
                <c:pt idx="31">
                  <c:v>54.529476382277551</c:v>
                </c:pt>
                <c:pt idx="32">
                  <c:v>81.157085316733799</c:v>
                </c:pt>
                <c:pt idx="33">
                  <c:v>82.255584035151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975-4100-8408-615A2CA1CA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4M5-biotin'!$B$2</c:f>
          <c:strCache>
            <c:ptCount val="1"/>
            <c:pt idx="0">
              <c:v>Binding of 4M5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4M5-biotin'!$H$54:$H$82</c:f>
                <c:numCache>
                  <c:formatCode>General</c:formatCode>
                  <c:ptCount val="29"/>
                  <c:pt idx="0">
                    <c:v>3.7604827116621924</c:v>
                  </c:pt>
                  <c:pt idx="1">
                    <c:v>2.3739774721476516</c:v>
                  </c:pt>
                  <c:pt idx="2">
                    <c:v>1.7799747287173171</c:v>
                  </c:pt>
                  <c:pt idx="3">
                    <c:v>2.3666465926611928</c:v>
                  </c:pt>
                  <c:pt idx="5">
                    <c:v>0.22427956861242687</c:v>
                  </c:pt>
                  <c:pt idx="6">
                    <c:v>0.60090902283517111</c:v>
                  </c:pt>
                  <c:pt idx="7">
                    <c:v>1.9739696562071172</c:v>
                  </c:pt>
                  <c:pt idx="8">
                    <c:v>5.132127418189345</c:v>
                  </c:pt>
                  <c:pt idx="10">
                    <c:v>8.9287295027926366</c:v>
                  </c:pt>
                  <c:pt idx="11">
                    <c:v>0.10666621129233909</c:v>
                  </c:pt>
                  <c:pt idx="12">
                    <c:v>2.1754347421585583</c:v>
                  </c:pt>
                  <c:pt idx="13">
                    <c:v>6.6047427176469027</c:v>
                  </c:pt>
                  <c:pt idx="15">
                    <c:v>3.9210763171454901</c:v>
                  </c:pt>
                  <c:pt idx="16">
                    <c:v>3.6874823396439638</c:v>
                  </c:pt>
                  <c:pt idx="17">
                    <c:v>2.1638426450399586</c:v>
                  </c:pt>
                  <c:pt idx="18">
                    <c:v>4.9971006453312832</c:v>
                  </c:pt>
                  <c:pt idx="20">
                    <c:v>1.4628557785656775</c:v>
                  </c:pt>
                  <c:pt idx="21">
                    <c:v>1.3728077128113068</c:v>
                  </c:pt>
                  <c:pt idx="22">
                    <c:v>1.59186190970113</c:v>
                  </c:pt>
                  <c:pt idx="23">
                    <c:v>3.8142746254785287</c:v>
                  </c:pt>
                  <c:pt idx="25">
                    <c:v>6.5278859758698102</c:v>
                  </c:pt>
                  <c:pt idx="26">
                    <c:v>3.7441371646590635</c:v>
                  </c:pt>
                  <c:pt idx="27">
                    <c:v>4.8779189344159573</c:v>
                  </c:pt>
                  <c:pt idx="28">
                    <c:v>4.57782354553725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4M5-biotin'!$B$54:$C$82</c:f>
              <c:multiLvlStrCache>
                <c:ptCount val="29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</c:lvl>
                <c:lvl>
                  <c:pt idx="0">
                    <c:v>4M7</c:v>
                  </c:pt>
                  <c:pt idx="5">
                    <c:v>4M8</c:v>
                  </c:pt>
                  <c:pt idx="10">
                    <c:v>M1-B8</c:v>
                  </c:pt>
                  <c:pt idx="15">
                    <c:v>M1-D1</c:v>
                  </c:pt>
                  <c:pt idx="20">
                    <c:v>M1-E1</c:v>
                  </c:pt>
                  <c:pt idx="25">
                    <c:v>MAb4-5</c:v>
                  </c:pt>
                </c:lvl>
              </c:multiLvlStrCache>
            </c:multiLvlStrRef>
          </c:cat>
          <c:val>
            <c:numRef>
              <c:f>'4M5-biotin'!$G$54:$G$82</c:f>
              <c:numCache>
                <c:formatCode>General</c:formatCode>
                <c:ptCount val="29"/>
                <c:pt idx="0">
                  <c:v>81.435371658733061</c:v>
                </c:pt>
                <c:pt idx="1">
                  <c:v>82.475283778835589</c:v>
                </c:pt>
                <c:pt idx="2">
                  <c:v>86.605638960087887</c:v>
                </c:pt>
                <c:pt idx="3">
                  <c:v>87.132918344928598</c:v>
                </c:pt>
                <c:pt idx="5">
                  <c:v>10.935292455495899</c:v>
                </c:pt>
                <c:pt idx="6">
                  <c:v>20.090421022887817</c:v>
                </c:pt>
                <c:pt idx="7">
                  <c:v>56.838089855891489</c:v>
                </c:pt>
                <c:pt idx="8">
                  <c:v>92.130545351794282</c:v>
                </c:pt>
                <c:pt idx="10">
                  <c:v>92.865216162757818</c:v>
                </c:pt>
                <c:pt idx="11">
                  <c:v>120.30234529528111</c:v>
                </c:pt>
                <c:pt idx="12">
                  <c:v>100.05651313930487</c:v>
                </c:pt>
                <c:pt idx="13">
                  <c:v>96.439672223792016</c:v>
                </c:pt>
                <c:pt idx="15">
                  <c:v>71.771686917208243</c:v>
                </c:pt>
                <c:pt idx="16">
                  <c:v>72.732410285391339</c:v>
                </c:pt>
                <c:pt idx="17">
                  <c:v>75.176603560327749</c:v>
                </c:pt>
                <c:pt idx="18">
                  <c:v>93.246679853065814</c:v>
                </c:pt>
                <c:pt idx="20">
                  <c:v>59.92078320005978</c:v>
                </c:pt>
                <c:pt idx="21">
                  <c:v>67.110081458784848</c:v>
                </c:pt>
                <c:pt idx="22">
                  <c:v>65.764890516403852</c:v>
                </c:pt>
                <c:pt idx="23">
                  <c:v>69.411852626858987</c:v>
                </c:pt>
                <c:pt idx="25">
                  <c:v>69.292280098647325</c:v>
                </c:pt>
                <c:pt idx="26">
                  <c:v>71.713623794933099</c:v>
                </c:pt>
                <c:pt idx="27">
                  <c:v>68.096554816530897</c:v>
                </c:pt>
                <c:pt idx="28">
                  <c:v>73.761303340557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0D-40C5-BAB3-4D7B1FD773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M1-E5-biotin'!$B$2</c:f>
          <c:strCache>
            <c:ptCount val="1"/>
            <c:pt idx="0">
              <c:v>Binding of M1-E5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1-E5-biotin'!$H$19:$H$52</c:f>
                <c:numCache>
                  <c:formatCode>General</c:formatCode>
                  <c:ptCount val="34"/>
                  <c:pt idx="0">
                    <c:v>4.3369453949790611</c:v>
                  </c:pt>
                  <c:pt idx="1">
                    <c:v>1.7948157581127673</c:v>
                  </c:pt>
                  <c:pt idx="2">
                    <c:v>1.5815198431245479</c:v>
                  </c:pt>
                  <c:pt idx="3">
                    <c:v>0.76245850709753382</c:v>
                  </c:pt>
                  <c:pt idx="5">
                    <c:v>3.29091810804568</c:v>
                  </c:pt>
                  <c:pt idx="6">
                    <c:v>5.5354524395707649</c:v>
                  </c:pt>
                  <c:pt idx="7">
                    <c:v>0.20916011047135424</c:v>
                  </c:pt>
                  <c:pt idx="8">
                    <c:v>2.8139614919259719</c:v>
                  </c:pt>
                  <c:pt idx="10">
                    <c:v>2.8402976209470632</c:v>
                  </c:pt>
                  <c:pt idx="11">
                    <c:v>4.7326641568124383</c:v>
                  </c:pt>
                  <c:pt idx="12">
                    <c:v>5.8805674296075976</c:v>
                  </c:pt>
                  <c:pt idx="13">
                    <c:v>1.9562986675910026</c:v>
                  </c:pt>
                  <c:pt idx="15">
                    <c:v>2.1929225869373963</c:v>
                  </c:pt>
                  <c:pt idx="16">
                    <c:v>3.9613197033813732</c:v>
                  </c:pt>
                  <c:pt idx="17">
                    <c:v>0.78528839237667902</c:v>
                  </c:pt>
                  <c:pt idx="18">
                    <c:v>2.7923522528134828</c:v>
                  </c:pt>
                  <c:pt idx="20">
                    <c:v>3.1765524677210486</c:v>
                  </c:pt>
                  <c:pt idx="21">
                    <c:v>4.0690106647060045</c:v>
                  </c:pt>
                  <c:pt idx="22">
                    <c:v>2.5278090309569259</c:v>
                  </c:pt>
                  <c:pt idx="23">
                    <c:v>2.6763495160655149</c:v>
                  </c:pt>
                  <c:pt idx="25">
                    <c:v>7.7820167636564364</c:v>
                  </c:pt>
                  <c:pt idx="26">
                    <c:v>3.0035533036345252</c:v>
                  </c:pt>
                  <c:pt idx="27">
                    <c:v>5.4152959225988493</c:v>
                  </c:pt>
                  <c:pt idx="28">
                    <c:v>8.0407452161693591</c:v>
                  </c:pt>
                  <c:pt idx="30">
                    <c:v>2.7421941934378338</c:v>
                  </c:pt>
                  <c:pt idx="31">
                    <c:v>2.1383123658404029</c:v>
                  </c:pt>
                  <c:pt idx="32">
                    <c:v>0.70108808274585555</c:v>
                  </c:pt>
                  <c:pt idx="33">
                    <c:v>0.914833369636234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M1-E5-biotin'!$B$19:$C$52</c:f>
              <c:multiLvlStrCache>
                <c:ptCount val="3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  <c:pt idx="30">
                    <c:v>4</c:v>
                  </c:pt>
                  <c:pt idx="31">
                    <c:v>1</c:v>
                  </c:pt>
                  <c:pt idx="32">
                    <c:v>0.25</c:v>
                  </c:pt>
                  <c:pt idx="33">
                    <c:v>0.0625</c:v>
                  </c:pt>
                </c:lvl>
                <c:lvl>
                  <c:pt idx="0">
                    <c:v>No.2</c:v>
                  </c:pt>
                  <c:pt idx="5">
                    <c:v>No.4</c:v>
                  </c:pt>
                  <c:pt idx="10">
                    <c:v>No.5</c:v>
                  </c:pt>
                  <c:pt idx="15">
                    <c:v>No.11</c:v>
                  </c:pt>
                  <c:pt idx="20">
                    <c:v>4M2</c:v>
                  </c:pt>
                  <c:pt idx="25">
                    <c:v>4M3</c:v>
                  </c:pt>
                  <c:pt idx="30">
                    <c:v>4M6</c:v>
                  </c:pt>
                </c:lvl>
              </c:multiLvlStrCache>
            </c:multiLvlStrRef>
          </c:cat>
          <c:val>
            <c:numRef>
              <c:f>'M1-E5-biotin'!$G$19:$G$52</c:f>
              <c:numCache>
                <c:formatCode>General</c:formatCode>
                <c:ptCount val="34"/>
                <c:pt idx="0">
                  <c:v>94.967763543498279</c:v>
                </c:pt>
                <c:pt idx="1">
                  <c:v>96.47492254877335</c:v>
                </c:pt>
                <c:pt idx="2">
                  <c:v>100.27631248430043</c:v>
                </c:pt>
                <c:pt idx="3">
                  <c:v>98.852884534873979</c:v>
                </c:pt>
                <c:pt idx="5">
                  <c:v>70.786234614418504</c:v>
                </c:pt>
                <c:pt idx="6">
                  <c:v>88.302771497948584</c:v>
                </c:pt>
                <c:pt idx="7">
                  <c:v>98.450975466800642</c:v>
                </c:pt>
                <c:pt idx="8">
                  <c:v>95.821820313154149</c:v>
                </c:pt>
                <c:pt idx="10">
                  <c:v>62.262413129029561</c:v>
                </c:pt>
                <c:pt idx="11">
                  <c:v>93.075441681319603</c:v>
                </c:pt>
                <c:pt idx="12">
                  <c:v>101.74997906723604</c:v>
                </c:pt>
                <c:pt idx="13">
                  <c:v>100.51075944067655</c:v>
                </c:pt>
                <c:pt idx="15">
                  <c:v>96.692623293979736</c:v>
                </c:pt>
                <c:pt idx="16">
                  <c:v>104.4293728543917</c:v>
                </c:pt>
                <c:pt idx="17">
                  <c:v>110.30729297496441</c:v>
                </c:pt>
                <c:pt idx="18">
                  <c:v>113.80725110943649</c:v>
                </c:pt>
                <c:pt idx="20">
                  <c:v>89.91505118710522</c:v>
                </c:pt>
                <c:pt idx="21">
                  <c:v>93.763159805416407</c:v>
                </c:pt>
                <c:pt idx="22">
                  <c:v>97.887170551078199</c:v>
                </c:pt>
                <c:pt idx="23">
                  <c:v>101.22703840848037</c:v>
                </c:pt>
                <c:pt idx="25">
                  <c:v>96.79310056099807</c:v>
                </c:pt>
                <c:pt idx="26">
                  <c:v>101.3480699991627</c:v>
                </c:pt>
                <c:pt idx="27">
                  <c:v>109.41974378296912</c:v>
                </c:pt>
                <c:pt idx="28">
                  <c:v>121.59423930335761</c:v>
                </c:pt>
                <c:pt idx="30">
                  <c:v>101.90953314455821</c:v>
                </c:pt>
                <c:pt idx="31">
                  <c:v>103.56494590866187</c:v>
                </c:pt>
                <c:pt idx="32">
                  <c:v>109.17011544325855</c:v>
                </c:pt>
                <c:pt idx="33">
                  <c:v>109.300805924635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A3-48E8-8B3B-4850790457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M1-E5-biotin'!$B$2</c:f>
          <c:strCache>
            <c:ptCount val="1"/>
            <c:pt idx="0">
              <c:v>Binding of M1-E5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1-E5-biotin'!$H$54:$H$82</c:f>
                <c:numCache>
                  <c:formatCode>General</c:formatCode>
                  <c:ptCount val="29"/>
                  <c:pt idx="0">
                    <c:v>8.9525187922037066</c:v>
                  </c:pt>
                  <c:pt idx="1">
                    <c:v>7.5938471566680157</c:v>
                  </c:pt>
                  <c:pt idx="2">
                    <c:v>2.9681842982983317</c:v>
                  </c:pt>
                  <c:pt idx="3">
                    <c:v>2.7421941934378338</c:v>
                  </c:pt>
                  <c:pt idx="5">
                    <c:v>4.6297016348082298</c:v>
                  </c:pt>
                  <c:pt idx="6">
                    <c:v>5.0325420900051228</c:v>
                  </c:pt>
                  <c:pt idx="7">
                    <c:v>4.0367009335198736</c:v>
                  </c:pt>
                  <c:pt idx="8">
                    <c:v>2.4704764763681637</c:v>
                  </c:pt>
                  <c:pt idx="10">
                    <c:v>0.89208709094122263</c:v>
                  </c:pt>
                  <c:pt idx="11">
                    <c:v>8.2422715304632064</c:v>
                  </c:pt>
                  <c:pt idx="12">
                    <c:v>4.7458047647502273</c:v>
                  </c:pt>
                  <c:pt idx="13">
                    <c:v>0.95945395115609677</c:v>
                  </c:pt>
                  <c:pt idx="15">
                    <c:v>0.11110049937857082</c:v>
                  </c:pt>
                  <c:pt idx="16">
                    <c:v>0.99795345938847646</c:v>
                  </c:pt>
                  <c:pt idx="17">
                    <c:v>2.1173625346533465</c:v>
                  </c:pt>
                  <c:pt idx="18">
                    <c:v>5.1529682692123666</c:v>
                  </c:pt>
                  <c:pt idx="20">
                    <c:v>0.46371720275443207</c:v>
                  </c:pt>
                  <c:pt idx="21">
                    <c:v>3.0461334706791234</c:v>
                  </c:pt>
                  <c:pt idx="22">
                    <c:v>3.6664050753118325</c:v>
                  </c:pt>
                  <c:pt idx="23">
                    <c:v>2.4517743184428129</c:v>
                  </c:pt>
                  <c:pt idx="25">
                    <c:v>5.7864062337494406</c:v>
                  </c:pt>
                  <c:pt idx="26">
                    <c:v>4.2936753488078843</c:v>
                  </c:pt>
                  <c:pt idx="27">
                    <c:v>20.122483454836686</c:v>
                  </c:pt>
                  <c:pt idx="28">
                    <c:v>12.5516044699214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M1-E5-biotin'!$B$54:$C$82</c:f>
              <c:multiLvlStrCache>
                <c:ptCount val="29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</c:lvl>
                <c:lvl>
                  <c:pt idx="0">
                    <c:v>4M7</c:v>
                  </c:pt>
                  <c:pt idx="5">
                    <c:v>4M8</c:v>
                  </c:pt>
                  <c:pt idx="10">
                    <c:v>M1-B8</c:v>
                  </c:pt>
                  <c:pt idx="15">
                    <c:v>M1-D1</c:v>
                  </c:pt>
                  <c:pt idx="20">
                    <c:v>M1-E1</c:v>
                  </c:pt>
                  <c:pt idx="25">
                    <c:v>MAb4-5</c:v>
                  </c:pt>
                </c:lvl>
              </c:multiLvlStrCache>
            </c:multiLvlStrRef>
          </c:cat>
          <c:val>
            <c:numRef>
              <c:f>'M1-E5-biotin'!$G$54:$G$82</c:f>
              <c:numCache>
                <c:formatCode>General</c:formatCode>
                <c:ptCount val="29"/>
                <c:pt idx="0">
                  <c:v>109.24272126624555</c:v>
                </c:pt>
                <c:pt idx="1">
                  <c:v>108.2262397444275</c:v>
                </c:pt>
                <c:pt idx="2">
                  <c:v>118.33297030421841</c:v>
                </c:pt>
                <c:pt idx="3">
                  <c:v>118.02802584767296</c:v>
                </c:pt>
                <c:pt idx="5">
                  <c:v>97.117548827415945</c:v>
                </c:pt>
                <c:pt idx="6">
                  <c:v>104.08770783416828</c:v>
                </c:pt>
                <c:pt idx="7">
                  <c:v>108.66187468234951</c:v>
                </c:pt>
                <c:pt idx="8">
                  <c:v>118.14419516445219</c:v>
                </c:pt>
                <c:pt idx="10">
                  <c:v>28.224560370833633</c:v>
                </c:pt>
                <c:pt idx="11">
                  <c:v>71.444338164962105</c:v>
                </c:pt>
                <c:pt idx="12">
                  <c:v>90.398057538076657</c:v>
                </c:pt>
                <c:pt idx="13">
                  <c:v>95.195349863880494</c:v>
                </c:pt>
                <c:pt idx="15">
                  <c:v>7.0046354204988583</c:v>
                </c:pt>
                <c:pt idx="16">
                  <c:v>52.137443896696333</c:v>
                </c:pt>
                <c:pt idx="17">
                  <c:v>86.557280553307308</c:v>
                </c:pt>
                <c:pt idx="18">
                  <c:v>91.943197704363172</c:v>
                </c:pt>
                <c:pt idx="20">
                  <c:v>13.891545875947317</c:v>
                </c:pt>
                <c:pt idx="21">
                  <c:v>64.631005812670139</c:v>
                </c:pt>
                <c:pt idx="22">
                  <c:v>94.091678316532978</c:v>
                </c:pt>
                <c:pt idx="23">
                  <c:v>94.238834522845991</c:v>
                </c:pt>
                <c:pt idx="25">
                  <c:v>113.70071879764758</c:v>
                </c:pt>
                <c:pt idx="26">
                  <c:v>118.12967399985479</c:v>
                </c:pt>
                <c:pt idx="27">
                  <c:v>125.39025629855513</c:v>
                </c:pt>
                <c:pt idx="28">
                  <c:v>126.14535685761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92-4140-A9E0-0FAA29D901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No.22-biotin'!$B$2</c:f>
          <c:strCache>
            <c:ptCount val="1"/>
            <c:pt idx="0">
              <c:v>Binding of No.22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o.22-biotin'!$H$19:$H$52</c:f>
                <c:numCache>
                  <c:formatCode>General</c:formatCode>
                  <c:ptCount val="34"/>
                  <c:pt idx="0">
                    <c:v>6.4714272218101234</c:v>
                  </c:pt>
                  <c:pt idx="1">
                    <c:v>3.1511080746352471</c:v>
                  </c:pt>
                  <c:pt idx="2">
                    <c:v>3.344384471474434</c:v>
                  </c:pt>
                  <c:pt idx="3">
                    <c:v>2.9493258503222992</c:v>
                  </c:pt>
                  <c:pt idx="5">
                    <c:v>1.3582744745469841</c:v>
                  </c:pt>
                  <c:pt idx="6">
                    <c:v>6.6379955361495817</c:v>
                  </c:pt>
                  <c:pt idx="7">
                    <c:v>10.967642086714195</c:v>
                  </c:pt>
                  <c:pt idx="8">
                    <c:v>5.444274014245341</c:v>
                  </c:pt>
                  <c:pt idx="10">
                    <c:v>13.133117742134433</c:v>
                  </c:pt>
                  <c:pt idx="11">
                    <c:v>4.3533227027454995</c:v>
                  </c:pt>
                  <c:pt idx="12">
                    <c:v>3.7626531993091303</c:v>
                  </c:pt>
                  <c:pt idx="13">
                    <c:v>9.9003647927543028</c:v>
                  </c:pt>
                  <c:pt idx="15">
                    <c:v>6.274190084275804</c:v>
                  </c:pt>
                  <c:pt idx="16">
                    <c:v>1.4880179052019269</c:v>
                  </c:pt>
                  <c:pt idx="17">
                    <c:v>6.6859678430828255</c:v>
                  </c:pt>
                  <c:pt idx="18">
                    <c:v>8.4590439566785545</c:v>
                  </c:pt>
                  <c:pt idx="20">
                    <c:v>4.1060385543510005</c:v>
                  </c:pt>
                  <c:pt idx="21">
                    <c:v>5.1747044499716557</c:v>
                  </c:pt>
                  <c:pt idx="22">
                    <c:v>3.182974836841618</c:v>
                  </c:pt>
                  <c:pt idx="23">
                    <c:v>3.7314340952398886</c:v>
                  </c:pt>
                  <c:pt idx="25">
                    <c:v>2.3842653761209962</c:v>
                  </c:pt>
                  <c:pt idx="26">
                    <c:v>4.8798733171930797</c:v>
                  </c:pt>
                  <c:pt idx="27">
                    <c:v>4.0529792932850821</c:v>
                  </c:pt>
                  <c:pt idx="28">
                    <c:v>5.4930513159565422</c:v>
                  </c:pt>
                  <c:pt idx="30">
                    <c:v>1.7473570397903373</c:v>
                  </c:pt>
                  <c:pt idx="31">
                    <c:v>7.9249485004183056</c:v>
                  </c:pt>
                  <c:pt idx="32">
                    <c:v>2.012904445194041</c:v>
                  </c:pt>
                  <c:pt idx="33">
                    <c:v>1.4304268405891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o.22-biotin'!$B$19:$C$52</c:f>
              <c:multiLvlStrCache>
                <c:ptCount val="3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  <c:pt idx="30">
                    <c:v>4</c:v>
                  </c:pt>
                  <c:pt idx="31">
                    <c:v>1</c:v>
                  </c:pt>
                  <c:pt idx="32">
                    <c:v>0.25</c:v>
                  </c:pt>
                  <c:pt idx="33">
                    <c:v>0.0625</c:v>
                  </c:pt>
                </c:lvl>
                <c:lvl>
                  <c:pt idx="0">
                    <c:v>No.16</c:v>
                  </c:pt>
                  <c:pt idx="5">
                    <c:v>No.23</c:v>
                  </c:pt>
                  <c:pt idx="10">
                    <c:v>No.31</c:v>
                  </c:pt>
                  <c:pt idx="15">
                    <c:v>No.33</c:v>
                  </c:pt>
                  <c:pt idx="20">
                    <c:v>No.40</c:v>
                  </c:pt>
                  <c:pt idx="25">
                    <c:v>5M1</c:v>
                  </c:pt>
                  <c:pt idx="30">
                    <c:v>5M3</c:v>
                  </c:pt>
                </c:lvl>
              </c:multiLvlStrCache>
            </c:multiLvlStrRef>
          </c:cat>
          <c:val>
            <c:numRef>
              <c:f>'No.22-biotin'!$G$19:$G$52</c:f>
              <c:numCache>
                <c:formatCode>General</c:formatCode>
                <c:ptCount val="34"/>
                <c:pt idx="0">
                  <c:v>74.553001277139231</c:v>
                </c:pt>
                <c:pt idx="1">
                  <c:v>71.024904214559399</c:v>
                </c:pt>
                <c:pt idx="2">
                  <c:v>76.979565772669233</c:v>
                </c:pt>
                <c:pt idx="3">
                  <c:v>76.213282247765022</c:v>
                </c:pt>
                <c:pt idx="5">
                  <c:v>28.464240102171136</c:v>
                </c:pt>
                <c:pt idx="6">
                  <c:v>54.18263090676885</c:v>
                </c:pt>
                <c:pt idx="7">
                  <c:v>80.363984674329515</c:v>
                </c:pt>
                <c:pt idx="8">
                  <c:v>91.746487867177549</c:v>
                </c:pt>
                <c:pt idx="10">
                  <c:v>97.1902937420179</c:v>
                </c:pt>
                <c:pt idx="11">
                  <c:v>100.46296296296299</c:v>
                </c:pt>
                <c:pt idx="12">
                  <c:v>99.840357598978301</c:v>
                </c:pt>
                <c:pt idx="13">
                  <c:v>96.934865900383159</c:v>
                </c:pt>
                <c:pt idx="15">
                  <c:v>68.167305236270764</c:v>
                </c:pt>
                <c:pt idx="16">
                  <c:v>72.924648786717782</c:v>
                </c:pt>
                <c:pt idx="17">
                  <c:v>80.02873563218391</c:v>
                </c:pt>
                <c:pt idx="18">
                  <c:v>85.424648786717782</c:v>
                </c:pt>
                <c:pt idx="20">
                  <c:v>70.849297573435535</c:v>
                </c:pt>
                <c:pt idx="21">
                  <c:v>78.751596424010231</c:v>
                </c:pt>
                <c:pt idx="22">
                  <c:v>82.662835249042146</c:v>
                </c:pt>
                <c:pt idx="23">
                  <c:v>91.538952745849315</c:v>
                </c:pt>
                <c:pt idx="25">
                  <c:v>80.98585584822564</c:v>
                </c:pt>
                <c:pt idx="26">
                  <c:v>88.252731430507353</c:v>
                </c:pt>
                <c:pt idx="27">
                  <c:v>96.756161599051424</c:v>
                </c:pt>
                <c:pt idx="28">
                  <c:v>96.790039806894242</c:v>
                </c:pt>
                <c:pt idx="30">
                  <c:v>81.375455238417899</c:v>
                </c:pt>
                <c:pt idx="31">
                  <c:v>85.593292114847145</c:v>
                </c:pt>
                <c:pt idx="32">
                  <c:v>86.999237740323551</c:v>
                </c:pt>
                <c:pt idx="33">
                  <c:v>84.9834843736766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A4-485E-803D-01EAEC0BDA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No.22-biotin'!$B$2</c:f>
          <c:strCache>
            <c:ptCount val="1"/>
            <c:pt idx="0">
              <c:v>Binding of No.22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o.22-biotin'!$H$54:$H$82</c:f>
                <c:numCache>
                  <c:formatCode>General</c:formatCode>
                  <c:ptCount val="29"/>
                  <c:pt idx="0">
                    <c:v>8.2286711253035705</c:v>
                  </c:pt>
                  <c:pt idx="1">
                    <c:v>0.69593916075689632</c:v>
                  </c:pt>
                  <c:pt idx="2">
                    <c:v>4.3882942468755841</c:v>
                  </c:pt>
                  <c:pt idx="3">
                    <c:v>4.8896609371300599</c:v>
                  </c:pt>
                  <c:pt idx="5">
                    <c:v>0.58458317698780127</c:v>
                  </c:pt>
                  <c:pt idx="6">
                    <c:v>6.3495887047035442</c:v>
                  </c:pt>
                  <c:pt idx="7">
                    <c:v>1.5433187742719494</c:v>
                  </c:pt>
                  <c:pt idx="8">
                    <c:v>4.1983014623410568</c:v>
                  </c:pt>
                  <c:pt idx="10">
                    <c:v>3.7995357634063849</c:v>
                  </c:pt>
                  <c:pt idx="11">
                    <c:v>3.4478050743471105</c:v>
                  </c:pt>
                  <c:pt idx="12">
                    <c:v>1.8504884141259959</c:v>
                  </c:pt>
                  <c:pt idx="13">
                    <c:v>9.8424976573847331</c:v>
                  </c:pt>
                  <c:pt idx="15">
                    <c:v>9.9255041731574476</c:v>
                  </c:pt>
                  <c:pt idx="16">
                    <c:v>9.5262446936093941</c:v>
                  </c:pt>
                  <c:pt idx="17">
                    <c:v>5.6906208736368429</c:v>
                  </c:pt>
                  <c:pt idx="18">
                    <c:v>6.1672997472634474</c:v>
                  </c:pt>
                  <c:pt idx="20">
                    <c:v>1.6363104569948808</c:v>
                  </c:pt>
                  <c:pt idx="21">
                    <c:v>0.55563100100641438</c:v>
                  </c:pt>
                  <c:pt idx="22">
                    <c:v>1.7976951308200702</c:v>
                  </c:pt>
                  <c:pt idx="23">
                    <c:v>4.099076209699156</c:v>
                  </c:pt>
                  <c:pt idx="25">
                    <c:v>3.9688317024814621</c:v>
                  </c:pt>
                  <c:pt idx="26">
                    <c:v>4.7700300371647133</c:v>
                  </c:pt>
                  <c:pt idx="27">
                    <c:v>12.323610814452691</c:v>
                  </c:pt>
                  <c:pt idx="28">
                    <c:v>10.323314758418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o.22-biotin'!$B$54:$C$82</c:f>
              <c:multiLvlStrCache>
                <c:ptCount val="29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</c:lvl>
                <c:lvl>
                  <c:pt idx="0">
                    <c:v>5M5</c:v>
                  </c:pt>
                  <c:pt idx="5">
                    <c:v>5M9</c:v>
                  </c:pt>
                  <c:pt idx="10">
                    <c:v>5D12</c:v>
                  </c:pt>
                  <c:pt idx="15">
                    <c:v>6D12</c:v>
                  </c:pt>
                  <c:pt idx="20">
                    <c:v>8E9</c:v>
                  </c:pt>
                  <c:pt idx="25">
                    <c:v>C3A11</c:v>
                  </c:pt>
                </c:lvl>
              </c:multiLvlStrCache>
            </c:multiLvlStrRef>
          </c:cat>
          <c:val>
            <c:numRef>
              <c:f>'No.22-biotin'!$G$54:$G$82</c:f>
              <c:numCache>
                <c:formatCode>General</c:formatCode>
                <c:ptCount val="29"/>
                <c:pt idx="0">
                  <c:v>60.546389923718287</c:v>
                </c:pt>
                <c:pt idx="1">
                  <c:v>78.978179882916436</c:v>
                </c:pt>
                <c:pt idx="2">
                  <c:v>97.445449707291104</c:v>
                </c:pt>
                <c:pt idx="3">
                  <c:v>115.57566081248892</c:v>
                </c:pt>
                <c:pt idx="5">
                  <c:v>27.509104768357759</c:v>
                </c:pt>
                <c:pt idx="6">
                  <c:v>57.847039891589738</c:v>
                </c:pt>
                <c:pt idx="7">
                  <c:v>82.408740577623462</c:v>
                </c:pt>
                <c:pt idx="8">
                  <c:v>93.436097230456525</c:v>
                </c:pt>
                <c:pt idx="10">
                  <c:v>86.641830761043096</c:v>
                </c:pt>
                <c:pt idx="11">
                  <c:v>98.935604044704633</c:v>
                </c:pt>
                <c:pt idx="12">
                  <c:v>111.33581692389571</c:v>
                </c:pt>
                <c:pt idx="13">
                  <c:v>124.26822778073442</c:v>
                </c:pt>
                <c:pt idx="15">
                  <c:v>95.653716515877235</c:v>
                </c:pt>
                <c:pt idx="16">
                  <c:v>96.930991662231676</c:v>
                </c:pt>
                <c:pt idx="17">
                  <c:v>104.00922476494588</c:v>
                </c:pt>
                <c:pt idx="18">
                  <c:v>105.42841937200637</c:v>
                </c:pt>
                <c:pt idx="20">
                  <c:v>98.048607415291812</c:v>
                </c:pt>
                <c:pt idx="21">
                  <c:v>100.37253858435338</c:v>
                </c:pt>
                <c:pt idx="22">
                  <c:v>107.34433209153804</c:v>
                </c:pt>
                <c:pt idx="23">
                  <c:v>105.6590384956537</c:v>
                </c:pt>
                <c:pt idx="25">
                  <c:v>24.605286499911298</c:v>
                </c:pt>
                <c:pt idx="26">
                  <c:v>42.079120099343619</c:v>
                </c:pt>
                <c:pt idx="27">
                  <c:v>88.965761930104648</c:v>
                </c:pt>
                <c:pt idx="28">
                  <c:v>113.7129678907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4E-45E4-BF5F-347AF932A1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C6C1-biotin'!$B$2</c:f>
          <c:strCache>
            <c:ptCount val="1"/>
            <c:pt idx="0">
              <c:v>Binding of C6C1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6C1-biotin'!$H$19:$H$52</c:f>
                <c:numCache>
                  <c:formatCode>General</c:formatCode>
                  <c:ptCount val="34"/>
                  <c:pt idx="0">
                    <c:v>2.2584744216995762</c:v>
                  </c:pt>
                  <c:pt idx="1">
                    <c:v>3.348423193478308</c:v>
                  </c:pt>
                  <c:pt idx="2">
                    <c:v>4.947750669103133</c:v>
                  </c:pt>
                  <c:pt idx="3">
                    <c:v>1.6872311103576734</c:v>
                  </c:pt>
                  <c:pt idx="5">
                    <c:v>4.8827107185552201</c:v>
                  </c:pt>
                  <c:pt idx="6">
                    <c:v>6.4392981552364459</c:v>
                  </c:pt>
                  <c:pt idx="7">
                    <c:v>8.4139951748804318</c:v>
                  </c:pt>
                  <c:pt idx="8">
                    <c:v>6.2217541084420001</c:v>
                  </c:pt>
                  <c:pt idx="10">
                    <c:v>10.904714939781037</c:v>
                  </c:pt>
                  <c:pt idx="11">
                    <c:v>6.6505199607488317</c:v>
                  </c:pt>
                  <c:pt idx="12">
                    <c:v>2.967526493687032</c:v>
                  </c:pt>
                  <c:pt idx="13">
                    <c:v>4.7243457094965251</c:v>
                  </c:pt>
                  <c:pt idx="15">
                    <c:v>0.56064763611576129</c:v>
                  </c:pt>
                  <c:pt idx="16">
                    <c:v>4.3554501499711895</c:v>
                  </c:pt>
                  <c:pt idx="17">
                    <c:v>4.1828438151728493</c:v>
                  </c:pt>
                  <c:pt idx="18">
                    <c:v>3.770987749809898</c:v>
                  </c:pt>
                  <c:pt idx="20">
                    <c:v>2.1129787994811284</c:v>
                  </c:pt>
                  <c:pt idx="21">
                    <c:v>3.912907731593088</c:v>
                  </c:pt>
                  <c:pt idx="22">
                    <c:v>2.2859188328045286</c:v>
                  </c:pt>
                  <c:pt idx="23">
                    <c:v>0.87496654252328532</c:v>
                  </c:pt>
                  <c:pt idx="25">
                    <c:v>6.4043753099878948</c:v>
                  </c:pt>
                  <c:pt idx="26">
                    <c:v>5.9790069002784021</c:v>
                  </c:pt>
                  <c:pt idx="27">
                    <c:v>3.5988877971630906</c:v>
                  </c:pt>
                  <c:pt idx="28">
                    <c:v>8.2898536501373528</c:v>
                  </c:pt>
                  <c:pt idx="30">
                    <c:v>3.6936812535547836</c:v>
                  </c:pt>
                  <c:pt idx="31">
                    <c:v>1.1358193210167828</c:v>
                  </c:pt>
                  <c:pt idx="32">
                    <c:v>3.8930209874836952</c:v>
                  </c:pt>
                  <c:pt idx="33">
                    <c:v>3.02723288723229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C6C1-biotin'!$B$19:$C$52</c:f>
              <c:multiLvlStrCache>
                <c:ptCount val="3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  <c:pt idx="30">
                    <c:v>4</c:v>
                  </c:pt>
                  <c:pt idx="31">
                    <c:v>1</c:v>
                  </c:pt>
                  <c:pt idx="32">
                    <c:v>0.25</c:v>
                  </c:pt>
                  <c:pt idx="33">
                    <c:v>0.0625</c:v>
                  </c:pt>
                </c:lvl>
                <c:lvl>
                  <c:pt idx="0">
                    <c:v>No.16</c:v>
                  </c:pt>
                  <c:pt idx="5">
                    <c:v>No.23</c:v>
                  </c:pt>
                  <c:pt idx="10">
                    <c:v>No.31</c:v>
                  </c:pt>
                  <c:pt idx="15">
                    <c:v>No.33</c:v>
                  </c:pt>
                  <c:pt idx="20">
                    <c:v>No.40</c:v>
                  </c:pt>
                  <c:pt idx="25">
                    <c:v>5M1</c:v>
                  </c:pt>
                  <c:pt idx="30">
                    <c:v>5M3</c:v>
                  </c:pt>
                </c:lvl>
              </c:multiLvlStrCache>
            </c:multiLvlStrRef>
          </c:cat>
          <c:val>
            <c:numRef>
              <c:f>'C6C1-biotin'!$G$19:$G$52</c:f>
              <c:numCache>
                <c:formatCode>General</c:formatCode>
                <c:ptCount val="34"/>
                <c:pt idx="0">
                  <c:v>94.619401804082941</c:v>
                </c:pt>
                <c:pt idx="1">
                  <c:v>100.01582528881153</c:v>
                </c:pt>
                <c:pt idx="2">
                  <c:v>104.20952682386455</c:v>
                </c:pt>
                <c:pt idx="3">
                  <c:v>103.87719575882261</c:v>
                </c:pt>
                <c:pt idx="5">
                  <c:v>102.32631745529356</c:v>
                </c:pt>
                <c:pt idx="6">
                  <c:v>107.3587592973572</c:v>
                </c:pt>
                <c:pt idx="7">
                  <c:v>113.40401962335814</c:v>
                </c:pt>
                <c:pt idx="8">
                  <c:v>111.789840164583</c:v>
                </c:pt>
                <c:pt idx="10">
                  <c:v>115.85693938914386</c:v>
                </c:pt>
                <c:pt idx="11">
                  <c:v>116.36334863111254</c:v>
                </c:pt>
                <c:pt idx="12">
                  <c:v>117.78762462414942</c:v>
                </c:pt>
                <c:pt idx="13">
                  <c:v>120.12976736825446</c:v>
                </c:pt>
                <c:pt idx="15">
                  <c:v>95.620206629904274</c:v>
                </c:pt>
                <c:pt idx="16">
                  <c:v>90.460797363250308</c:v>
                </c:pt>
                <c:pt idx="17">
                  <c:v>96.887874754389301</c:v>
                </c:pt>
                <c:pt idx="18">
                  <c:v>97.217468466755392</c:v>
                </c:pt>
                <c:pt idx="20">
                  <c:v>81.270203460733981</c:v>
                </c:pt>
                <c:pt idx="21">
                  <c:v>87.101476833365027</c:v>
                </c:pt>
                <c:pt idx="22">
                  <c:v>91.918615706408048</c:v>
                </c:pt>
                <c:pt idx="23">
                  <c:v>89.345249413703485</c:v>
                </c:pt>
                <c:pt idx="25">
                  <c:v>106.42506725747745</c:v>
                </c:pt>
                <c:pt idx="26">
                  <c:v>108.41905364772909</c:v>
                </c:pt>
                <c:pt idx="27">
                  <c:v>115.47713245766737</c:v>
                </c:pt>
                <c:pt idx="28">
                  <c:v>114.25858521918026</c:v>
                </c:pt>
                <c:pt idx="30">
                  <c:v>100.08239842809151</c:v>
                </c:pt>
                <c:pt idx="31">
                  <c:v>94.352538505419275</c:v>
                </c:pt>
                <c:pt idx="32">
                  <c:v>103.59383913291499</c:v>
                </c:pt>
                <c:pt idx="33">
                  <c:v>104.671357038727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71-421C-9750-C7F3D2E5CF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C6C1-biotin'!$B$2</c:f>
          <c:strCache>
            <c:ptCount val="1"/>
            <c:pt idx="0">
              <c:v>Binding of C6C1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6C1-biotin'!$H$54:$H$82</c:f>
                <c:numCache>
                  <c:formatCode>General</c:formatCode>
                  <c:ptCount val="29"/>
                  <c:pt idx="0">
                    <c:v>5.4698231658773011</c:v>
                  </c:pt>
                  <c:pt idx="1">
                    <c:v>9.2285791085467199</c:v>
                  </c:pt>
                  <c:pt idx="2">
                    <c:v>6.1659727652245317</c:v>
                  </c:pt>
                  <c:pt idx="3">
                    <c:v>7.9813728666953443</c:v>
                  </c:pt>
                  <c:pt idx="5">
                    <c:v>1.6771664722121076</c:v>
                  </c:pt>
                  <c:pt idx="6">
                    <c:v>2.6966597006299531</c:v>
                  </c:pt>
                  <c:pt idx="7">
                    <c:v>3.6498568667352984</c:v>
                  </c:pt>
                  <c:pt idx="8">
                    <c:v>6.0453297455832233</c:v>
                  </c:pt>
                  <c:pt idx="10">
                    <c:v>10.074491309177745</c:v>
                  </c:pt>
                  <c:pt idx="11">
                    <c:v>5.1009660852854291</c:v>
                  </c:pt>
                  <c:pt idx="12">
                    <c:v>9.803733335362562</c:v>
                  </c:pt>
                  <c:pt idx="13">
                    <c:v>9.4645258054603065</c:v>
                  </c:pt>
                  <c:pt idx="15">
                    <c:v>1.5675576227818975</c:v>
                  </c:pt>
                  <c:pt idx="16">
                    <c:v>4.3913311974864436E-2</c:v>
                  </c:pt>
                  <c:pt idx="17">
                    <c:v>4.1541621766636645</c:v>
                  </c:pt>
                  <c:pt idx="18">
                    <c:v>0.42348464444418621</c:v>
                  </c:pt>
                  <c:pt idx="20">
                    <c:v>2.1023172133601502</c:v>
                  </c:pt>
                  <c:pt idx="21">
                    <c:v>1.763904905056173</c:v>
                  </c:pt>
                  <c:pt idx="22">
                    <c:v>3.1641837483749451</c:v>
                  </c:pt>
                  <c:pt idx="23">
                    <c:v>2.120625110882822</c:v>
                  </c:pt>
                  <c:pt idx="25">
                    <c:v>5.9506984615120775</c:v>
                  </c:pt>
                  <c:pt idx="26">
                    <c:v>7.7481379213414661</c:v>
                  </c:pt>
                  <c:pt idx="27">
                    <c:v>1.677047638012634</c:v>
                  </c:pt>
                  <c:pt idx="28">
                    <c:v>3.28007403134480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C6C1-biotin'!$B$54:$C$82</c:f>
              <c:multiLvlStrCache>
                <c:ptCount val="29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</c:lvl>
                <c:lvl>
                  <c:pt idx="0">
                    <c:v>5M5</c:v>
                  </c:pt>
                  <c:pt idx="5">
                    <c:v>5M9</c:v>
                  </c:pt>
                  <c:pt idx="10">
                    <c:v>5D12</c:v>
                  </c:pt>
                  <c:pt idx="15">
                    <c:v>6D12</c:v>
                  </c:pt>
                  <c:pt idx="20">
                    <c:v>8E9</c:v>
                  </c:pt>
                  <c:pt idx="25">
                    <c:v>C3A11</c:v>
                  </c:pt>
                </c:lvl>
              </c:multiLvlStrCache>
            </c:multiLvlStrRef>
          </c:cat>
          <c:val>
            <c:numRef>
              <c:f>'C6C1-biotin'!$G$54:$G$82</c:f>
              <c:numCache>
                <c:formatCode>General</c:formatCode>
                <c:ptCount val="29"/>
                <c:pt idx="0">
                  <c:v>93.550803988242777</c:v>
                </c:pt>
                <c:pt idx="1">
                  <c:v>93.308743011930162</c:v>
                </c:pt>
                <c:pt idx="2">
                  <c:v>99.049046164486199</c:v>
                </c:pt>
                <c:pt idx="3">
                  <c:v>95.7062993487407</c:v>
                </c:pt>
                <c:pt idx="5">
                  <c:v>89.308973546193315</c:v>
                </c:pt>
                <c:pt idx="6">
                  <c:v>85.747219180450699</c:v>
                </c:pt>
                <c:pt idx="7">
                  <c:v>92.720880640885255</c:v>
                </c:pt>
                <c:pt idx="8">
                  <c:v>89.48187424355946</c:v>
                </c:pt>
                <c:pt idx="10">
                  <c:v>109.40652549304735</c:v>
                </c:pt>
                <c:pt idx="11">
                  <c:v>117.2771062437517</c:v>
                </c:pt>
                <c:pt idx="12">
                  <c:v>119.24020721621376</c:v>
                </c:pt>
                <c:pt idx="13">
                  <c:v>121.13060074525129</c:v>
                </c:pt>
                <c:pt idx="15">
                  <c:v>101.31203650884197</c:v>
                </c:pt>
                <c:pt idx="16">
                  <c:v>97.382265322938451</c:v>
                </c:pt>
                <c:pt idx="17">
                  <c:v>100.43734550294732</c:v>
                </c:pt>
                <c:pt idx="18">
                  <c:v>99.448564365849009</c:v>
                </c:pt>
                <c:pt idx="20">
                  <c:v>104.17158956648184</c:v>
                </c:pt>
                <c:pt idx="21">
                  <c:v>105.42579296555483</c:v>
                </c:pt>
                <c:pt idx="22">
                  <c:v>109.22475688448606</c:v>
                </c:pt>
                <c:pt idx="23">
                  <c:v>120.65800236299191</c:v>
                </c:pt>
                <c:pt idx="25">
                  <c:v>108.71995850383264</c:v>
                </c:pt>
                <c:pt idx="26">
                  <c:v>109.19255374330011</c:v>
                </c:pt>
                <c:pt idx="27">
                  <c:v>115.73972681689817</c:v>
                </c:pt>
                <c:pt idx="28">
                  <c:v>116.627283730044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0A-4663-B1C1-8568ACD6DD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Ab3-biotin'!$B$2</c:f>
          <c:strCache>
            <c:ptCount val="1"/>
            <c:pt idx="0">
              <c:v>Binding of Ab3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b3-biotin'!$H$19:$H$52</c:f>
                <c:numCache>
                  <c:formatCode>General</c:formatCode>
                  <c:ptCount val="34"/>
                  <c:pt idx="0">
                    <c:v>3.9317541409876382</c:v>
                  </c:pt>
                  <c:pt idx="1">
                    <c:v>7.2008438061136903</c:v>
                  </c:pt>
                  <c:pt idx="2">
                    <c:v>4.8768261192432094</c:v>
                  </c:pt>
                  <c:pt idx="3">
                    <c:v>6.1348488729455699</c:v>
                  </c:pt>
                  <c:pt idx="5">
                    <c:v>6.7078683660678946</c:v>
                  </c:pt>
                  <c:pt idx="6">
                    <c:v>1.6369277921630467</c:v>
                  </c:pt>
                  <c:pt idx="7">
                    <c:v>6.3332764439369447</c:v>
                  </c:pt>
                  <c:pt idx="8">
                    <c:v>4.2746856419861841</c:v>
                  </c:pt>
                  <c:pt idx="10">
                    <c:v>8.7257688286565642</c:v>
                  </c:pt>
                  <c:pt idx="11">
                    <c:v>3.2971999457828378</c:v>
                  </c:pt>
                  <c:pt idx="12">
                    <c:v>3.8699956608650914</c:v>
                  </c:pt>
                  <c:pt idx="13">
                    <c:v>6.441653330722608</c:v>
                  </c:pt>
                  <c:pt idx="15">
                    <c:v>2.7616279483180266</c:v>
                  </c:pt>
                  <c:pt idx="16">
                    <c:v>8.7525481692597129</c:v>
                  </c:pt>
                  <c:pt idx="17">
                    <c:v>3.9823234064973265</c:v>
                  </c:pt>
                  <c:pt idx="18">
                    <c:v>7.9372533307980113</c:v>
                  </c:pt>
                  <c:pt idx="20">
                    <c:v>2.8129581416763578</c:v>
                  </c:pt>
                  <c:pt idx="21">
                    <c:v>2.0183837251085728</c:v>
                  </c:pt>
                  <c:pt idx="22">
                    <c:v>3.7774170832385527</c:v>
                  </c:pt>
                  <c:pt idx="23">
                    <c:v>3.4736515168441153</c:v>
                  </c:pt>
                  <c:pt idx="25">
                    <c:v>2.0151710432186203</c:v>
                  </c:pt>
                  <c:pt idx="26">
                    <c:v>3.4154657584824872</c:v>
                  </c:pt>
                  <c:pt idx="27">
                    <c:v>1.9432449105490426</c:v>
                  </c:pt>
                  <c:pt idx="28">
                    <c:v>2.6776723521543118</c:v>
                  </c:pt>
                  <c:pt idx="30">
                    <c:v>6.6478112472615356</c:v>
                  </c:pt>
                  <c:pt idx="31">
                    <c:v>8.6301834256465408</c:v>
                  </c:pt>
                  <c:pt idx="32">
                    <c:v>5.8645762211373897</c:v>
                  </c:pt>
                  <c:pt idx="33">
                    <c:v>4.96087086658926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Ab3-biotin'!$B$19:$C$52</c:f>
              <c:multiLvlStrCache>
                <c:ptCount val="34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  <c:pt idx="30">
                    <c:v>4</c:v>
                  </c:pt>
                  <c:pt idx="31">
                    <c:v>1</c:v>
                  </c:pt>
                  <c:pt idx="32">
                    <c:v>0.25</c:v>
                  </c:pt>
                  <c:pt idx="33">
                    <c:v>0.0625</c:v>
                  </c:pt>
                </c:lvl>
                <c:lvl>
                  <c:pt idx="0">
                    <c:v>No.16</c:v>
                  </c:pt>
                  <c:pt idx="5">
                    <c:v>No.23</c:v>
                  </c:pt>
                  <c:pt idx="10">
                    <c:v>No.31</c:v>
                  </c:pt>
                  <c:pt idx="15">
                    <c:v>No.33</c:v>
                  </c:pt>
                  <c:pt idx="20">
                    <c:v>No.40</c:v>
                  </c:pt>
                  <c:pt idx="25">
                    <c:v>5M1</c:v>
                  </c:pt>
                  <c:pt idx="30">
                    <c:v>5M3</c:v>
                  </c:pt>
                </c:lvl>
              </c:multiLvlStrCache>
            </c:multiLvlStrRef>
          </c:cat>
          <c:val>
            <c:numRef>
              <c:f>'Ab3-biotin'!$G$19:$G$52</c:f>
              <c:numCache>
                <c:formatCode>General</c:formatCode>
                <c:ptCount val="34"/>
                <c:pt idx="0">
                  <c:v>107.34135964515252</c:v>
                </c:pt>
                <c:pt idx="1">
                  <c:v>104.4265411423916</c:v>
                </c:pt>
                <c:pt idx="2">
                  <c:v>106.65339006064994</c:v>
                </c:pt>
                <c:pt idx="3">
                  <c:v>100.46166380012671</c:v>
                </c:pt>
                <c:pt idx="5">
                  <c:v>116.7737847379379</c:v>
                </c:pt>
                <c:pt idx="6">
                  <c:v>115.83235267493437</c:v>
                </c:pt>
                <c:pt idx="7">
                  <c:v>124.81216619896804</c:v>
                </c:pt>
                <c:pt idx="8">
                  <c:v>113.44256359192541</c:v>
                </c:pt>
                <c:pt idx="10">
                  <c:v>112.0847288856703</c:v>
                </c:pt>
                <c:pt idx="11">
                  <c:v>126.133791979723</c:v>
                </c:pt>
                <c:pt idx="12">
                  <c:v>120.57572191545215</c:v>
                </c:pt>
                <c:pt idx="13">
                  <c:v>125.98895627772247</c:v>
                </c:pt>
                <c:pt idx="15">
                  <c:v>114.40210011767901</c:v>
                </c:pt>
                <c:pt idx="16">
                  <c:v>124.81216619896804</c:v>
                </c:pt>
                <c:pt idx="17">
                  <c:v>121.66198968045622</c:v>
                </c:pt>
                <c:pt idx="18">
                  <c:v>126.36914999547388</c:v>
                </c:pt>
                <c:pt idx="20">
                  <c:v>122.38616819045895</c:v>
                </c:pt>
                <c:pt idx="21">
                  <c:v>119.43514076219788</c:v>
                </c:pt>
                <c:pt idx="22">
                  <c:v>126.55019462297456</c:v>
                </c:pt>
                <c:pt idx="23">
                  <c:v>131.99963791074498</c:v>
                </c:pt>
                <c:pt idx="25">
                  <c:v>88.926588525601503</c:v>
                </c:pt>
                <c:pt idx="26">
                  <c:v>86.320172732880948</c:v>
                </c:pt>
                <c:pt idx="27">
                  <c:v>86.798272671190617</c:v>
                </c:pt>
                <c:pt idx="28">
                  <c:v>83.760024676125838</c:v>
                </c:pt>
                <c:pt idx="30">
                  <c:v>84.376927822331893</c:v>
                </c:pt>
                <c:pt idx="31">
                  <c:v>86.088834053053688</c:v>
                </c:pt>
                <c:pt idx="32">
                  <c:v>88.217149907464531</c:v>
                </c:pt>
                <c:pt idx="33">
                  <c:v>95.157310302282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89-4E2E-8E39-F727951DC3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13</c:f>
          <c:strCache>
            <c:ptCount val="1"/>
            <c:pt idx="0">
              <c:v>No.11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14:$H$14</c:f>
                <c:numCache>
                  <c:formatCode>General</c:formatCode>
                  <c:ptCount val="4"/>
                  <c:pt idx="0">
                    <c:v>4.9371347658644762</c:v>
                  </c:pt>
                  <c:pt idx="1">
                    <c:v>6.415472931112018</c:v>
                  </c:pt>
                  <c:pt idx="2">
                    <c:v>6.0301867306052248</c:v>
                  </c:pt>
                  <c:pt idx="3">
                    <c:v>4.108879652991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13:$H$13</c:f>
              <c:numCache>
                <c:formatCode>General</c:formatCode>
                <c:ptCount val="4"/>
                <c:pt idx="0">
                  <c:v>121.7153284671533</c:v>
                </c:pt>
                <c:pt idx="1">
                  <c:v>119.16058394160585</c:v>
                </c:pt>
                <c:pt idx="2">
                  <c:v>123.9051094890511</c:v>
                </c:pt>
                <c:pt idx="3">
                  <c:v>111.49635036496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00-4B7D-8497-306B5733BA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Ab3-biotin'!$B$2</c:f>
          <c:strCache>
            <c:ptCount val="1"/>
            <c:pt idx="0">
              <c:v>Binding of Ab3-biotin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b3-biotin'!$H$54:$H$82</c:f>
                <c:numCache>
                  <c:formatCode>General</c:formatCode>
                  <c:ptCount val="29"/>
                  <c:pt idx="0">
                    <c:v>3.1052281144100755</c:v>
                  </c:pt>
                  <c:pt idx="1">
                    <c:v>0.83324754221098651</c:v>
                  </c:pt>
                  <c:pt idx="2">
                    <c:v>1.8150874687785039</c:v>
                  </c:pt>
                  <c:pt idx="3">
                    <c:v>2.7161696291753188</c:v>
                  </c:pt>
                  <c:pt idx="5">
                    <c:v>6.8248177966303238</c:v>
                  </c:pt>
                  <c:pt idx="6">
                    <c:v>6.9633070722396653</c:v>
                  </c:pt>
                  <c:pt idx="7">
                    <c:v>4.560209020599264</c:v>
                  </c:pt>
                  <c:pt idx="8">
                    <c:v>2.5381272766404255</c:v>
                  </c:pt>
                  <c:pt idx="10">
                    <c:v>1.3498312710911213</c:v>
                  </c:pt>
                  <c:pt idx="11">
                    <c:v>2.3306753346380642</c:v>
                  </c:pt>
                  <c:pt idx="12">
                    <c:v>4.0914586005563951</c:v>
                  </c:pt>
                  <c:pt idx="13">
                    <c:v>5.6706384955327023</c:v>
                  </c:pt>
                  <c:pt idx="15">
                    <c:v>7.7233082545213625</c:v>
                  </c:pt>
                  <c:pt idx="16">
                    <c:v>6.3222701896046747</c:v>
                  </c:pt>
                  <c:pt idx="17">
                    <c:v>4.2451563176152174</c:v>
                  </c:pt>
                  <c:pt idx="18">
                    <c:v>6.6527980583729924</c:v>
                  </c:pt>
                  <c:pt idx="20">
                    <c:v>6.3795809326871673</c:v>
                  </c:pt>
                  <c:pt idx="21">
                    <c:v>5.157209759372261</c:v>
                  </c:pt>
                  <c:pt idx="22">
                    <c:v>2.2989990590015146</c:v>
                  </c:pt>
                  <c:pt idx="23">
                    <c:v>7.6531273578616519</c:v>
                  </c:pt>
                  <c:pt idx="25">
                    <c:v>10.108837682210524</c:v>
                  </c:pt>
                  <c:pt idx="26">
                    <c:v>4.4006594537347352</c:v>
                  </c:pt>
                  <c:pt idx="27">
                    <c:v>6.3680032218007598</c:v>
                  </c:pt>
                  <c:pt idx="28">
                    <c:v>4.99477791461723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Ab3-biotin'!$B$54:$C$82</c:f>
              <c:multiLvlStrCache>
                <c:ptCount val="29"/>
                <c:lvl>
                  <c:pt idx="0">
                    <c:v>4</c:v>
                  </c:pt>
                  <c:pt idx="1">
                    <c:v>1</c:v>
                  </c:pt>
                  <c:pt idx="2">
                    <c:v>0.25</c:v>
                  </c:pt>
                  <c:pt idx="3">
                    <c:v>0.0625</c:v>
                  </c:pt>
                  <c:pt idx="5">
                    <c:v>4</c:v>
                  </c:pt>
                  <c:pt idx="6">
                    <c:v>1</c:v>
                  </c:pt>
                  <c:pt idx="7">
                    <c:v>0.25</c:v>
                  </c:pt>
                  <c:pt idx="8">
                    <c:v>0.0625</c:v>
                  </c:pt>
                  <c:pt idx="10">
                    <c:v>4</c:v>
                  </c:pt>
                  <c:pt idx="11">
                    <c:v>1</c:v>
                  </c:pt>
                  <c:pt idx="12">
                    <c:v>0.25</c:v>
                  </c:pt>
                  <c:pt idx="13">
                    <c:v>0.0625</c:v>
                  </c:pt>
                  <c:pt idx="15">
                    <c:v>4</c:v>
                  </c:pt>
                  <c:pt idx="16">
                    <c:v>1</c:v>
                  </c:pt>
                  <c:pt idx="17">
                    <c:v>0.25</c:v>
                  </c:pt>
                  <c:pt idx="18">
                    <c:v>0.0625</c:v>
                  </c:pt>
                  <c:pt idx="20">
                    <c:v>4</c:v>
                  </c:pt>
                  <c:pt idx="21">
                    <c:v>1</c:v>
                  </c:pt>
                  <c:pt idx="22">
                    <c:v>0.25</c:v>
                  </c:pt>
                  <c:pt idx="23">
                    <c:v>0.0625</c:v>
                  </c:pt>
                  <c:pt idx="25">
                    <c:v>4</c:v>
                  </c:pt>
                  <c:pt idx="26">
                    <c:v>1</c:v>
                  </c:pt>
                  <c:pt idx="27">
                    <c:v>0.25</c:v>
                  </c:pt>
                  <c:pt idx="28">
                    <c:v>0.0625</c:v>
                  </c:pt>
                </c:lvl>
                <c:lvl>
                  <c:pt idx="0">
                    <c:v>5M5</c:v>
                  </c:pt>
                  <c:pt idx="5">
                    <c:v>5M9</c:v>
                  </c:pt>
                  <c:pt idx="10">
                    <c:v>5D12</c:v>
                  </c:pt>
                  <c:pt idx="15">
                    <c:v>6D12</c:v>
                  </c:pt>
                  <c:pt idx="20">
                    <c:v>8E9</c:v>
                  </c:pt>
                  <c:pt idx="25">
                    <c:v>C3A11</c:v>
                  </c:pt>
                </c:lvl>
              </c:multiLvlStrCache>
            </c:multiLvlStrRef>
          </c:cat>
          <c:val>
            <c:numRef>
              <c:f>'Ab3-biotin'!$G$54:$G$82</c:f>
              <c:numCache>
                <c:formatCode>General</c:formatCode>
                <c:ptCount val="29"/>
                <c:pt idx="0">
                  <c:v>79.472547809993827</c:v>
                </c:pt>
                <c:pt idx="1">
                  <c:v>80.166563849475622</c:v>
                </c:pt>
                <c:pt idx="2">
                  <c:v>84.669956816779759</c:v>
                </c:pt>
                <c:pt idx="3">
                  <c:v>89.682294879703889</c:v>
                </c:pt>
                <c:pt idx="5">
                  <c:v>96.822948797038862</c:v>
                </c:pt>
                <c:pt idx="6">
                  <c:v>99.96915484268969</c:v>
                </c:pt>
                <c:pt idx="7">
                  <c:v>103.93275755706354</c:v>
                </c:pt>
                <c:pt idx="8">
                  <c:v>116.44046884639111</c:v>
                </c:pt>
                <c:pt idx="10">
                  <c:v>103.55134179656115</c:v>
                </c:pt>
                <c:pt idx="11">
                  <c:v>104.00128555359152</c:v>
                </c:pt>
                <c:pt idx="12">
                  <c:v>106.2992125984252</c:v>
                </c:pt>
                <c:pt idx="13">
                  <c:v>107.63297444962238</c:v>
                </c:pt>
                <c:pt idx="15">
                  <c:v>112.10027318013822</c:v>
                </c:pt>
                <c:pt idx="16">
                  <c:v>109.5291659971075</c:v>
                </c:pt>
                <c:pt idx="17">
                  <c:v>111.85923188172909</c:v>
                </c:pt>
                <c:pt idx="18">
                  <c:v>125.11650329423109</c:v>
                </c:pt>
                <c:pt idx="20">
                  <c:v>96.653300431832193</c:v>
                </c:pt>
                <c:pt idx="21">
                  <c:v>89.929056138186297</c:v>
                </c:pt>
                <c:pt idx="22">
                  <c:v>91.286243059839592</c:v>
                </c:pt>
                <c:pt idx="23">
                  <c:v>90.376310919185698</c:v>
                </c:pt>
                <c:pt idx="25">
                  <c:v>94.01338858782276</c:v>
                </c:pt>
                <c:pt idx="26">
                  <c:v>98.093720114759321</c:v>
                </c:pt>
                <c:pt idx="27">
                  <c:v>99.254064392731934</c:v>
                </c:pt>
                <c:pt idx="28">
                  <c:v>104.96652853044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3C-4617-929B-AEF1614DE2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7375551"/>
        <c:axId val="917385119"/>
      </c:barChart>
      <c:catAx>
        <c:axId val="9173755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mpetitor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85119"/>
        <c:crosses val="autoZero"/>
        <c:auto val="1"/>
        <c:lblAlgn val="ctr"/>
        <c:lblOffset val="100"/>
        <c:noMultiLvlLbl val="0"/>
      </c:catAx>
      <c:valAx>
        <c:axId val="917385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 (no inhibito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737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454-419E-8814-66845674AD7B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454-419E-8814-66845674AD7B}"/>
              </c:ext>
            </c:extLst>
          </c:dPt>
          <c:dPt>
            <c:idx val="4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454-419E-8814-66845674AD7B}"/>
              </c:ext>
            </c:extLst>
          </c:dPt>
          <c:dPt>
            <c:idx val="6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454-419E-8814-66845674AD7B}"/>
              </c:ext>
            </c:extLst>
          </c:dPt>
          <c:dPt>
            <c:idx val="8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2454-419E-8814-66845674AD7B}"/>
              </c:ext>
            </c:extLst>
          </c:dPt>
          <c:dPt>
            <c:idx val="10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2454-419E-8814-66845674AD7B}"/>
              </c:ext>
            </c:extLst>
          </c:dPt>
          <c:dPt>
            <c:idx val="1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2454-419E-8814-66845674AD7B}"/>
              </c:ext>
            </c:extLst>
          </c:dPt>
          <c:dPt>
            <c:idx val="14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2454-419E-8814-66845674AD7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B$21:$Q$21</c:f>
                <c:numCache>
                  <c:formatCode>General</c:formatCode>
                  <c:ptCount val="16"/>
                  <c:pt idx="0">
                    <c:v>5.6709787515031369</c:v>
                  </c:pt>
                  <c:pt idx="1">
                    <c:v>3.0527899743052958</c:v>
                  </c:pt>
                  <c:pt idx="2">
                    <c:v>11.149887891813091</c:v>
                  </c:pt>
                  <c:pt idx="3">
                    <c:v>7.0501164537782204</c:v>
                  </c:pt>
                  <c:pt idx="4">
                    <c:v>5.5425625842204038</c:v>
                  </c:pt>
                  <c:pt idx="5">
                    <c:v>5.2029804840264111</c:v>
                  </c:pt>
                  <c:pt idx="6">
                    <c:v>5.4990908339470082</c:v>
                  </c:pt>
                  <c:pt idx="7">
                    <c:v>9.813346786286969</c:v>
                  </c:pt>
                  <c:pt idx="8">
                    <c:v>12.831211945876365</c:v>
                  </c:pt>
                  <c:pt idx="9">
                    <c:v>13.521842947113006</c:v>
                  </c:pt>
                  <c:pt idx="10">
                    <c:v>5.2306787322488093</c:v>
                  </c:pt>
                  <c:pt idx="11">
                    <c:v>2.6646935501059579</c:v>
                  </c:pt>
                  <c:pt idx="12">
                    <c:v>2.0784609690826579</c:v>
                  </c:pt>
                  <c:pt idx="13">
                    <c:v>9.8133467862869814</c:v>
                  </c:pt>
                  <c:pt idx="14">
                    <c:v>4.8497422611928593</c:v>
                  </c:pt>
                  <c:pt idx="15">
                    <c:v>9.15836992291588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18:$Q$19</c:f>
              <c:multiLvlStrCache>
                <c:ptCount val="16"/>
                <c:lvl>
                  <c:pt idx="0">
                    <c:v>Pre</c:v>
                  </c:pt>
                  <c:pt idx="1">
                    <c:v>Post</c:v>
                  </c:pt>
                  <c:pt idx="2">
                    <c:v>Pre</c:v>
                  </c:pt>
                  <c:pt idx="3">
                    <c:v>Post</c:v>
                  </c:pt>
                  <c:pt idx="4">
                    <c:v>Pre</c:v>
                  </c:pt>
                  <c:pt idx="5">
                    <c:v>Post</c:v>
                  </c:pt>
                  <c:pt idx="6">
                    <c:v>Pre</c:v>
                  </c:pt>
                  <c:pt idx="7">
                    <c:v>Post</c:v>
                  </c:pt>
                  <c:pt idx="8">
                    <c:v>Pre</c:v>
                  </c:pt>
                  <c:pt idx="9">
                    <c:v>Post</c:v>
                  </c:pt>
                  <c:pt idx="10">
                    <c:v>Pre</c:v>
                  </c:pt>
                  <c:pt idx="11">
                    <c:v>Post</c:v>
                  </c:pt>
                  <c:pt idx="12">
                    <c:v>Pre</c:v>
                  </c:pt>
                  <c:pt idx="13">
                    <c:v>Post</c:v>
                  </c:pt>
                  <c:pt idx="14">
                    <c:v>Pre</c:v>
                  </c:pt>
                  <c:pt idx="15">
                    <c:v>Post</c:v>
                  </c:pt>
                </c:lvl>
                <c:lvl>
                  <c:pt idx="0">
                    <c:v>Ab10</c:v>
                  </c:pt>
                  <c:pt idx="2">
                    <c:v>4M5</c:v>
                  </c:pt>
                  <c:pt idx="4">
                    <c:v>M1-E5</c:v>
                  </c:pt>
                  <c:pt idx="6">
                    <c:v>No.22</c:v>
                  </c:pt>
                  <c:pt idx="8">
                    <c:v>C6C1</c:v>
                  </c:pt>
                  <c:pt idx="10">
                    <c:v>Ab3</c:v>
                  </c:pt>
                  <c:pt idx="12">
                    <c:v>mIgG1</c:v>
                  </c:pt>
                  <c:pt idx="14">
                    <c:v>hIgG</c:v>
                  </c:pt>
                </c:lvl>
              </c:multiLvlStrCache>
            </c:multiLvlStrRef>
          </c:cat>
          <c:val>
            <c:numRef>
              <c:f>Sheet1!$B$20:$Q$20</c:f>
              <c:numCache>
                <c:formatCode>General</c:formatCode>
                <c:ptCount val="16"/>
                <c:pt idx="0">
                  <c:v>30.400000000000002</c:v>
                </c:pt>
                <c:pt idx="1">
                  <c:v>53.076923076923073</c:v>
                </c:pt>
                <c:pt idx="2">
                  <c:v>40</c:v>
                </c:pt>
                <c:pt idx="3">
                  <c:v>45.384615384615387</c:v>
                </c:pt>
                <c:pt idx="4">
                  <c:v>64</c:v>
                </c:pt>
                <c:pt idx="5">
                  <c:v>77.692307692307693</c:v>
                </c:pt>
                <c:pt idx="6">
                  <c:v>57.6</c:v>
                </c:pt>
                <c:pt idx="7">
                  <c:v>46.923076923076927</c:v>
                </c:pt>
                <c:pt idx="8">
                  <c:v>70.800000000000011</c:v>
                </c:pt>
                <c:pt idx="9">
                  <c:v>50.384615384615387</c:v>
                </c:pt>
                <c:pt idx="10">
                  <c:v>22.8</c:v>
                </c:pt>
                <c:pt idx="11">
                  <c:v>18.846153846153843</c:v>
                </c:pt>
                <c:pt idx="12">
                  <c:v>104.40000000000002</c:v>
                </c:pt>
                <c:pt idx="13">
                  <c:v>100.76923076923076</c:v>
                </c:pt>
                <c:pt idx="14">
                  <c:v>90.800000000000011</c:v>
                </c:pt>
                <c:pt idx="15">
                  <c:v>103.846153846153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454-419E-8814-66845674AD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614224"/>
        <c:axId val="348614640"/>
      </c:barChart>
      <c:catAx>
        <c:axId val="348614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8614640"/>
        <c:crosses val="autoZero"/>
        <c:auto val="1"/>
        <c:lblAlgn val="ctr"/>
        <c:lblOffset val="100"/>
        <c:noMultiLvlLbl val="0"/>
      </c:catAx>
      <c:valAx>
        <c:axId val="348614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no antibody infectiv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8614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16</c:f>
          <c:strCache>
            <c:ptCount val="1"/>
            <c:pt idx="0">
              <c:v>4M2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17:$H$17</c:f>
                <c:numCache>
                  <c:formatCode>General</c:formatCode>
                  <c:ptCount val="4"/>
                  <c:pt idx="0">
                    <c:v>18.290182295789837</c:v>
                  </c:pt>
                  <c:pt idx="1">
                    <c:v>9.3604614126318921</c:v>
                  </c:pt>
                  <c:pt idx="2">
                    <c:v>1.8897219360642725</c:v>
                  </c:pt>
                  <c:pt idx="3">
                    <c:v>11.8874517982677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16:$H$16</c:f>
              <c:numCache>
                <c:formatCode>General</c:formatCode>
                <c:ptCount val="4"/>
                <c:pt idx="0">
                  <c:v>115.4639175257732</c:v>
                </c:pt>
                <c:pt idx="1">
                  <c:v>118.76288659793816</c:v>
                </c:pt>
                <c:pt idx="2">
                  <c:v>102.88659793814433</c:v>
                </c:pt>
                <c:pt idx="3">
                  <c:v>90.103092783505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81-4BD8-BF4C-45E898270D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25</c:f>
          <c:strCache>
            <c:ptCount val="1"/>
            <c:pt idx="0">
              <c:v>4M6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26:$H$26</c:f>
                <c:numCache>
                  <c:formatCode>General</c:formatCode>
                  <c:ptCount val="4"/>
                  <c:pt idx="0">
                    <c:v>16.277136165129519</c:v>
                  </c:pt>
                  <c:pt idx="1">
                    <c:v>16.003609200035392</c:v>
                  </c:pt>
                  <c:pt idx="2">
                    <c:v>5.6703853018162444</c:v>
                  </c:pt>
                  <c:pt idx="3">
                    <c:v>7.96005576942045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25:$H$25</c:f>
              <c:numCache>
                <c:formatCode>General</c:formatCode>
                <c:ptCount val="4"/>
                <c:pt idx="0">
                  <c:v>120.13605442176872</c:v>
                </c:pt>
                <c:pt idx="1">
                  <c:v>105.44217687074831</c:v>
                </c:pt>
                <c:pt idx="2">
                  <c:v>100.40816326530613</c:v>
                </c:pt>
                <c:pt idx="3">
                  <c:v>112.925170068027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B6-4844-B217-45272E7BE3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28</c:f>
          <c:strCache>
            <c:ptCount val="1"/>
            <c:pt idx="0">
              <c:v>4M7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中和結果!$E$29:$H$29</c:f>
                <c:numCache>
                  <c:formatCode>General</c:formatCode>
                  <c:ptCount val="4"/>
                  <c:pt idx="0">
                    <c:v>3.4205272479593329</c:v>
                  </c:pt>
                  <c:pt idx="1">
                    <c:v>15.07861347349861</c:v>
                  </c:pt>
                  <c:pt idx="2">
                    <c:v>6.9336413803777734</c:v>
                  </c:pt>
                  <c:pt idx="3">
                    <c:v>4.08540460900254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28:$H$28</c:f>
              <c:numCache>
                <c:formatCode>General</c:formatCode>
                <c:ptCount val="4"/>
                <c:pt idx="0">
                  <c:v>89.246467817896402</c:v>
                </c:pt>
                <c:pt idx="1">
                  <c:v>90.973312401883831</c:v>
                </c:pt>
                <c:pt idx="2">
                  <c:v>83.359497645211931</c:v>
                </c:pt>
                <c:pt idx="3">
                  <c:v>65.463108320251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D66-405C-83DB-F884E94C86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ax val="1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中和結果!$B$31</c:f>
          <c:strCache>
            <c:ptCount val="1"/>
            <c:pt idx="0">
              <c:v>4M8</c:v>
            </c:pt>
          </c:strCache>
        </c:strRef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中和結果!$E$2:$H$3</c:f>
              <c:multiLvlStrCache>
                <c:ptCount val="4"/>
                <c:lvl>
                  <c:pt idx="0">
                    <c:v>0.25</c:v>
                  </c:pt>
                  <c:pt idx="1">
                    <c:v>1</c:v>
                  </c:pt>
                  <c:pt idx="2">
                    <c:v>4</c:v>
                  </c:pt>
                  <c:pt idx="3">
                    <c:v>16</c:v>
                  </c:pt>
                </c:lvl>
                <c:lvl>
                  <c:pt idx="0">
                    <c:v>µg/mL</c:v>
                  </c:pt>
                </c:lvl>
              </c:multiLvlStrCache>
            </c:multiLvlStrRef>
          </c:cat>
          <c:val>
            <c:numRef>
              <c:f>中和結果!$E$31:$H$31</c:f>
              <c:numCache>
                <c:formatCode>General</c:formatCode>
                <c:ptCount val="4"/>
                <c:pt idx="0">
                  <c:v>120.6436420722135</c:v>
                </c:pt>
                <c:pt idx="1">
                  <c:v>98.037676609105176</c:v>
                </c:pt>
                <c:pt idx="2">
                  <c:v>116.32653061224489</c:v>
                </c:pt>
                <c:pt idx="3">
                  <c:v>97.723704866562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3F-48F3-86DF-631DFD4ED6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2026255"/>
        <c:axId val="1762037487"/>
      </c:barChart>
      <c:catAx>
        <c:axId val="1762026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37487"/>
        <c:crosses val="autoZero"/>
        <c:auto val="1"/>
        <c:lblAlgn val="ctr"/>
        <c:lblOffset val="100"/>
        <c:noMultiLvlLbl val="0"/>
      </c:catAx>
      <c:valAx>
        <c:axId val="17620374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% of contro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6202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305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417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4743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6437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635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843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6755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116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45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656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891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88C40-6936-451D-9085-F8895C045C9A}" type="datetimeFigureOut">
              <a:rPr kumimoji="1" lang="ja-JP" altLang="en-US" smtClean="0"/>
              <a:t>2022/7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D3D43E-D235-4D8F-BD98-E955D779BA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7089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1.xml"/><Relationship Id="rId13" Type="http://schemas.openxmlformats.org/officeDocument/2006/relationships/chart" Target="../charts/chart26.xml"/><Relationship Id="rId3" Type="http://schemas.openxmlformats.org/officeDocument/2006/relationships/chart" Target="../charts/chart16.xml"/><Relationship Id="rId7" Type="http://schemas.openxmlformats.org/officeDocument/2006/relationships/chart" Target="../charts/chart20.xml"/><Relationship Id="rId12" Type="http://schemas.openxmlformats.org/officeDocument/2006/relationships/chart" Target="../charts/chart25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9.xml"/><Relationship Id="rId11" Type="http://schemas.openxmlformats.org/officeDocument/2006/relationships/chart" Target="../charts/chart24.xml"/><Relationship Id="rId5" Type="http://schemas.openxmlformats.org/officeDocument/2006/relationships/chart" Target="../charts/chart18.xml"/><Relationship Id="rId15" Type="http://schemas.openxmlformats.org/officeDocument/2006/relationships/chart" Target="../charts/chart28.xml"/><Relationship Id="rId10" Type="http://schemas.openxmlformats.org/officeDocument/2006/relationships/chart" Target="../charts/chart23.xml"/><Relationship Id="rId4" Type="http://schemas.openxmlformats.org/officeDocument/2006/relationships/chart" Target="../charts/chart17.xml"/><Relationship Id="rId9" Type="http://schemas.openxmlformats.org/officeDocument/2006/relationships/chart" Target="../charts/chart22.xml"/><Relationship Id="rId14" Type="http://schemas.openxmlformats.org/officeDocument/2006/relationships/chart" Target="../charts/chart2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0.xml"/><Relationship Id="rId2" Type="http://schemas.openxmlformats.org/officeDocument/2006/relationships/chart" Target="../charts/chart2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2.xml"/><Relationship Id="rId4" Type="http://schemas.openxmlformats.org/officeDocument/2006/relationships/chart" Target="../charts/chart3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4.xml"/><Relationship Id="rId7" Type="http://schemas.openxmlformats.org/officeDocument/2006/relationships/chart" Target="../charts/chart38.xml"/><Relationship Id="rId2" Type="http://schemas.openxmlformats.org/officeDocument/2006/relationships/chart" Target="../charts/chart3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7.xml"/><Relationship Id="rId5" Type="http://schemas.openxmlformats.org/officeDocument/2006/relationships/chart" Target="../charts/chart36.xml"/><Relationship Id="rId4" Type="http://schemas.openxmlformats.org/officeDocument/2006/relationships/chart" Target="../charts/chart3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0.xml"/><Relationship Id="rId2" Type="http://schemas.openxmlformats.org/officeDocument/2006/relationships/chart" Target="../charts/chart3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3.xml"/><Relationship Id="rId2" Type="http://schemas.openxmlformats.org/officeDocument/2006/relationships/chart" Target="../charts/chart4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6.xml"/><Relationship Id="rId2" Type="http://schemas.openxmlformats.org/officeDocument/2006/relationships/chart" Target="../charts/chart4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9.xml"/><Relationship Id="rId2" Type="http://schemas.openxmlformats.org/officeDocument/2006/relationships/chart" Target="../charts/chart48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50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FF25D909-CBA1-4157-AD75-F57729833E8B}"/>
              </a:ext>
            </a:extLst>
          </p:cNvPr>
          <p:cNvGraphicFramePr>
            <a:graphicFrameLocks/>
          </p:cNvGraphicFramePr>
          <p:nvPr/>
        </p:nvGraphicFramePr>
        <p:xfrm>
          <a:off x="1673906" y="2697220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B58A6A9C-6680-4182-BA06-65064EE16F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8214924"/>
              </p:ext>
            </p:extLst>
          </p:nvPr>
        </p:nvGraphicFramePr>
        <p:xfrm>
          <a:off x="40142" y="420744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4C6C6C86-D010-46FD-97E3-BD87DB22B6A2}"/>
              </a:ext>
            </a:extLst>
          </p:cNvPr>
          <p:cNvGraphicFramePr>
            <a:graphicFrameLocks/>
          </p:cNvGraphicFramePr>
          <p:nvPr/>
        </p:nvGraphicFramePr>
        <p:xfrm>
          <a:off x="1669143" y="430269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62DD54B8-35DA-4832-8D51-B3378331CF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9590066"/>
              </p:ext>
            </p:extLst>
          </p:nvPr>
        </p:nvGraphicFramePr>
        <p:xfrm>
          <a:off x="3319576" y="439794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C17759C4-BC5F-49AE-9F61-75F9425DAB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036284"/>
              </p:ext>
            </p:extLst>
          </p:nvPr>
        </p:nvGraphicFramePr>
        <p:xfrm>
          <a:off x="5167425" y="449319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1AB760A1-4354-40EA-B94E-DF8EDE75BC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0123709"/>
              </p:ext>
            </p:extLst>
          </p:nvPr>
        </p:nvGraphicFramePr>
        <p:xfrm>
          <a:off x="37761" y="2680550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1591BD3C-F495-44D4-88EC-9261A521F8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4511673"/>
              </p:ext>
            </p:extLst>
          </p:nvPr>
        </p:nvGraphicFramePr>
        <p:xfrm>
          <a:off x="3271950" y="2709125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021FF098-F876-4181-94C4-E0A3C9EBE1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1002545"/>
              </p:ext>
            </p:extLst>
          </p:nvPr>
        </p:nvGraphicFramePr>
        <p:xfrm>
          <a:off x="5148373" y="2716269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4241F4EE-C62A-4C5F-9DF6-794A1E6698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967012"/>
              </p:ext>
            </p:extLst>
          </p:nvPr>
        </p:nvGraphicFramePr>
        <p:xfrm>
          <a:off x="47287" y="5071325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B3253A27-B389-4EC4-A923-DAD0C7DC8ED1}"/>
              </a:ext>
            </a:extLst>
          </p:cNvPr>
          <p:cNvGraphicFramePr>
            <a:graphicFrameLocks/>
          </p:cNvGraphicFramePr>
          <p:nvPr/>
        </p:nvGraphicFramePr>
        <p:xfrm>
          <a:off x="1676288" y="5080850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7896E6FF-06CF-4BB7-BE06-5E7D014464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9754984"/>
              </p:ext>
            </p:extLst>
          </p:nvPr>
        </p:nvGraphicFramePr>
        <p:xfrm>
          <a:off x="3295763" y="5090375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AA194713-9E2B-4D88-9759-A667FA715B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376422"/>
              </p:ext>
            </p:extLst>
          </p:nvPr>
        </p:nvGraphicFramePr>
        <p:xfrm>
          <a:off x="5157898" y="5083232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21D2AF63-5D1E-4379-B6E9-BCAD1AFCA4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2853943"/>
              </p:ext>
            </p:extLst>
          </p:nvPr>
        </p:nvGraphicFramePr>
        <p:xfrm>
          <a:off x="44905" y="7378757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C257BEEF-361E-444A-A09B-9593CF127099}"/>
              </a:ext>
            </a:extLst>
          </p:cNvPr>
          <p:cNvGraphicFramePr>
            <a:graphicFrameLocks/>
          </p:cNvGraphicFramePr>
          <p:nvPr/>
        </p:nvGraphicFramePr>
        <p:xfrm>
          <a:off x="1635807" y="7385901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F39221E-F8CD-46CB-A2F8-F86D4FCB5784}"/>
              </a:ext>
            </a:extLst>
          </p:cNvPr>
          <p:cNvSpPr txBox="1"/>
          <p:nvPr/>
        </p:nvSpPr>
        <p:spPr>
          <a:xfrm>
            <a:off x="2907767" y="10346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1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F6F08A-7046-2831-97A2-6180FBA5DBF8}"/>
              </a:ext>
            </a:extLst>
          </p:cNvPr>
          <p:cNvSpPr txBox="1"/>
          <p:nvPr/>
        </p:nvSpPr>
        <p:spPr>
          <a:xfrm>
            <a:off x="3578907" y="7848600"/>
            <a:ext cx="304165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900" b="1" dirty="0">
                <a:latin typeface="Palatino Linotype" panose="02040502050505030304" pitchFamily="18" charset="0"/>
              </a:rPr>
              <a:t>Figure S1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: neutralizing activities of anti-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G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against replication-defective VSV carrying SFTS virus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G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/Gc.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x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xis indicates concentration of the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sed to treat virus and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y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xis indicates reporter-positive cell number percentages against control (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0 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µ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/mL).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Experiments were performed at triplicates. Data are the means ± standard deviations.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2974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AA71132-7411-4CE6-8482-EBB7F684BB15}"/>
              </a:ext>
            </a:extLst>
          </p:cNvPr>
          <p:cNvGraphicFramePr>
            <a:graphicFrameLocks/>
          </p:cNvGraphicFramePr>
          <p:nvPr/>
        </p:nvGraphicFramePr>
        <p:xfrm>
          <a:off x="23700" y="552905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06F10FC1-4DC5-45F1-A7FA-59F9594721F9}"/>
              </a:ext>
            </a:extLst>
          </p:cNvPr>
          <p:cNvGraphicFramePr>
            <a:graphicFrameLocks/>
          </p:cNvGraphicFramePr>
          <p:nvPr/>
        </p:nvGraphicFramePr>
        <p:xfrm>
          <a:off x="1747725" y="550523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38E1090F-9DE5-4A95-96CA-A18BE07D59A4}"/>
              </a:ext>
            </a:extLst>
          </p:cNvPr>
          <p:cNvGraphicFramePr>
            <a:graphicFrameLocks/>
          </p:cNvGraphicFramePr>
          <p:nvPr/>
        </p:nvGraphicFramePr>
        <p:xfrm>
          <a:off x="3471750" y="548141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B7BD08E7-F514-4436-B15C-7DD57BE67D9D}"/>
              </a:ext>
            </a:extLst>
          </p:cNvPr>
          <p:cNvGraphicFramePr>
            <a:graphicFrameLocks/>
          </p:cNvGraphicFramePr>
          <p:nvPr/>
        </p:nvGraphicFramePr>
        <p:xfrm>
          <a:off x="5195775" y="545759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76EAD111-143D-493E-A085-4A3E242597AB}"/>
              </a:ext>
            </a:extLst>
          </p:cNvPr>
          <p:cNvGraphicFramePr>
            <a:graphicFrameLocks/>
          </p:cNvGraphicFramePr>
          <p:nvPr/>
        </p:nvGraphicFramePr>
        <p:xfrm>
          <a:off x="21319" y="2741274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32F2EFEE-60B8-43B3-9046-D89754C97448}"/>
              </a:ext>
            </a:extLst>
          </p:cNvPr>
          <p:cNvGraphicFramePr>
            <a:graphicFrameLocks/>
          </p:cNvGraphicFramePr>
          <p:nvPr/>
        </p:nvGraphicFramePr>
        <p:xfrm>
          <a:off x="1745344" y="2738892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53C69830-FA97-4E4B-B0E3-9072FA015926}"/>
              </a:ext>
            </a:extLst>
          </p:cNvPr>
          <p:cNvGraphicFramePr>
            <a:graphicFrameLocks/>
          </p:cNvGraphicFramePr>
          <p:nvPr/>
        </p:nvGraphicFramePr>
        <p:xfrm>
          <a:off x="3469369" y="2736510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50C2C072-72C4-496A-86B7-6A37E05B72AF}"/>
              </a:ext>
            </a:extLst>
          </p:cNvPr>
          <p:cNvGraphicFramePr>
            <a:graphicFrameLocks/>
          </p:cNvGraphicFramePr>
          <p:nvPr/>
        </p:nvGraphicFramePr>
        <p:xfrm>
          <a:off x="5193394" y="2734128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4E16356-5019-4723-934B-95E42CED999E}"/>
              </a:ext>
            </a:extLst>
          </p:cNvPr>
          <p:cNvGraphicFramePr>
            <a:graphicFrameLocks/>
          </p:cNvGraphicFramePr>
          <p:nvPr/>
        </p:nvGraphicFramePr>
        <p:xfrm>
          <a:off x="18937" y="5001081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F763C191-C306-4323-949E-9C9158E1CBA5}"/>
              </a:ext>
            </a:extLst>
          </p:cNvPr>
          <p:cNvGraphicFramePr>
            <a:graphicFrameLocks/>
          </p:cNvGraphicFramePr>
          <p:nvPr/>
        </p:nvGraphicFramePr>
        <p:xfrm>
          <a:off x="1742962" y="4998699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A016DB21-8144-4451-AE5F-7467863136B4}"/>
              </a:ext>
            </a:extLst>
          </p:cNvPr>
          <p:cNvGraphicFramePr>
            <a:graphicFrameLocks/>
          </p:cNvGraphicFramePr>
          <p:nvPr/>
        </p:nvGraphicFramePr>
        <p:xfrm>
          <a:off x="3466987" y="4996317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346E4CFE-D92F-4951-BF2D-E16224C2C65F}"/>
              </a:ext>
            </a:extLst>
          </p:cNvPr>
          <p:cNvGraphicFramePr>
            <a:graphicFrameLocks/>
          </p:cNvGraphicFramePr>
          <p:nvPr/>
        </p:nvGraphicFramePr>
        <p:xfrm>
          <a:off x="5191012" y="4993935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58CD32EF-04E5-4911-BCD4-370C1A4F9F2C}"/>
              </a:ext>
            </a:extLst>
          </p:cNvPr>
          <p:cNvGraphicFramePr>
            <a:graphicFrameLocks/>
          </p:cNvGraphicFramePr>
          <p:nvPr/>
        </p:nvGraphicFramePr>
        <p:xfrm>
          <a:off x="28462" y="7260887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09D6048A-27E6-4EBA-8538-96A92D4479ED}"/>
              </a:ext>
            </a:extLst>
          </p:cNvPr>
          <p:cNvGraphicFramePr>
            <a:graphicFrameLocks/>
          </p:cNvGraphicFramePr>
          <p:nvPr/>
        </p:nvGraphicFramePr>
        <p:xfrm>
          <a:off x="1752487" y="7258505"/>
          <a:ext cx="1643288" cy="2099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5663BE4-4225-4EDB-AE96-A3DA3D68D8CF}"/>
              </a:ext>
            </a:extLst>
          </p:cNvPr>
          <p:cNvSpPr txBox="1"/>
          <p:nvPr/>
        </p:nvSpPr>
        <p:spPr>
          <a:xfrm>
            <a:off x="2907767" y="17642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2</a:t>
            </a:r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0B0135F-9D67-6A45-7F76-ED72BD550FD4}"/>
              </a:ext>
            </a:extLst>
          </p:cNvPr>
          <p:cNvSpPr txBox="1"/>
          <p:nvPr/>
        </p:nvSpPr>
        <p:spPr>
          <a:xfrm>
            <a:off x="3578907" y="7848600"/>
            <a:ext cx="304165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900" b="1" dirty="0">
                <a:latin typeface="Palatino Linotype" panose="02040502050505030304" pitchFamily="18" charset="0"/>
              </a:rPr>
              <a:t>Figure S2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: neutralizing activities of anti-Gc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against replication-defective VSV carrying SFTS virus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G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/Gc.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x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xis indicates concentration of the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sed to treat virus and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y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xis indicates reporter-positive cell number percentages against control (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0 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µ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/mL).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Experiments were performed at triplicates. Data are the means ± standard deviations.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15691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CF9520D-D637-4293-9B49-1ABED1C1FE66}"/>
              </a:ext>
            </a:extLst>
          </p:cNvPr>
          <p:cNvSpPr txBox="1"/>
          <p:nvPr/>
        </p:nvSpPr>
        <p:spPr>
          <a:xfrm>
            <a:off x="2907767" y="5487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3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E25F31F-4515-5F03-5679-B40A01AAEE4D}"/>
              </a:ext>
            </a:extLst>
          </p:cNvPr>
          <p:cNvSpPr txBox="1"/>
          <p:nvPr/>
        </p:nvSpPr>
        <p:spPr>
          <a:xfrm>
            <a:off x="189000" y="1149199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a)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542BC95-E056-20EF-007E-2FF7A884D481}"/>
              </a:ext>
            </a:extLst>
          </p:cNvPr>
          <p:cNvSpPr txBox="1"/>
          <p:nvPr/>
        </p:nvSpPr>
        <p:spPr>
          <a:xfrm>
            <a:off x="189000" y="431843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b)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DBCAD50-F575-00FB-1AF4-BEAD0DAD8CC0}"/>
              </a:ext>
            </a:extLst>
          </p:cNvPr>
          <p:cNvSpPr txBox="1"/>
          <p:nvPr/>
        </p:nvSpPr>
        <p:spPr>
          <a:xfrm>
            <a:off x="354189" y="7848600"/>
            <a:ext cx="617996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900" b="1" dirty="0">
                <a:latin typeface="Palatino Linotype" panose="02040502050505030304" pitchFamily="18" charset="0"/>
              </a:rPr>
              <a:t>Figure S3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: therapeutic effects of anti-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G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and anti-Gc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in a fatal murine model of SFTS. Anti-Gc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with comparatively strong neutralizing activities (a) and the other anti-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G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and anti-Gc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(b). IFNAR-/- mice infected with SFTS virus were intraperitoneally injected with 1 mg of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daily between 1 dpi and 6 dpi. The parentheses also include numbers of mice used. Mice were observed for their survival/death (left, Kaplan-Meier) and body weight (right) daily up to 14dpi. In right, body weight percentages against 0 dpi are shown. Data of body weight are shown in means ± standard deviations.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41A2953F-6C9D-4C99-AE44-42C62EE803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0515437"/>
              </p:ext>
            </p:extLst>
          </p:nvPr>
        </p:nvGraphicFramePr>
        <p:xfrm>
          <a:off x="354188" y="1333865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9A321D54-DFAB-4121-B1A5-3C47FBA3D0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4300940"/>
              </p:ext>
            </p:extLst>
          </p:nvPr>
        </p:nvGraphicFramePr>
        <p:xfrm>
          <a:off x="354188" y="4503099"/>
          <a:ext cx="3240000" cy="31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E12B7A6E-0EE5-489B-BCA6-CCA9CB9CD8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5381466"/>
              </p:ext>
            </p:extLst>
          </p:nvPr>
        </p:nvGraphicFramePr>
        <p:xfrm>
          <a:off x="3594188" y="4503099"/>
          <a:ext cx="3240000" cy="31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84FF7053-4699-4D3D-A9AB-22CD34C67F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858314"/>
              </p:ext>
            </p:extLst>
          </p:nvPr>
        </p:nvGraphicFramePr>
        <p:xfrm>
          <a:off x="3594188" y="1333865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733493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9E5577F2-3F98-4CD9-9225-0933DDCD11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0392942"/>
              </p:ext>
            </p:extLst>
          </p:nvPr>
        </p:nvGraphicFramePr>
        <p:xfrm>
          <a:off x="0" y="104124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9CDEA0DF-FB80-4ACA-991A-D97676680D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6123407"/>
              </p:ext>
            </p:extLst>
          </p:nvPr>
        </p:nvGraphicFramePr>
        <p:xfrm>
          <a:off x="0" y="390128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E0B2A21E-B3E6-46EA-B3A1-07CBDA4C42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3952392"/>
              </p:ext>
            </p:extLst>
          </p:nvPr>
        </p:nvGraphicFramePr>
        <p:xfrm>
          <a:off x="0" y="676132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D24E0C5E-DFF5-401C-841F-3D18EAE6B0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2114107"/>
              </p:ext>
            </p:extLst>
          </p:nvPr>
        </p:nvGraphicFramePr>
        <p:xfrm>
          <a:off x="3429000" y="104124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7E3FC46-EA7C-4ED2-A6E0-CEC98AF45C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3565680"/>
              </p:ext>
            </p:extLst>
          </p:nvPr>
        </p:nvGraphicFramePr>
        <p:xfrm>
          <a:off x="3429000" y="390128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21F7F04E-3CEF-4DD2-80B7-08D29CA091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4603295"/>
              </p:ext>
            </p:extLst>
          </p:nvPr>
        </p:nvGraphicFramePr>
        <p:xfrm>
          <a:off x="3429000" y="676132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BF7986C-4B73-4538-9DB8-C3AEA398EFAA}"/>
              </a:ext>
            </a:extLst>
          </p:cNvPr>
          <p:cNvSpPr txBox="1"/>
          <p:nvPr/>
        </p:nvSpPr>
        <p:spPr>
          <a:xfrm>
            <a:off x="2907767" y="5487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4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6715802-2C10-36C7-783D-09F838B1D267}"/>
              </a:ext>
            </a:extLst>
          </p:cNvPr>
          <p:cNvSpPr txBox="1"/>
          <p:nvPr/>
        </p:nvSpPr>
        <p:spPr>
          <a:xfrm>
            <a:off x="121920" y="9281320"/>
            <a:ext cx="65470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pitopes of anti-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n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Gc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mpetitive ELISA was performed among three anti-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n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left) and among anti-three Gc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right). Biotinylate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incubated with antigens in the presence of unlabeled competitor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n detected.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xis indicates concentration of competitor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sed and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xis indicates binding of biotinylate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% of control, no competitor). Experiments were performed at triplicates and data are means ± standard deviations.</a:t>
            </a:r>
            <a:endParaRPr lang="ja-JP" altLang="ja-JP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03279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1CB6E07A-AF39-49F1-A998-6BC8D8776F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1741927"/>
              </p:ext>
            </p:extLst>
          </p:nvPr>
        </p:nvGraphicFramePr>
        <p:xfrm>
          <a:off x="913762" y="1038382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4D2E6F5C-BA7A-4AB9-A263-10759C2CD2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3363326"/>
              </p:ext>
            </p:extLst>
          </p:nvPr>
        </p:nvGraphicFramePr>
        <p:xfrm>
          <a:off x="904237" y="3558382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F72A8ED8-D4DC-48E3-AD3A-F91E3F569C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1579031"/>
              </p:ext>
            </p:extLst>
          </p:nvPr>
        </p:nvGraphicFramePr>
        <p:xfrm>
          <a:off x="913762" y="6078382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4D4E255-9925-491C-A014-0AAFFDA9FDC9}"/>
              </a:ext>
            </a:extLst>
          </p:cNvPr>
          <p:cNvSpPr txBox="1"/>
          <p:nvPr/>
        </p:nvSpPr>
        <p:spPr>
          <a:xfrm>
            <a:off x="2907767" y="5487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5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455807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CE19C320-5D46-4445-8B69-A0D3CCAF84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6494340"/>
              </p:ext>
            </p:extLst>
          </p:nvPr>
        </p:nvGraphicFramePr>
        <p:xfrm>
          <a:off x="904237" y="1059337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EB860C1-5F70-4581-940E-8BE360546C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466370"/>
              </p:ext>
            </p:extLst>
          </p:nvPr>
        </p:nvGraphicFramePr>
        <p:xfrm>
          <a:off x="913762" y="3579337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8E8590A9-C0DA-4126-9086-8EA63AA5B3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6163791"/>
              </p:ext>
            </p:extLst>
          </p:nvPr>
        </p:nvGraphicFramePr>
        <p:xfrm>
          <a:off x="904237" y="6099337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5381A4C-CBE1-4F05-99AE-EACEE2FE1A28}"/>
              </a:ext>
            </a:extLst>
          </p:cNvPr>
          <p:cNvSpPr txBox="1"/>
          <p:nvPr/>
        </p:nvSpPr>
        <p:spPr>
          <a:xfrm>
            <a:off x="2378393" y="548759"/>
            <a:ext cx="2101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5, continued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39551E5-2F2C-9632-53E1-F323771229AA}"/>
              </a:ext>
            </a:extLst>
          </p:cNvPr>
          <p:cNvSpPr txBox="1"/>
          <p:nvPr/>
        </p:nvSpPr>
        <p:spPr>
          <a:xfrm>
            <a:off x="354189" y="8619337"/>
            <a:ext cx="61799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900" b="1" dirty="0">
                <a:latin typeface="Palatino Linotype" panose="02040502050505030304" pitchFamily="18" charset="0"/>
              </a:rPr>
              <a:t>Figure S4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: competitive ELISA for anti-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G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. 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otinylate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incubated with antigens in the presence of unlabeled competitor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n detected.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xis indicates concentration of competitor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sed and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xis indicates binding of biotinylate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% of control, no competitor). Experiments were performed at triplicates and data are means ± standard deviations.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62921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4C525BD6-303F-4929-9F09-BECC7E5664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088215"/>
              </p:ext>
            </p:extLst>
          </p:nvPr>
        </p:nvGraphicFramePr>
        <p:xfrm>
          <a:off x="913762" y="1386725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BF1884B-5A62-4169-92B2-AD3998DDFE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1375194"/>
              </p:ext>
            </p:extLst>
          </p:nvPr>
        </p:nvGraphicFramePr>
        <p:xfrm>
          <a:off x="904237" y="3906725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308F189-5901-43E2-A7A9-C5160008CC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3659367"/>
              </p:ext>
            </p:extLst>
          </p:nvPr>
        </p:nvGraphicFramePr>
        <p:xfrm>
          <a:off x="913762" y="6426725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651A4D2-EADB-CBEA-06F8-7EB37879CE04}"/>
              </a:ext>
            </a:extLst>
          </p:cNvPr>
          <p:cNvSpPr txBox="1"/>
          <p:nvPr/>
        </p:nvSpPr>
        <p:spPr>
          <a:xfrm>
            <a:off x="2907768" y="5487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6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488300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F2CAEDE-9B6B-4163-844B-B041C23268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803925"/>
              </p:ext>
            </p:extLst>
          </p:nvPr>
        </p:nvGraphicFramePr>
        <p:xfrm>
          <a:off x="904237" y="1514360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139DBA9-BA4D-462C-92A8-CBAD8ECD2E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3372727"/>
              </p:ext>
            </p:extLst>
          </p:nvPr>
        </p:nvGraphicFramePr>
        <p:xfrm>
          <a:off x="913762" y="4034360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F452B362-D32A-48D1-933B-762B29D20A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2894257"/>
              </p:ext>
            </p:extLst>
          </p:nvPr>
        </p:nvGraphicFramePr>
        <p:xfrm>
          <a:off x="904237" y="6554360"/>
          <a:ext cx="50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F9817D-3541-3A59-92EB-AD55DAFDA4C2}"/>
              </a:ext>
            </a:extLst>
          </p:cNvPr>
          <p:cNvSpPr txBox="1"/>
          <p:nvPr/>
        </p:nvSpPr>
        <p:spPr>
          <a:xfrm>
            <a:off x="2378392" y="548759"/>
            <a:ext cx="2101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6, continued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99ED06D-92E2-3A2A-CD7B-E86FEB7659C1}"/>
              </a:ext>
            </a:extLst>
          </p:cNvPr>
          <p:cNvSpPr txBox="1"/>
          <p:nvPr/>
        </p:nvSpPr>
        <p:spPr>
          <a:xfrm>
            <a:off x="354189" y="9074360"/>
            <a:ext cx="61799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900" b="1" dirty="0">
                <a:latin typeface="Palatino Linotype" panose="02040502050505030304" pitchFamily="18" charset="0"/>
              </a:rPr>
              <a:t>Figure S5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: competitive ELISA for anti-Gc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mAb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. 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otinylate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incubated with antigens in the presence of unlabeled competitor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n detected.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xis indicates concentration of competitor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sed and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xis indicates binding of biotinylate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% of control, no competitor). Experiments were performed at triplicates and data are means ± standard deviations.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61462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10BD946-8473-D20C-4932-3B6ECC8A408A}"/>
              </a:ext>
            </a:extLst>
          </p:cNvPr>
          <p:cNvSpPr txBox="1"/>
          <p:nvPr/>
        </p:nvSpPr>
        <p:spPr>
          <a:xfrm>
            <a:off x="2907768" y="5487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Figure S7</a:t>
            </a:r>
            <a:endParaRPr kumimoji="1" lang="ja-JP" altLang="en-US" dirty="0"/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6D63CEFF-4909-FF69-7799-58B0315D86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4921605"/>
              </p:ext>
            </p:extLst>
          </p:nvPr>
        </p:nvGraphicFramePr>
        <p:xfrm>
          <a:off x="1196340" y="2010641"/>
          <a:ext cx="4465320" cy="2628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B24333-CD3E-F289-96D1-294A04BD9815}"/>
              </a:ext>
            </a:extLst>
          </p:cNvPr>
          <p:cNvSpPr txBox="1"/>
          <p:nvPr/>
        </p:nvSpPr>
        <p:spPr>
          <a:xfrm>
            <a:off x="630383" y="5091545"/>
            <a:ext cx="5713267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7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a different property of neutralizing anti-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n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Gc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ja-JP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in neutralizing tests, 6 </a:t>
            </a:r>
            <a:r>
              <a:rPr lang="en-US" altLang="ja-JP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mouse IgG1 isotype control (mIgG1), and normal human IgG (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IgG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ere used before (Pre; virus was treated with antibodies then inoculated to cells) and after (Post; virus was inoculated first to cells in the absence of antibodies then cultured with media containing antibodies) viral adsorption to cells. Student’s </a:t>
            </a:r>
            <a:r>
              <a:rPr lang="en-US" altLang="ja-JP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test was performed to determine the significance of the difference between the means of two groups.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EC2EDD8-6599-2A28-C47F-19335BB34282}"/>
              </a:ext>
            </a:extLst>
          </p:cNvPr>
          <p:cNvCxnSpPr>
            <a:cxnSpLocks/>
          </p:cNvCxnSpPr>
          <p:nvPr/>
        </p:nvCxnSpPr>
        <p:spPr>
          <a:xfrm>
            <a:off x="1905002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AD08FF2-24EC-285D-45AB-A690F0BD1C9E}"/>
              </a:ext>
            </a:extLst>
          </p:cNvPr>
          <p:cNvSpPr txBox="1"/>
          <p:nvPr/>
        </p:nvSpPr>
        <p:spPr>
          <a:xfrm>
            <a:off x="1805570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lt;0.01</a:t>
            </a:r>
            <a:endParaRPr kumimoji="1" lang="ja-JP" altLang="en-US" sz="900" dirty="0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4551839B-676A-2CCC-F624-0394277E64B0}"/>
              </a:ext>
            </a:extLst>
          </p:cNvPr>
          <p:cNvCxnSpPr>
            <a:cxnSpLocks/>
          </p:cNvCxnSpPr>
          <p:nvPr/>
        </p:nvCxnSpPr>
        <p:spPr>
          <a:xfrm>
            <a:off x="2365223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71EDCE9-DCA9-1ED6-2A60-6318242412EE}"/>
              </a:ext>
            </a:extLst>
          </p:cNvPr>
          <p:cNvSpPr txBox="1"/>
          <p:nvPr/>
        </p:nvSpPr>
        <p:spPr>
          <a:xfrm>
            <a:off x="2265791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gt;0.05</a:t>
            </a:r>
            <a:endParaRPr kumimoji="1" lang="ja-JP" altLang="en-US" sz="900" dirty="0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A15C08B8-A7AA-8BB4-3AF6-5BECF45EB317}"/>
              </a:ext>
            </a:extLst>
          </p:cNvPr>
          <p:cNvCxnSpPr>
            <a:cxnSpLocks/>
          </p:cNvCxnSpPr>
          <p:nvPr/>
        </p:nvCxnSpPr>
        <p:spPr>
          <a:xfrm>
            <a:off x="2825444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075A462-5E18-C5F1-C686-94C356662B77}"/>
              </a:ext>
            </a:extLst>
          </p:cNvPr>
          <p:cNvSpPr txBox="1"/>
          <p:nvPr/>
        </p:nvSpPr>
        <p:spPr>
          <a:xfrm>
            <a:off x="2726012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lt;0.05</a:t>
            </a:r>
            <a:endParaRPr kumimoji="1" lang="ja-JP" altLang="en-US" sz="900" dirty="0"/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F56D3B6C-D44B-0ACB-E8CC-3E630062FB0F}"/>
              </a:ext>
            </a:extLst>
          </p:cNvPr>
          <p:cNvCxnSpPr>
            <a:cxnSpLocks/>
          </p:cNvCxnSpPr>
          <p:nvPr/>
        </p:nvCxnSpPr>
        <p:spPr>
          <a:xfrm>
            <a:off x="3285665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C81E224-833F-5F12-4ABD-99F2E6C3567C}"/>
              </a:ext>
            </a:extLst>
          </p:cNvPr>
          <p:cNvSpPr txBox="1"/>
          <p:nvPr/>
        </p:nvSpPr>
        <p:spPr>
          <a:xfrm>
            <a:off x="3186233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gt;0.05</a:t>
            </a:r>
            <a:endParaRPr kumimoji="1" lang="ja-JP" altLang="en-US" sz="900" dirty="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B4AED653-6474-12BC-8ABC-1EFF1B1E664D}"/>
              </a:ext>
            </a:extLst>
          </p:cNvPr>
          <p:cNvCxnSpPr>
            <a:cxnSpLocks/>
          </p:cNvCxnSpPr>
          <p:nvPr/>
        </p:nvCxnSpPr>
        <p:spPr>
          <a:xfrm>
            <a:off x="3745886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CFE8CB5-93B2-EFAA-8ED5-C8FEC1E280F0}"/>
              </a:ext>
            </a:extLst>
          </p:cNvPr>
          <p:cNvSpPr txBox="1"/>
          <p:nvPr/>
        </p:nvSpPr>
        <p:spPr>
          <a:xfrm>
            <a:off x="3646454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gt;0.05</a:t>
            </a:r>
            <a:endParaRPr kumimoji="1" lang="ja-JP" altLang="en-US" sz="900" dirty="0"/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6ECA9F81-941E-251C-694D-1143515EF875}"/>
              </a:ext>
            </a:extLst>
          </p:cNvPr>
          <p:cNvCxnSpPr>
            <a:cxnSpLocks/>
          </p:cNvCxnSpPr>
          <p:nvPr/>
        </p:nvCxnSpPr>
        <p:spPr>
          <a:xfrm>
            <a:off x="4206107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5668117-0051-0D7A-5CD2-34C3200F573A}"/>
              </a:ext>
            </a:extLst>
          </p:cNvPr>
          <p:cNvSpPr txBox="1"/>
          <p:nvPr/>
        </p:nvSpPr>
        <p:spPr>
          <a:xfrm>
            <a:off x="4106675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gt;0.05</a:t>
            </a:r>
            <a:endParaRPr kumimoji="1" lang="ja-JP" altLang="en-US" sz="900" dirty="0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81A414AD-CE42-B842-2910-C074DE58B3C2}"/>
              </a:ext>
            </a:extLst>
          </p:cNvPr>
          <p:cNvCxnSpPr>
            <a:cxnSpLocks/>
          </p:cNvCxnSpPr>
          <p:nvPr/>
        </p:nvCxnSpPr>
        <p:spPr>
          <a:xfrm>
            <a:off x="4666328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0F2FFB5-5A08-D047-BDDF-4AECF08823EA}"/>
              </a:ext>
            </a:extLst>
          </p:cNvPr>
          <p:cNvSpPr txBox="1"/>
          <p:nvPr/>
        </p:nvSpPr>
        <p:spPr>
          <a:xfrm>
            <a:off x="4566896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gt;0.05</a:t>
            </a:r>
            <a:endParaRPr kumimoji="1" lang="ja-JP" altLang="en-US" sz="900" dirty="0"/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6303DB35-F0E3-853D-DF09-C5299AC7CA4B}"/>
              </a:ext>
            </a:extLst>
          </p:cNvPr>
          <p:cNvCxnSpPr>
            <a:cxnSpLocks/>
          </p:cNvCxnSpPr>
          <p:nvPr/>
        </p:nvCxnSpPr>
        <p:spPr>
          <a:xfrm>
            <a:off x="5126549" y="1977304"/>
            <a:ext cx="30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3D83C9B-BDDD-C233-1645-088C40D0A238}"/>
              </a:ext>
            </a:extLst>
          </p:cNvPr>
          <p:cNvSpPr txBox="1"/>
          <p:nvPr/>
        </p:nvSpPr>
        <p:spPr>
          <a:xfrm>
            <a:off x="5027117" y="173218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</a:t>
            </a:r>
            <a:r>
              <a:rPr kumimoji="1" lang="en-US" altLang="ja-JP" sz="900" dirty="0"/>
              <a:t>&gt;0.05</a:t>
            </a:r>
            <a:endParaRPr kumimoji="1" lang="ja-JP" altLang="en-US" sz="900" dirty="0"/>
          </a:p>
        </p:txBody>
      </p:sp>
    </p:spTree>
    <p:extLst>
      <p:ext uri="{BB962C8B-B14F-4D97-AF65-F5344CB8AC3E}">
        <p14:creationId xmlns:p14="http://schemas.microsoft.com/office/powerpoint/2010/main" val="1755525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8</TotalTime>
  <Words>916</Words>
  <Application>Microsoft Office PowerPoint</Application>
  <PresentationFormat>A4 210 x 297 mm</PresentationFormat>
  <Paragraphs>99</Paragraphs>
  <Slides>9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昌幸 下島</dc:creator>
  <cp:lastModifiedBy> </cp:lastModifiedBy>
  <cp:revision>33</cp:revision>
  <cp:lastPrinted>2022-04-13T03:57:28Z</cp:lastPrinted>
  <dcterms:created xsi:type="dcterms:W3CDTF">2022-01-17T06:38:27Z</dcterms:created>
  <dcterms:modified xsi:type="dcterms:W3CDTF">2022-07-26T14:14:13Z</dcterms:modified>
</cp:coreProperties>
</file>